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sldIdLst>
    <p:sldId id="260" r:id="rId5"/>
    <p:sldId id="256" r:id="rId6"/>
    <p:sldId id="262" r:id="rId7"/>
    <p:sldId id="257" r:id="rId8"/>
    <p:sldId id="258" r:id="rId9"/>
    <p:sldId id="259" r:id="rId10"/>
    <p:sldId id="261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728C617-D917-4D05-E2DF-19BDF680058A}" name="Kiraly, Ms Szilvia Kiraly" initials="MK" userId="S::zcbtkir@ucl.ac.uk::a1291dd4-14de-4b8f-803a-e4583c1a756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164D2B3-DACE-4998-A73A-03506DF671DE}" v="46" dt="2025-04-27T22:56:29.6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27" autoAdjust="0"/>
    <p:restoredTop sz="95964"/>
  </p:normalViewPr>
  <p:slideViewPr>
    <p:cSldViewPr snapToGrid="0">
      <p:cViewPr varScale="1">
        <p:scale>
          <a:sx n="77" d="100"/>
          <a:sy n="77" d="100"/>
        </p:scale>
        <p:origin x="324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8/10/relationships/authors" Target="author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18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753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541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271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028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04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549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959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001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632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262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880D0-04FB-0A4E-98EF-4CC72734B5EA}" type="datetimeFigureOut">
              <a:rPr lang="en-US" smtClean="0"/>
              <a:t>4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D4A809-6819-1448-B954-2CD76CBA7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646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10" Type="http://schemas.openxmlformats.org/officeDocument/2006/relationships/image" Target="../media/image6.png"/><Relationship Id="rId4" Type="http://schemas.openxmlformats.org/officeDocument/2006/relationships/image" Target="../media/image3.png"/><Relationship Id="rId9" Type="http://schemas.microsoft.com/office/2007/relationships/hdphoto" Target="../media/hdphoto3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9.wdp"/><Relationship Id="rId3" Type="http://schemas.microsoft.com/office/2007/relationships/hdphoto" Target="../media/hdphoto4.wdp"/><Relationship Id="rId7" Type="http://schemas.microsoft.com/office/2007/relationships/hdphoto" Target="../media/hdphoto6.wdp"/><Relationship Id="rId12" Type="http://schemas.openxmlformats.org/officeDocument/2006/relationships/image" Target="../media/image12.png"/><Relationship Id="rId17" Type="http://schemas.openxmlformats.org/officeDocument/2006/relationships/image" Target="../media/image15.png"/><Relationship Id="rId2" Type="http://schemas.openxmlformats.org/officeDocument/2006/relationships/image" Target="../media/image7.png"/><Relationship Id="rId16" Type="http://schemas.microsoft.com/office/2007/relationships/hdphoto" Target="../media/hdphoto10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11" Type="http://schemas.microsoft.com/office/2007/relationships/hdphoto" Target="../media/hdphoto8.wdp"/><Relationship Id="rId5" Type="http://schemas.microsoft.com/office/2007/relationships/hdphoto" Target="../media/hdphoto5.wdp"/><Relationship Id="rId15" Type="http://schemas.openxmlformats.org/officeDocument/2006/relationships/image" Target="../media/image14.png"/><Relationship Id="rId10" Type="http://schemas.openxmlformats.org/officeDocument/2006/relationships/image" Target="../media/image11.png"/><Relationship Id="rId4" Type="http://schemas.openxmlformats.org/officeDocument/2006/relationships/image" Target="../media/image8.png"/><Relationship Id="rId9" Type="http://schemas.microsoft.com/office/2007/relationships/hdphoto" Target="../media/hdphoto7.wdp"/><Relationship Id="rId1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3.wdp"/><Relationship Id="rId13" Type="http://schemas.openxmlformats.org/officeDocument/2006/relationships/image" Target="../media/image22.png"/><Relationship Id="rId18" Type="http://schemas.microsoft.com/office/2007/relationships/hdphoto" Target="../media/hdphoto18.wdp"/><Relationship Id="rId3" Type="http://schemas.openxmlformats.org/officeDocument/2006/relationships/image" Target="../media/image17.png"/><Relationship Id="rId7" Type="http://schemas.openxmlformats.org/officeDocument/2006/relationships/image" Target="../media/image19.png"/><Relationship Id="rId12" Type="http://schemas.microsoft.com/office/2007/relationships/hdphoto" Target="../media/hdphoto15.wdp"/><Relationship Id="rId17" Type="http://schemas.openxmlformats.org/officeDocument/2006/relationships/image" Target="../media/image24.png"/><Relationship Id="rId2" Type="http://schemas.openxmlformats.org/officeDocument/2006/relationships/image" Target="../media/image16.png"/><Relationship Id="rId16" Type="http://schemas.microsoft.com/office/2007/relationships/hdphoto" Target="../media/hdphoto17.wdp"/><Relationship Id="rId1" Type="http://schemas.openxmlformats.org/officeDocument/2006/relationships/slideLayout" Target="../slideLayouts/slideLayout2.xml"/><Relationship Id="rId6" Type="http://schemas.microsoft.com/office/2007/relationships/hdphoto" Target="../media/hdphoto12.wdp"/><Relationship Id="rId11" Type="http://schemas.openxmlformats.org/officeDocument/2006/relationships/image" Target="../media/image21.png"/><Relationship Id="rId5" Type="http://schemas.openxmlformats.org/officeDocument/2006/relationships/image" Target="../media/image18.png"/><Relationship Id="rId15" Type="http://schemas.openxmlformats.org/officeDocument/2006/relationships/image" Target="../media/image23.png"/><Relationship Id="rId10" Type="http://schemas.microsoft.com/office/2007/relationships/hdphoto" Target="../media/hdphoto14.wdp"/><Relationship Id="rId4" Type="http://schemas.microsoft.com/office/2007/relationships/hdphoto" Target="../media/hdphoto11.wdp"/><Relationship Id="rId9" Type="http://schemas.openxmlformats.org/officeDocument/2006/relationships/image" Target="../media/image20.png"/><Relationship Id="rId14" Type="http://schemas.microsoft.com/office/2007/relationships/hdphoto" Target="../media/hdphoto16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21.wdp"/><Relationship Id="rId13" Type="http://schemas.microsoft.com/office/2007/relationships/hdphoto" Target="../media/hdphoto24.wdp"/><Relationship Id="rId18" Type="http://schemas.openxmlformats.org/officeDocument/2006/relationships/image" Target="../media/image33.png"/><Relationship Id="rId26" Type="http://schemas.openxmlformats.org/officeDocument/2006/relationships/image" Target="../media/image37.png"/><Relationship Id="rId3" Type="http://schemas.openxmlformats.org/officeDocument/2006/relationships/image" Target="../media/image26.png"/><Relationship Id="rId21" Type="http://schemas.microsoft.com/office/2007/relationships/hdphoto" Target="../media/hdphoto28.wdp"/><Relationship Id="rId7" Type="http://schemas.openxmlformats.org/officeDocument/2006/relationships/image" Target="../media/image28.png"/><Relationship Id="rId12" Type="http://schemas.openxmlformats.org/officeDocument/2006/relationships/image" Target="../media/image30.png"/><Relationship Id="rId17" Type="http://schemas.microsoft.com/office/2007/relationships/hdphoto" Target="../media/hdphoto26.wdp"/><Relationship Id="rId25" Type="http://schemas.microsoft.com/office/2007/relationships/hdphoto" Target="../media/hdphoto30.wdp"/><Relationship Id="rId2" Type="http://schemas.openxmlformats.org/officeDocument/2006/relationships/image" Target="../media/image25.png"/><Relationship Id="rId16" Type="http://schemas.openxmlformats.org/officeDocument/2006/relationships/image" Target="../media/image32.png"/><Relationship Id="rId20" Type="http://schemas.openxmlformats.org/officeDocument/2006/relationships/image" Target="../media/image34.png"/><Relationship Id="rId29" Type="http://schemas.microsoft.com/office/2007/relationships/hdphoto" Target="../media/hdphoto32.wdp"/><Relationship Id="rId1" Type="http://schemas.openxmlformats.org/officeDocument/2006/relationships/slideLayout" Target="../slideLayouts/slideLayout1.xml"/><Relationship Id="rId6" Type="http://schemas.microsoft.com/office/2007/relationships/hdphoto" Target="../media/hdphoto20.wdp"/><Relationship Id="rId11" Type="http://schemas.microsoft.com/office/2007/relationships/hdphoto" Target="../media/hdphoto23.wdp"/><Relationship Id="rId24" Type="http://schemas.openxmlformats.org/officeDocument/2006/relationships/image" Target="../media/image36.png"/><Relationship Id="rId32" Type="http://schemas.openxmlformats.org/officeDocument/2006/relationships/image" Target="../media/image41.png"/><Relationship Id="rId5" Type="http://schemas.openxmlformats.org/officeDocument/2006/relationships/image" Target="../media/image27.png"/><Relationship Id="rId15" Type="http://schemas.microsoft.com/office/2007/relationships/hdphoto" Target="../media/hdphoto25.wdp"/><Relationship Id="rId23" Type="http://schemas.microsoft.com/office/2007/relationships/hdphoto" Target="../media/hdphoto29.wdp"/><Relationship Id="rId28" Type="http://schemas.openxmlformats.org/officeDocument/2006/relationships/image" Target="../media/image38.png"/><Relationship Id="rId10" Type="http://schemas.openxmlformats.org/officeDocument/2006/relationships/image" Target="../media/image29.png"/><Relationship Id="rId19" Type="http://schemas.microsoft.com/office/2007/relationships/hdphoto" Target="../media/hdphoto27.wdp"/><Relationship Id="rId31" Type="http://schemas.openxmlformats.org/officeDocument/2006/relationships/image" Target="../media/image40.png"/><Relationship Id="rId4" Type="http://schemas.microsoft.com/office/2007/relationships/hdphoto" Target="../media/hdphoto19.wdp"/><Relationship Id="rId9" Type="http://schemas.microsoft.com/office/2007/relationships/hdphoto" Target="../media/hdphoto22.wdp"/><Relationship Id="rId14" Type="http://schemas.openxmlformats.org/officeDocument/2006/relationships/image" Target="../media/image31.png"/><Relationship Id="rId22" Type="http://schemas.openxmlformats.org/officeDocument/2006/relationships/image" Target="../media/image35.png"/><Relationship Id="rId27" Type="http://schemas.microsoft.com/office/2007/relationships/hdphoto" Target="../media/hdphoto31.wdp"/><Relationship Id="rId30" Type="http://schemas.openxmlformats.org/officeDocument/2006/relationships/image" Target="../media/image3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openxmlformats.org/officeDocument/2006/relationships/image" Target="../media/image43.png"/><Relationship Id="rId7" Type="http://schemas.openxmlformats.org/officeDocument/2006/relationships/image" Target="../media/image46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10" Type="http://schemas.openxmlformats.org/officeDocument/2006/relationships/image" Target="../media/image48.jpeg"/><Relationship Id="rId4" Type="http://schemas.microsoft.com/office/2007/relationships/hdphoto" Target="../media/hdphoto33.wdp"/><Relationship Id="rId9" Type="http://schemas.microsoft.com/office/2007/relationships/hdphoto" Target="../media/hdphoto34.wdp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37.wdp"/><Relationship Id="rId13" Type="http://schemas.openxmlformats.org/officeDocument/2006/relationships/image" Target="../media/image55.png"/><Relationship Id="rId3" Type="http://schemas.openxmlformats.org/officeDocument/2006/relationships/image" Target="../media/image50.png"/><Relationship Id="rId7" Type="http://schemas.openxmlformats.org/officeDocument/2006/relationships/image" Target="../media/image52.png"/><Relationship Id="rId12" Type="http://schemas.microsoft.com/office/2007/relationships/hdphoto" Target="../media/hdphoto39.wdp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1.xml"/><Relationship Id="rId6" Type="http://schemas.microsoft.com/office/2007/relationships/hdphoto" Target="../media/hdphoto36.wdp"/><Relationship Id="rId11" Type="http://schemas.openxmlformats.org/officeDocument/2006/relationships/image" Target="../media/image54.png"/><Relationship Id="rId5" Type="http://schemas.openxmlformats.org/officeDocument/2006/relationships/image" Target="../media/image51.png"/><Relationship Id="rId10" Type="http://schemas.microsoft.com/office/2007/relationships/hdphoto" Target="../media/hdphoto38.wdp"/><Relationship Id="rId4" Type="http://schemas.microsoft.com/office/2007/relationships/hdphoto" Target="../media/hdphoto35.wdp"/><Relationship Id="rId9" Type="http://schemas.openxmlformats.org/officeDocument/2006/relationships/image" Target="../media/image53.png"/><Relationship Id="rId14" Type="http://schemas.openxmlformats.org/officeDocument/2006/relationships/image" Target="../media/image5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20C55EA-1566-6F14-4C4C-B95C348EA98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665" t="5322" r="6408" b="4894"/>
          <a:stretch/>
        </p:blipFill>
        <p:spPr>
          <a:xfrm>
            <a:off x="2104844" y="520883"/>
            <a:ext cx="1656271" cy="2385577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96B05129-A1DA-2E9D-F84C-2A7DC852F560}"/>
              </a:ext>
            </a:extLst>
          </p:cNvPr>
          <p:cNvSpPr txBox="1"/>
          <p:nvPr/>
        </p:nvSpPr>
        <p:spPr>
          <a:xfrm>
            <a:off x="2101094" y="166336"/>
            <a:ext cx="514970" cy="28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E8CFC230-3660-2C3A-6756-2DB247F5F8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9419" y="308970"/>
            <a:ext cx="2878343" cy="3766649"/>
          </a:xfrm>
          <a:prstGeom prst="rect">
            <a:avLst/>
          </a:prstGeom>
        </p:spPr>
      </p:pic>
      <p:grpSp>
        <p:nvGrpSpPr>
          <p:cNvPr id="37" name="Group 36">
            <a:extLst>
              <a:ext uri="{FF2B5EF4-FFF2-40B4-BE49-F238E27FC236}">
                <a16:creationId xmlns:a16="http://schemas.microsoft.com/office/drawing/2014/main" id="{9D9DA166-6853-7277-3995-B99968EAC965}"/>
              </a:ext>
            </a:extLst>
          </p:cNvPr>
          <p:cNvGrpSpPr/>
          <p:nvPr/>
        </p:nvGrpSpPr>
        <p:grpSpPr>
          <a:xfrm>
            <a:off x="645867" y="299572"/>
            <a:ext cx="1279879" cy="3881544"/>
            <a:chOff x="500332" y="1187571"/>
            <a:chExt cx="1980001" cy="6004835"/>
          </a:xfrm>
        </p:grpSpPr>
        <p:pic>
          <p:nvPicPr>
            <p:cNvPr id="38" name="Picture 37" descr="A close-up of a black and white image&#10;&#10;AI-generated content may be incorrect.">
              <a:extLst>
                <a:ext uri="{FF2B5EF4-FFF2-40B4-BE49-F238E27FC236}">
                  <a16:creationId xmlns:a16="http://schemas.microsoft.com/office/drawing/2014/main" id="{ED2FB562-438E-0F2F-302B-0C8A4F86FC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00332" y="1187571"/>
              <a:ext cx="1980000" cy="1980000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80EB098A-76BC-97A1-B284-4A12C7E8BC1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00334" y="3199989"/>
              <a:ext cx="1979999" cy="1980000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CAAD7870-3CC6-9DDC-4E89-098EE0100BB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00334" y="5212406"/>
              <a:ext cx="1979999" cy="1980000"/>
            </a:xfrm>
            <a:prstGeom prst="rect">
              <a:avLst/>
            </a:prstGeom>
          </p:spPr>
        </p:pic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FDBF5B18-6F03-862F-E4D6-92A8F8AC21AF}"/>
              </a:ext>
            </a:extLst>
          </p:cNvPr>
          <p:cNvSpPr txBox="1"/>
          <p:nvPr/>
        </p:nvSpPr>
        <p:spPr>
          <a:xfrm rot="16200000">
            <a:off x="175475" y="904427"/>
            <a:ext cx="7083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ehicl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6071A44-3422-1AC5-EC70-3A220BA084EA}"/>
              </a:ext>
            </a:extLst>
          </p:cNvPr>
          <p:cNvSpPr txBox="1"/>
          <p:nvPr/>
        </p:nvSpPr>
        <p:spPr>
          <a:xfrm rot="16200000">
            <a:off x="27482" y="2067641"/>
            <a:ext cx="10042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4hrs NALL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F265942-9944-5392-1028-949FBA1EAE3F}"/>
              </a:ext>
            </a:extLst>
          </p:cNvPr>
          <p:cNvSpPr txBox="1"/>
          <p:nvPr/>
        </p:nvSpPr>
        <p:spPr>
          <a:xfrm rot="16200000">
            <a:off x="21865" y="3410824"/>
            <a:ext cx="10042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2hrs NALL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614CE07-482A-7D3C-213B-A4F8FB032181}"/>
              </a:ext>
            </a:extLst>
          </p:cNvPr>
          <p:cNvSpPr txBox="1"/>
          <p:nvPr/>
        </p:nvSpPr>
        <p:spPr>
          <a:xfrm>
            <a:off x="888060" y="68246"/>
            <a:ext cx="9857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PC1 P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6ACB5F3-6C4B-8561-E197-DBC250E5B07D}"/>
              </a:ext>
            </a:extLst>
          </p:cNvPr>
          <p:cNvSpPr txBox="1"/>
          <p:nvPr/>
        </p:nvSpPr>
        <p:spPr>
          <a:xfrm>
            <a:off x="337571" y="166336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F54F1B5-F8C0-ECAB-CAA4-B9ADADD3232F}"/>
              </a:ext>
            </a:extLst>
          </p:cNvPr>
          <p:cNvSpPr txBox="1"/>
          <p:nvPr/>
        </p:nvSpPr>
        <p:spPr>
          <a:xfrm>
            <a:off x="3960732" y="166336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759B044-6929-FC0F-5CDA-946584805CA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2844" y="4233949"/>
            <a:ext cx="4494362" cy="449436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35C7179-B310-3D7B-3C43-30C75AB8F2B7}"/>
              </a:ext>
            </a:extLst>
          </p:cNvPr>
          <p:cNvSpPr txBox="1"/>
          <p:nvPr/>
        </p:nvSpPr>
        <p:spPr>
          <a:xfrm>
            <a:off x="285750" y="8640916"/>
            <a:ext cx="628649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kern="0" dirty="0">
                <a:effectLst/>
                <a:ea typeface="Times New Roman" panose="02020603050405020304" pitchFamily="18" charset="0"/>
              </a:rPr>
              <a:t>Supplemental Figure S1. A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)</a:t>
            </a:r>
            <a:r>
              <a:rPr lang="en-GB" sz="1200" dirty="0">
                <a:effectLst/>
              </a:rPr>
              <a:t> Representative images of filipin-stained cholesterol in 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NPC1 patient-derived </a:t>
            </a:r>
            <a:r>
              <a:rPr lang="en-GB" sz="1200" kern="0" dirty="0">
                <a:ea typeface="Times New Roman" panose="02020603050405020304" pitchFamily="18" charset="0"/>
              </a:rPr>
              <a:t>fibroblasts treated with NALL for 24-72 hours as indicated. Scale bar, 50</a:t>
            </a:r>
            <a:r>
              <a:rPr lang="en-GB" sz="1200" kern="0" dirty="0">
                <a:latin typeface="Symbol" pitchFamily="2" charset="2"/>
                <a:ea typeface="Times New Roman" panose="02020603050405020304" pitchFamily="18" charset="0"/>
              </a:rPr>
              <a:t>m</a:t>
            </a:r>
            <a:r>
              <a:rPr lang="en-GB" sz="1200" kern="0" dirty="0">
                <a:ea typeface="Times New Roman" panose="02020603050405020304" pitchFamily="18" charset="0"/>
              </a:rPr>
              <a:t>m. </a:t>
            </a:r>
            <a:r>
              <a:rPr lang="en-GB" sz="1200" b="1" kern="0" dirty="0">
                <a:ea typeface="Times New Roman" panose="02020603050405020304" pitchFamily="18" charset="0"/>
              </a:rPr>
              <a:t>B</a:t>
            </a:r>
            <a:r>
              <a:rPr lang="en-GB" sz="1200" kern="0" dirty="0">
                <a:ea typeface="Times New Roman" panose="02020603050405020304" pitchFamily="18" charset="0"/>
              </a:rPr>
              <a:t>) Quantitation of filipin-stained cholesterol in NPC1 patient cells following incubation with NALL for the specified periods.  </a:t>
            </a:r>
            <a:r>
              <a:rPr lang="en-GB" sz="1200" b="1" kern="0" dirty="0">
                <a:ea typeface="Times New Roman" panose="02020603050405020304" pitchFamily="18" charset="0"/>
              </a:rPr>
              <a:t>C</a:t>
            </a:r>
            <a:r>
              <a:rPr lang="en-GB" sz="1200" kern="0" dirty="0">
                <a:ea typeface="Times New Roman" panose="02020603050405020304" pitchFamily="18" charset="0"/>
              </a:rPr>
              <a:t>) Example images showing differences in filipin-stained cholesterol in NPC1 patient cells following 72 hours incubation with NALL. Scale bar, 50</a:t>
            </a:r>
            <a:r>
              <a:rPr lang="el-GR" sz="1200" kern="0" dirty="0">
                <a:ea typeface="Times New Roman" panose="02020603050405020304" pitchFamily="18" charset="0"/>
              </a:rPr>
              <a:t>μ</a:t>
            </a:r>
            <a:r>
              <a:rPr lang="en-GB" sz="1200" kern="0" dirty="0">
                <a:ea typeface="Times New Roman" panose="02020603050405020304" pitchFamily="18" charset="0"/>
              </a:rPr>
              <a:t>m </a:t>
            </a:r>
            <a:r>
              <a:rPr lang="en-GB" sz="1200" b="1" kern="0" dirty="0">
                <a:ea typeface="Times New Roman" panose="02020603050405020304" pitchFamily="18" charset="0"/>
              </a:rPr>
              <a:t>D</a:t>
            </a:r>
            <a:r>
              <a:rPr lang="en-GB" sz="1200" kern="0" dirty="0">
                <a:ea typeface="Times New Roman" panose="02020603050405020304" pitchFamily="18" charset="0"/>
              </a:rPr>
              <a:t>) Quantitation of effect of 72 hours treatment with NALL or 48 hours with LPDS in individual cell lines.</a:t>
            </a:r>
            <a:endParaRPr lang="en-US" sz="12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20D4849-2B3B-0404-6632-321DB811BD88}"/>
              </a:ext>
            </a:extLst>
          </p:cNvPr>
          <p:cNvSpPr txBox="1"/>
          <p:nvPr/>
        </p:nvSpPr>
        <p:spPr>
          <a:xfrm>
            <a:off x="337571" y="4273403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37906323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59">
            <a:extLst>
              <a:ext uri="{FF2B5EF4-FFF2-40B4-BE49-F238E27FC236}">
                <a16:creationId xmlns:a16="http://schemas.microsoft.com/office/drawing/2014/main" id="{9C6B84A5-A245-5B36-2ABF-09B8C58B5864}"/>
              </a:ext>
            </a:extLst>
          </p:cNvPr>
          <p:cNvSpPr txBox="1"/>
          <p:nvPr/>
        </p:nvSpPr>
        <p:spPr>
          <a:xfrm>
            <a:off x="2081295" y="3491360"/>
            <a:ext cx="4289668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Supplemental Figure S2. </a:t>
            </a:r>
            <a:r>
              <a:rPr lang="en-US" sz="1200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F</a:t>
            </a:r>
            <a:r>
              <a:rPr lang="en-US" sz="1200" kern="0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ibroblasts from healthy control donor 1 and 2 (HC D1/D2) or from </a:t>
            </a:r>
            <a:r>
              <a:rPr lang="en-US" sz="1200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NPC1 patients P1 and P3 were cultured ± NALL for 72 hours prior to fixation and ER:LE/Lys PLA. </a:t>
            </a:r>
            <a:r>
              <a:rPr lang="en-GB" sz="1200" b="1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A) </a:t>
            </a:r>
            <a:r>
              <a:rPr lang="en-US" sz="1200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Representative images of ER:LE/Lys PLA.</a:t>
            </a:r>
            <a:r>
              <a:rPr lang="en-US" sz="1200" kern="0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200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Scale bar, 50mm. </a:t>
            </a:r>
            <a:r>
              <a:rPr lang="en-US" sz="1200" b="1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B) </a:t>
            </a:r>
            <a:r>
              <a:rPr lang="en-US" sz="1200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Quantitation of PLA spots per cell normalized to controls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</a:rPr>
              <a:t>Data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</a:rPr>
              <a:t>analyse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</a:rPr>
              <a:t> by one-way ANOVA followed by Tukey’s multiple comparisons test, comparing all groups (* p ≤ 0.05, ** p ≤ 0.01, *** p ≤ 0.001, ns = non-significant, n = 3).</a:t>
            </a:r>
            <a:endParaRPr lang="en-GB" sz="1200" dirty="0"/>
          </a:p>
        </p:txBody>
      </p:sp>
      <p:grpSp>
        <p:nvGrpSpPr>
          <p:cNvPr id="96" name="Group 95">
            <a:extLst>
              <a:ext uri="{FF2B5EF4-FFF2-40B4-BE49-F238E27FC236}">
                <a16:creationId xmlns:a16="http://schemas.microsoft.com/office/drawing/2014/main" id="{EABC7AF9-4ECA-30EF-5BCD-B1DDB7B32655}"/>
              </a:ext>
            </a:extLst>
          </p:cNvPr>
          <p:cNvGrpSpPr/>
          <p:nvPr/>
        </p:nvGrpSpPr>
        <p:grpSpPr>
          <a:xfrm>
            <a:off x="1525691" y="8199222"/>
            <a:ext cx="571500" cy="306346"/>
            <a:chOff x="1505097" y="8129201"/>
            <a:chExt cx="571500" cy="563412"/>
          </a:xfrm>
        </p:grpSpPr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B2BEBEBE-3B7D-6EAC-E005-E635219BB231}"/>
                </a:ext>
              </a:extLst>
            </p:cNvPr>
            <p:cNvCxnSpPr/>
            <p:nvPr/>
          </p:nvCxnSpPr>
          <p:spPr>
            <a:xfrm>
              <a:off x="1593795" y="8153824"/>
              <a:ext cx="358948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Text Box 16">
              <a:extLst>
                <a:ext uri="{FF2B5EF4-FFF2-40B4-BE49-F238E27FC236}">
                  <a16:creationId xmlns:a16="http://schemas.microsoft.com/office/drawing/2014/main" id="{AD986766-76C2-3BFF-EE71-D6C63298FE36}"/>
                </a:ext>
              </a:extLst>
            </p:cNvPr>
            <p:cNvSpPr txBox="1"/>
            <p:nvPr/>
          </p:nvSpPr>
          <p:spPr>
            <a:xfrm>
              <a:off x="1505097" y="8129201"/>
              <a:ext cx="571500" cy="563412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US" sz="600" b="1" kern="100" dirty="0">
                  <a:solidFill>
                    <a:srgbClr val="FFFFFF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rPr>
                <a:t>50μm</a:t>
              </a:r>
              <a:endParaRPr lang="en-GB" sz="11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1" name="Group 90">
            <a:extLst>
              <a:ext uri="{FF2B5EF4-FFF2-40B4-BE49-F238E27FC236}">
                <a16:creationId xmlns:a16="http://schemas.microsoft.com/office/drawing/2014/main" id="{671F10C4-C831-0879-F903-24C589501CFB}"/>
              </a:ext>
            </a:extLst>
          </p:cNvPr>
          <p:cNvGrpSpPr/>
          <p:nvPr/>
        </p:nvGrpSpPr>
        <p:grpSpPr>
          <a:xfrm>
            <a:off x="319241" y="343476"/>
            <a:ext cx="5609272" cy="2945291"/>
            <a:chOff x="105728" y="1762069"/>
            <a:chExt cx="5719830" cy="3003342"/>
          </a:xfrm>
        </p:grpSpPr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1962CA70-003E-C549-8C35-C9F7C7C12445}"/>
                </a:ext>
              </a:extLst>
            </p:cNvPr>
            <p:cNvGrpSpPr/>
            <p:nvPr/>
          </p:nvGrpSpPr>
          <p:grpSpPr>
            <a:xfrm>
              <a:off x="349635" y="2049247"/>
              <a:ext cx="5475923" cy="2716164"/>
              <a:chOff x="324200" y="2068507"/>
              <a:chExt cx="5475923" cy="2716164"/>
            </a:xfrm>
          </p:grpSpPr>
          <p:pic>
            <p:nvPicPr>
              <p:cNvPr id="68" name="Picture 67">
                <a:extLst>
                  <a:ext uri="{FF2B5EF4-FFF2-40B4-BE49-F238E27FC236}">
                    <a16:creationId xmlns:a16="http://schemas.microsoft.com/office/drawing/2014/main" id="{49C7858F-EA8A-4196-1342-F2DBAA6655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92809" y="2068507"/>
                <a:ext cx="1350000" cy="1350000"/>
              </a:xfrm>
              <a:prstGeom prst="rect">
                <a:avLst/>
              </a:prstGeom>
            </p:spPr>
          </p:pic>
          <p:pic>
            <p:nvPicPr>
              <p:cNvPr id="69" name="Picture 68">
                <a:extLst>
                  <a:ext uri="{FF2B5EF4-FFF2-40B4-BE49-F238E27FC236}">
                    <a16:creationId xmlns:a16="http://schemas.microsoft.com/office/drawing/2014/main" id="{5B0334F0-4ECA-C6EF-B236-8C8E56E02F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99508" y="3434671"/>
                <a:ext cx="1350000" cy="1350000"/>
              </a:xfrm>
              <a:prstGeom prst="rect">
                <a:avLst/>
              </a:prstGeom>
            </p:spPr>
          </p:pic>
          <p:pic>
            <p:nvPicPr>
              <p:cNvPr id="70" name="Picture 69">
                <a:extLst>
                  <a:ext uri="{FF2B5EF4-FFF2-40B4-BE49-F238E27FC236}">
                    <a16:creationId xmlns:a16="http://schemas.microsoft.com/office/drawing/2014/main" id="{D00AA714-ACF2-2614-40E4-D76F93BA07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4200" y="2068507"/>
                <a:ext cx="1350000" cy="1350000"/>
              </a:xfrm>
              <a:prstGeom prst="rect">
                <a:avLst/>
              </a:prstGeom>
            </p:spPr>
          </p:pic>
          <p:pic>
            <p:nvPicPr>
              <p:cNvPr id="71" name="Picture 70">
                <a:extLst>
                  <a:ext uri="{FF2B5EF4-FFF2-40B4-BE49-F238E27FC236}">
                    <a16:creationId xmlns:a16="http://schemas.microsoft.com/office/drawing/2014/main" id="{B4BB6F87-9FCC-2EF1-4099-7A61151C26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4200" y="3434671"/>
                <a:ext cx="1350000" cy="1350000"/>
              </a:xfrm>
              <a:prstGeom prst="rect">
                <a:avLst/>
              </a:prstGeom>
            </p:spPr>
          </p:pic>
          <p:pic>
            <p:nvPicPr>
              <p:cNvPr id="72" name="Picture 71">
                <a:extLst>
                  <a:ext uri="{FF2B5EF4-FFF2-40B4-BE49-F238E27FC236}">
                    <a16:creationId xmlns:a16="http://schemas.microsoft.com/office/drawing/2014/main" id="{F73EE402-2FCE-E068-693D-FDE2E9535B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450123" y="2068507"/>
                <a:ext cx="1350000" cy="1350000"/>
              </a:xfrm>
              <a:prstGeom prst="rect">
                <a:avLst/>
              </a:prstGeom>
            </p:spPr>
          </p:pic>
          <p:pic>
            <p:nvPicPr>
              <p:cNvPr id="73" name="Picture 72">
                <a:extLst>
                  <a:ext uri="{FF2B5EF4-FFF2-40B4-BE49-F238E27FC236}">
                    <a16:creationId xmlns:a16="http://schemas.microsoft.com/office/drawing/2014/main" id="{546347DA-96B7-2AD3-B177-8BC09B3C7D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071466" y="2068507"/>
                <a:ext cx="1350000" cy="1350000"/>
              </a:xfrm>
              <a:prstGeom prst="rect">
                <a:avLst/>
              </a:prstGeom>
            </p:spPr>
          </p:pic>
          <p:pic>
            <p:nvPicPr>
              <p:cNvPr id="74" name="Picture 73">
                <a:extLst>
                  <a:ext uri="{FF2B5EF4-FFF2-40B4-BE49-F238E27FC236}">
                    <a16:creationId xmlns:a16="http://schemas.microsoft.com/office/drawing/2014/main" id="{1A327ABE-C9B4-CCA7-92CC-3135117A411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450123" y="3434671"/>
                <a:ext cx="1350000" cy="1350000"/>
              </a:xfrm>
              <a:prstGeom prst="rect">
                <a:avLst/>
              </a:prstGeom>
            </p:spPr>
          </p:pic>
          <p:pic>
            <p:nvPicPr>
              <p:cNvPr id="75" name="Picture 74">
                <a:extLst>
                  <a:ext uri="{FF2B5EF4-FFF2-40B4-BE49-F238E27FC236}">
                    <a16:creationId xmlns:a16="http://schemas.microsoft.com/office/drawing/2014/main" id="{AC8AB2E3-8AC8-4935-61FA-13C8AD9AB1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074816" y="3434671"/>
                <a:ext cx="1350000" cy="1350000"/>
              </a:xfrm>
              <a:prstGeom prst="rect">
                <a:avLst/>
              </a:prstGeom>
            </p:spPr>
          </p:pic>
        </p:grp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0E5DA328-C028-6391-F197-0A8B4F1B2900}"/>
                </a:ext>
              </a:extLst>
            </p:cNvPr>
            <p:cNvGrpSpPr/>
            <p:nvPr/>
          </p:nvGrpSpPr>
          <p:grpSpPr>
            <a:xfrm>
              <a:off x="446251" y="1781119"/>
              <a:ext cx="1143928" cy="260583"/>
              <a:chOff x="446251" y="1781119"/>
              <a:chExt cx="1143928" cy="260583"/>
            </a:xfrm>
          </p:grpSpPr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5935AD5F-9BC4-1B51-4866-7192D47EAC2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251" y="1995731"/>
                <a:ext cx="1143928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8" name="Text Box 14">
                <a:extLst>
                  <a:ext uri="{FF2B5EF4-FFF2-40B4-BE49-F238E27FC236}">
                    <a16:creationId xmlns:a16="http://schemas.microsoft.com/office/drawing/2014/main" id="{BC0135B3-9D62-3380-7100-75272AE2368F}"/>
                  </a:ext>
                </a:extLst>
              </p:cNvPr>
              <p:cNvSpPr txBox="1"/>
              <p:nvPr/>
            </p:nvSpPr>
            <p:spPr>
              <a:xfrm>
                <a:off x="617978" y="1781119"/>
                <a:ext cx="762738" cy="260583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100" kern="100" dirty="0">
                    <a:effectLst/>
                    <a:latin typeface="Arial" panose="020B0604020202020204" pitchFamily="34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HC D1</a:t>
                </a:r>
                <a:endParaRPr lang="en-GB" sz="1100" kern="100" dirty="0">
                  <a:effectLst/>
                  <a:latin typeface="Aptos" panose="020B00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F8BAA922-383B-1BA4-4980-27DCE162A53E}"/>
                </a:ext>
              </a:extLst>
            </p:cNvPr>
            <p:cNvGrpSpPr/>
            <p:nvPr/>
          </p:nvGrpSpPr>
          <p:grpSpPr>
            <a:xfrm>
              <a:off x="1817851" y="1771594"/>
              <a:ext cx="1143928" cy="260583"/>
              <a:chOff x="446251" y="1781119"/>
              <a:chExt cx="1143928" cy="260583"/>
            </a:xfrm>
          </p:grpSpPr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FB47C4F8-507F-3A19-5896-4E2D9D2013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251" y="1995731"/>
                <a:ext cx="1143928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2" name="Text Box 14">
                <a:extLst>
                  <a:ext uri="{FF2B5EF4-FFF2-40B4-BE49-F238E27FC236}">
                    <a16:creationId xmlns:a16="http://schemas.microsoft.com/office/drawing/2014/main" id="{B7C535D9-1C98-D850-1054-D4A551F4D801}"/>
                  </a:ext>
                </a:extLst>
              </p:cNvPr>
              <p:cNvSpPr txBox="1"/>
              <p:nvPr/>
            </p:nvSpPr>
            <p:spPr>
              <a:xfrm>
                <a:off x="617978" y="1781119"/>
                <a:ext cx="762738" cy="260583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100" kern="100" dirty="0">
                    <a:effectLst/>
                    <a:latin typeface="Arial" panose="020B0604020202020204" pitchFamily="34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HC D2</a:t>
                </a:r>
              </a:p>
            </p:txBody>
          </p:sp>
        </p:grp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2E49F4A0-F1EA-5E27-D62C-AF334F9182EC}"/>
                </a:ext>
              </a:extLst>
            </p:cNvPr>
            <p:cNvGrpSpPr/>
            <p:nvPr/>
          </p:nvGrpSpPr>
          <p:grpSpPr>
            <a:xfrm>
              <a:off x="3246601" y="1781119"/>
              <a:ext cx="1143928" cy="260583"/>
              <a:chOff x="446251" y="1781119"/>
              <a:chExt cx="1143928" cy="260583"/>
            </a:xfrm>
          </p:grpSpPr>
          <p:cxnSp>
            <p:nvCxnSpPr>
              <p:cNvPr id="84" name="Straight Connector 83">
                <a:extLst>
                  <a:ext uri="{FF2B5EF4-FFF2-40B4-BE49-F238E27FC236}">
                    <a16:creationId xmlns:a16="http://schemas.microsoft.com/office/drawing/2014/main" id="{960B5180-8C4F-AB42-FBB7-E4D521E8C7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251" y="1995731"/>
                <a:ext cx="1143928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5" name="Text Box 14">
                <a:extLst>
                  <a:ext uri="{FF2B5EF4-FFF2-40B4-BE49-F238E27FC236}">
                    <a16:creationId xmlns:a16="http://schemas.microsoft.com/office/drawing/2014/main" id="{C52F30FC-9CE2-EE37-3EF3-B20FA7C5F434}"/>
                  </a:ext>
                </a:extLst>
              </p:cNvPr>
              <p:cNvSpPr txBox="1"/>
              <p:nvPr/>
            </p:nvSpPr>
            <p:spPr>
              <a:xfrm>
                <a:off x="617978" y="1781119"/>
                <a:ext cx="867922" cy="260583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100" kern="100" dirty="0">
                    <a:latin typeface="Arial" panose="020B0604020202020204" pitchFamily="34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NPC1 P1</a:t>
                </a:r>
                <a:endParaRPr lang="en-GB" sz="1100" kern="100" dirty="0">
                  <a:effectLst/>
                  <a:latin typeface="Aptos" panose="020B00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681EF119-E54A-6E90-4B47-327A056C1F9C}"/>
                </a:ext>
              </a:extLst>
            </p:cNvPr>
            <p:cNvGrpSpPr/>
            <p:nvPr/>
          </p:nvGrpSpPr>
          <p:grpSpPr>
            <a:xfrm>
              <a:off x="4561051" y="1762069"/>
              <a:ext cx="1143928" cy="260583"/>
              <a:chOff x="446251" y="1781119"/>
              <a:chExt cx="1143928" cy="260583"/>
            </a:xfrm>
          </p:grpSpPr>
          <p:cxnSp>
            <p:nvCxnSpPr>
              <p:cNvPr id="87" name="Straight Connector 86">
                <a:extLst>
                  <a:ext uri="{FF2B5EF4-FFF2-40B4-BE49-F238E27FC236}">
                    <a16:creationId xmlns:a16="http://schemas.microsoft.com/office/drawing/2014/main" id="{4BD93031-9DB5-F89D-F42F-B80F301574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251" y="1995731"/>
                <a:ext cx="1143928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8" name="Text Box 14">
                <a:extLst>
                  <a:ext uri="{FF2B5EF4-FFF2-40B4-BE49-F238E27FC236}">
                    <a16:creationId xmlns:a16="http://schemas.microsoft.com/office/drawing/2014/main" id="{0CC09EC6-1492-C3B5-D9AB-D91A6F96E7F0}"/>
                  </a:ext>
                </a:extLst>
              </p:cNvPr>
              <p:cNvSpPr txBox="1"/>
              <p:nvPr/>
            </p:nvSpPr>
            <p:spPr>
              <a:xfrm>
                <a:off x="617978" y="1781119"/>
                <a:ext cx="906022" cy="260583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sz="1100" kern="100" dirty="0">
                    <a:effectLst/>
                    <a:latin typeface="Arial" panose="020B0604020202020204" pitchFamily="34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NPC1 P3</a:t>
                </a:r>
                <a:endParaRPr lang="en-GB" sz="1100" kern="100" dirty="0">
                  <a:effectLst/>
                  <a:latin typeface="Aptos" panose="020B00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9" name="Text Box 14">
              <a:extLst>
                <a:ext uri="{FF2B5EF4-FFF2-40B4-BE49-F238E27FC236}">
                  <a16:creationId xmlns:a16="http://schemas.microsoft.com/office/drawing/2014/main" id="{B3050C2F-07A5-DE7D-935C-E0590C194C22}"/>
                </a:ext>
              </a:extLst>
            </p:cNvPr>
            <p:cNvSpPr txBox="1"/>
            <p:nvPr/>
          </p:nvSpPr>
          <p:spPr>
            <a:xfrm rot="16200000">
              <a:off x="-139223" y="2694303"/>
              <a:ext cx="762157" cy="27225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rPr>
                <a:t>Vehicle</a:t>
              </a:r>
              <a:endParaRPr lang="en-GB" sz="11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Text Box 14">
              <a:extLst>
                <a:ext uri="{FF2B5EF4-FFF2-40B4-BE49-F238E27FC236}">
                  <a16:creationId xmlns:a16="http://schemas.microsoft.com/office/drawing/2014/main" id="{71DFEF21-BE0E-0A30-EA4F-9C50268DFB5A}"/>
                </a:ext>
              </a:extLst>
            </p:cNvPr>
            <p:cNvSpPr txBox="1"/>
            <p:nvPr/>
          </p:nvSpPr>
          <p:spPr>
            <a:xfrm rot="16200000">
              <a:off x="-120173" y="3875403"/>
              <a:ext cx="762157" cy="27225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rPr>
                <a:t>NALL</a:t>
              </a:r>
              <a:endParaRPr lang="en-GB" sz="11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2" name="TextBox 91">
            <a:extLst>
              <a:ext uri="{FF2B5EF4-FFF2-40B4-BE49-F238E27FC236}">
                <a16:creationId xmlns:a16="http://schemas.microsoft.com/office/drawing/2014/main" id="{BB8A7F3A-750E-0B1D-9701-730589BC77F9}"/>
              </a:ext>
            </a:extLst>
          </p:cNvPr>
          <p:cNvSpPr txBox="1"/>
          <p:nvPr/>
        </p:nvSpPr>
        <p:spPr>
          <a:xfrm>
            <a:off x="192690" y="297802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07EED8CC-5B55-B3F8-192D-DA125D6BBABE}"/>
              </a:ext>
            </a:extLst>
          </p:cNvPr>
          <p:cNvSpPr txBox="1"/>
          <p:nvPr/>
        </p:nvSpPr>
        <p:spPr>
          <a:xfrm>
            <a:off x="192690" y="3279127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grpSp>
        <p:nvGrpSpPr>
          <p:cNvPr id="97" name="Group 96">
            <a:extLst>
              <a:ext uri="{FF2B5EF4-FFF2-40B4-BE49-F238E27FC236}">
                <a16:creationId xmlns:a16="http://schemas.microsoft.com/office/drawing/2014/main" id="{929CB7B7-DDC5-C431-D15F-8E075BCB3B24}"/>
              </a:ext>
            </a:extLst>
          </p:cNvPr>
          <p:cNvGrpSpPr/>
          <p:nvPr/>
        </p:nvGrpSpPr>
        <p:grpSpPr>
          <a:xfrm>
            <a:off x="1438189" y="1805276"/>
            <a:ext cx="571500" cy="315053"/>
            <a:chOff x="1529811" y="8091287"/>
            <a:chExt cx="571500" cy="563412"/>
          </a:xfrm>
        </p:grpSpPr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F882257A-5BC8-AAE9-6BF0-6B0D2ED76798}"/>
                </a:ext>
              </a:extLst>
            </p:cNvPr>
            <p:cNvCxnSpPr>
              <a:cxnSpLocks/>
            </p:cNvCxnSpPr>
            <p:nvPr/>
          </p:nvCxnSpPr>
          <p:spPr>
            <a:xfrm>
              <a:off x="1688757" y="8153824"/>
              <a:ext cx="263986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9" name="Text Box 16">
              <a:extLst>
                <a:ext uri="{FF2B5EF4-FFF2-40B4-BE49-F238E27FC236}">
                  <a16:creationId xmlns:a16="http://schemas.microsoft.com/office/drawing/2014/main" id="{CAEC696D-CD6F-B82B-D3F3-BC9C24E4731B}"/>
                </a:ext>
              </a:extLst>
            </p:cNvPr>
            <p:cNvSpPr txBox="1"/>
            <p:nvPr/>
          </p:nvSpPr>
          <p:spPr>
            <a:xfrm>
              <a:off x="1529811" y="8091287"/>
              <a:ext cx="571500" cy="563412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US" sz="500" b="1" kern="100" dirty="0">
                  <a:solidFill>
                    <a:srgbClr val="FFFFFF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rPr>
                <a:t>50μm</a:t>
              </a:r>
              <a:endParaRPr lang="en-GB" sz="11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07151B6F-3130-2FD8-FE83-A86AF934A93F}"/>
              </a:ext>
            </a:extLst>
          </p:cNvPr>
          <p:cNvGrpSpPr/>
          <p:nvPr/>
        </p:nvGrpSpPr>
        <p:grpSpPr>
          <a:xfrm>
            <a:off x="2780956" y="1805276"/>
            <a:ext cx="571500" cy="315053"/>
            <a:chOff x="1529811" y="8091287"/>
            <a:chExt cx="571500" cy="563412"/>
          </a:xfrm>
        </p:grpSpPr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DABE6F51-C6B2-E5D5-38E2-968AEBEC51D0}"/>
                </a:ext>
              </a:extLst>
            </p:cNvPr>
            <p:cNvCxnSpPr>
              <a:cxnSpLocks/>
            </p:cNvCxnSpPr>
            <p:nvPr/>
          </p:nvCxnSpPr>
          <p:spPr>
            <a:xfrm>
              <a:off x="1688757" y="8153824"/>
              <a:ext cx="263986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3" name="Text Box 16">
              <a:extLst>
                <a:ext uri="{FF2B5EF4-FFF2-40B4-BE49-F238E27FC236}">
                  <a16:creationId xmlns:a16="http://schemas.microsoft.com/office/drawing/2014/main" id="{F5CB0C87-D4DD-751E-22CE-B9601D01EC06}"/>
                </a:ext>
              </a:extLst>
            </p:cNvPr>
            <p:cNvSpPr txBox="1"/>
            <p:nvPr/>
          </p:nvSpPr>
          <p:spPr>
            <a:xfrm>
              <a:off x="1529811" y="8091287"/>
              <a:ext cx="571500" cy="563412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US" sz="500" b="1" kern="100" dirty="0">
                  <a:solidFill>
                    <a:srgbClr val="FFFFFF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rPr>
                <a:t>50μm</a:t>
              </a:r>
              <a:endParaRPr lang="en-GB" sz="11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E71177E7-689A-3102-80CD-4A9606876F6E}"/>
              </a:ext>
            </a:extLst>
          </p:cNvPr>
          <p:cNvGrpSpPr/>
          <p:nvPr/>
        </p:nvGrpSpPr>
        <p:grpSpPr>
          <a:xfrm>
            <a:off x="4127842" y="1801157"/>
            <a:ext cx="571500" cy="315053"/>
            <a:chOff x="1529811" y="8091287"/>
            <a:chExt cx="571500" cy="563412"/>
          </a:xfrm>
        </p:grpSpPr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FB0EED87-ECF0-BB7D-395E-E70DAF95842B}"/>
                </a:ext>
              </a:extLst>
            </p:cNvPr>
            <p:cNvCxnSpPr>
              <a:cxnSpLocks/>
            </p:cNvCxnSpPr>
            <p:nvPr/>
          </p:nvCxnSpPr>
          <p:spPr>
            <a:xfrm>
              <a:off x="1688757" y="8153824"/>
              <a:ext cx="263986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6" name="Text Box 16">
              <a:extLst>
                <a:ext uri="{FF2B5EF4-FFF2-40B4-BE49-F238E27FC236}">
                  <a16:creationId xmlns:a16="http://schemas.microsoft.com/office/drawing/2014/main" id="{19338B0C-550E-8FB1-EBBD-8E07EC37D49E}"/>
                </a:ext>
              </a:extLst>
            </p:cNvPr>
            <p:cNvSpPr txBox="1"/>
            <p:nvPr/>
          </p:nvSpPr>
          <p:spPr>
            <a:xfrm>
              <a:off x="1529811" y="8091287"/>
              <a:ext cx="571500" cy="563412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US" sz="500" b="1" kern="100" dirty="0">
                  <a:solidFill>
                    <a:srgbClr val="FFFFFF"/>
                  </a:solidFill>
                  <a:effectLst/>
                  <a:latin typeface="Arial" panose="020B06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rPr>
                <a:t>50μm</a:t>
              </a:r>
              <a:endParaRPr lang="en-GB" sz="11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7" name="TextBox 106">
            <a:extLst>
              <a:ext uri="{FF2B5EF4-FFF2-40B4-BE49-F238E27FC236}">
                <a16:creationId xmlns:a16="http://schemas.microsoft.com/office/drawing/2014/main" id="{B7FB0162-58FB-AE85-2C62-AE471CE27568}"/>
              </a:ext>
            </a:extLst>
          </p:cNvPr>
          <p:cNvSpPr txBox="1"/>
          <p:nvPr/>
        </p:nvSpPr>
        <p:spPr>
          <a:xfrm>
            <a:off x="530648" y="597209"/>
            <a:ext cx="14734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solidFill>
                  <a:srgbClr val="92D050"/>
                </a:solidFill>
              </a:rPr>
              <a:t>ER:LE/Lys PL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9741D2A-49A8-1A50-74E4-0AC2E0F0220E}"/>
              </a:ext>
            </a:extLst>
          </p:cNvPr>
          <p:cNvGrpSpPr/>
          <p:nvPr/>
        </p:nvGrpSpPr>
        <p:grpSpPr>
          <a:xfrm>
            <a:off x="296311" y="3338643"/>
            <a:ext cx="1798708" cy="2229222"/>
            <a:chOff x="296311" y="3338643"/>
            <a:chExt cx="1798708" cy="222922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7A9E5CA-5F9E-03F1-7C03-CF019E773970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512" t="4131" r="3875" b="6549"/>
            <a:stretch/>
          </p:blipFill>
          <p:spPr>
            <a:xfrm>
              <a:off x="296311" y="3379146"/>
              <a:ext cx="1798708" cy="2188719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36F35A86-8EEB-2CA0-B7A4-70FE292FA9DF}"/>
                </a:ext>
              </a:extLst>
            </p:cNvPr>
            <p:cNvSpPr/>
            <p:nvPr/>
          </p:nvSpPr>
          <p:spPr>
            <a:xfrm>
              <a:off x="707660" y="3338643"/>
              <a:ext cx="1373635" cy="20215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6434793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E69A45D-0156-A373-BD68-E2BF7560CE8E}"/>
              </a:ext>
            </a:extLst>
          </p:cNvPr>
          <p:cNvSpPr txBox="1"/>
          <p:nvPr/>
        </p:nvSpPr>
        <p:spPr>
          <a:xfrm>
            <a:off x="2448809" y="3941420"/>
            <a:ext cx="4008407" cy="2123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upplemental Figure S3. </a:t>
            </a:r>
            <a:r>
              <a:rPr lang="en-US" sz="1200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F</a:t>
            </a:r>
            <a:r>
              <a:rPr lang="en-US" sz="1200" kern="0" dirty="0">
                <a:solidFill>
                  <a:srgbClr val="00000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ibroblasts from healthy control donor 1 and 2 (HC D1/D2) or from </a:t>
            </a:r>
            <a:r>
              <a:rPr lang="en-US" sz="1200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NPC1 patients P1 and P3 were cultured ± NALL for 72 hours and incubated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</a:rPr>
              <a:t>with 5</a:t>
            </a:r>
            <a:r>
              <a:rPr lang="el-GR" sz="1200" b="0" i="0" u="none" strike="noStrike" dirty="0">
                <a:solidFill>
                  <a:srgbClr val="000000"/>
                </a:solidFill>
                <a:effectLst/>
              </a:rPr>
              <a:t>μ</a:t>
            </a:r>
            <a:r>
              <a:rPr lang="en-GB" sz="1200" b="0" i="0" u="none" strike="noStrike" dirty="0">
                <a:solidFill>
                  <a:srgbClr val="000000"/>
                </a:solidFill>
                <a:effectLst/>
              </a:rPr>
              <a:t>M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</a:rPr>
              <a:t> BODIPY prior to fixation.  </a:t>
            </a:r>
            <a:r>
              <a:rPr lang="en-GB" sz="1200" b="1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)</a:t>
            </a:r>
            <a:r>
              <a:rPr lang="en-GB" sz="1200" b="1" kern="0" dirty="0">
                <a:solidFill>
                  <a:srgbClr val="000000"/>
                </a:solidFill>
                <a:ea typeface="Times New Roman" panose="02020603050405020304" pitchFamily="18" charset="0"/>
              </a:rPr>
              <a:t> </a:t>
            </a:r>
            <a:r>
              <a:rPr lang="en-GB" sz="1200" kern="0" dirty="0">
                <a:solidFill>
                  <a:srgbClr val="000000"/>
                </a:solidFill>
                <a:ea typeface="Times New Roman" panose="02020603050405020304" pitchFamily="18" charset="0"/>
              </a:rPr>
              <a:t>Representative images of BODIPY lipid droplet staining (green)</a:t>
            </a:r>
            <a:r>
              <a:rPr lang="en-US" sz="1200" i="0" u="none" strike="noStrike" dirty="0">
                <a:solidFill>
                  <a:srgbClr val="000000"/>
                </a:solidFill>
                <a:effectLst/>
              </a:rPr>
              <a:t>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</a:rPr>
              <a:t>Scale bar, 50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Symbol" pitchFamily="2" charset="2"/>
              </a:rPr>
              <a:t>m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</a:rPr>
              <a:t>m. 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</a:rPr>
              <a:t>B)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</a:rPr>
              <a:t>Quantitation of  BODIPY spots per cell. Scatter plots show 2 NPC patient cell lines, both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</a:rPr>
              <a:t>normalise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</a:rPr>
              <a:t> to the healthy control average, </a:t>
            </a:r>
            <a:r>
              <a:rPr lang="en-GB" sz="1200" b="0" i="0" u="none" strike="noStrike" dirty="0">
                <a:solidFill>
                  <a:srgbClr val="222222"/>
                </a:solidFill>
                <a:effectLst/>
              </a:rPr>
              <a:t>centre lines show medians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</a:rPr>
              <a:t>Data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</a:rPr>
              <a:t>analyse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</a:rPr>
              <a:t> by one-way ANOVA followed by Tukey’s multiple comparisons test comparing all groups (* p ≤ 0.05, ** p ≤ 0.01, *** p ≤ 0.001, ns = non-significant, n = 2)</a:t>
            </a:r>
            <a:endParaRPr lang="en-US" sz="1200" dirty="0"/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CA7ABCCE-02F4-BA41-D3ED-97FCC89B9AC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14195"/>
          <a:stretch/>
        </p:blipFill>
        <p:spPr>
          <a:xfrm>
            <a:off x="446046" y="3951298"/>
            <a:ext cx="2002763" cy="2378558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E2A5F0C3-5AA9-F71C-3C34-2C3A69B49A83}"/>
              </a:ext>
            </a:extLst>
          </p:cNvPr>
          <p:cNvSpPr txBox="1"/>
          <p:nvPr/>
        </p:nvSpPr>
        <p:spPr>
          <a:xfrm>
            <a:off x="297600" y="3941420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A05D7D7-5F8E-A007-3C83-7BDC66A76F7D}"/>
              </a:ext>
            </a:extLst>
          </p:cNvPr>
          <p:cNvGrpSpPr/>
          <p:nvPr/>
        </p:nvGrpSpPr>
        <p:grpSpPr>
          <a:xfrm>
            <a:off x="383974" y="551079"/>
            <a:ext cx="6023550" cy="3152831"/>
            <a:chOff x="-45676" y="-34596"/>
            <a:chExt cx="6806761" cy="356302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FADB03BA-A89F-30BC-9DF7-DB21CE0A7DDD}"/>
                </a:ext>
              </a:extLst>
            </p:cNvPr>
            <p:cNvGrpSpPr/>
            <p:nvPr/>
          </p:nvGrpSpPr>
          <p:grpSpPr>
            <a:xfrm>
              <a:off x="214000" y="-34596"/>
              <a:ext cx="6547085" cy="3563021"/>
              <a:chOff x="0" y="33984"/>
              <a:chExt cx="6547085" cy="3563021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7D889DD4-3162-2762-D4F9-748561B0E58C}"/>
                  </a:ext>
                </a:extLst>
              </p:cNvPr>
              <p:cNvGrpSpPr/>
              <p:nvPr/>
            </p:nvGrpSpPr>
            <p:grpSpPr>
              <a:xfrm>
                <a:off x="0" y="335280"/>
                <a:ext cx="6547085" cy="3261725"/>
                <a:chOff x="0" y="0"/>
                <a:chExt cx="6547085" cy="3261725"/>
              </a:xfrm>
            </p:grpSpPr>
            <p:pic>
              <p:nvPicPr>
                <p:cNvPr id="19" name="Picture 18" descr="Green lights on a black background&#10;&#10;AI-generated content may be incorrect.">
                  <a:extLst>
                    <a:ext uri="{FF2B5EF4-FFF2-40B4-BE49-F238E27FC236}">
                      <a16:creationId xmlns:a16="http://schemas.microsoft.com/office/drawing/2014/main" id="{572AB1EC-6D18-4535-BC8C-0B09424B3DC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0" y="1641840"/>
                  <a:ext cx="1619885" cy="161988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20" name="Picture 19" descr="A green glowing cells in a dark background&#10;&#10;AI-generated content may be incorrect.">
                  <a:extLst>
                    <a:ext uri="{FF2B5EF4-FFF2-40B4-BE49-F238E27FC236}">
                      <a16:creationId xmlns:a16="http://schemas.microsoft.com/office/drawing/2014/main" id="{795FC7EA-D113-CFDF-8235-B625B80B5CF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39859" y="1641840"/>
                  <a:ext cx="1619885" cy="161988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21" name="Picture 20" descr="A green glowing cells in a dark space&#10;&#10;AI-generated content may be incorrect.">
                  <a:extLst>
                    <a:ext uri="{FF2B5EF4-FFF2-40B4-BE49-F238E27FC236}">
                      <a16:creationId xmlns:a16="http://schemas.microsoft.com/office/drawing/2014/main" id="{C904354E-F2D0-43B0-0BCB-3D9587418B7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84381" y="0"/>
                  <a:ext cx="1619885" cy="161988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22" name="Picture 21" descr="Green lights in the dark&#10;&#10;AI-generated content may be incorrect.">
                  <a:extLst>
                    <a:ext uri="{FF2B5EF4-FFF2-40B4-BE49-F238E27FC236}">
                      <a16:creationId xmlns:a16="http://schemas.microsoft.com/office/drawing/2014/main" id="{6336FF29-6F55-E4D0-69EF-DE4161584EE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27200" y="0"/>
                  <a:ext cx="1619885" cy="161988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23" name="Picture 22" descr="A green background with black and white spots&#10;&#10;AI-generated content may be incorrect.">
                  <a:extLst>
                    <a:ext uri="{FF2B5EF4-FFF2-40B4-BE49-F238E27FC236}">
                      <a16:creationId xmlns:a16="http://schemas.microsoft.com/office/drawing/2014/main" id="{D026C3D7-EA61-4206-21BB-001859E6008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 cstate="print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84381" y="1641840"/>
                  <a:ext cx="1619885" cy="161988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24" name="Picture 23" descr="Green lights on a black background&#10;&#10;AI-generated content may be incorrect.">
                  <a:extLst>
                    <a:ext uri="{FF2B5EF4-FFF2-40B4-BE49-F238E27FC236}">
                      <a16:creationId xmlns:a16="http://schemas.microsoft.com/office/drawing/2014/main" id="{E7012AF9-5E94-A0E4-9A47-48A2BCF2CA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 cstate="print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39859" y="0"/>
                  <a:ext cx="1619885" cy="161988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25" name="Picture 24" descr="Green glowing cells in a dark space&#10;&#10;AI-generated content may be incorrect.">
                  <a:extLst>
                    <a:ext uri="{FF2B5EF4-FFF2-40B4-BE49-F238E27FC236}">
                      <a16:creationId xmlns:a16="http://schemas.microsoft.com/office/drawing/2014/main" id="{C25CF53B-BFAE-E708-D4DD-812C679731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 cstate="print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0" y="0"/>
                  <a:ext cx="1619885" cy="161988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26" name="Picture 25" descr="A green glowing object in the dark&#10;&#10;AI-generated content may be incorrect.">
                  <a:extLst>
                    <a:ext uri="{FF2B5EF4-FFF2-40B4-BE49-F238E27FC236}">
                      <a16:creationId xmlns:a16="http://schemas.microsoft.com/office/drawing/2014/main" id="{79CCF1C8-E0E8-06A7-3A45-F359BD2CF6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7" cstate="print"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27200" y="1641840"/>
                  <a:ext cx="1619885" cy="161988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</p:grp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1184D13E-6049-C419-9964-7813A2C4EE39}"/>
                  </a:ext>
                </a:extLst>
              </p:cNvPr>
              <p:cNvGrpSpPr/>
              <p:nvPr/>
            </p:nvGrpSpPr>
            <p:grpSpPr>
              <a:xfrm>
                <a:off x="457200" y="33984"/>
                <a:ext cx="5927806" cy="312420"/>
                <a:chOff x="0" y="35504"/>
                <a:chExt cx="5927806" cy="326390"/>
              </a:xfrm>
            </p:grpSpPr>
            <p:sp>
              <p:nvSpPr>
                <p:cNvPr id="15" name="Text Box 14">
                  <a:extLst>
                    <a:ext uri="{FF2B5EF4-FFF2-40B4-BE49-F238E27FC236}">
                      <a16:creationId xmlns:a16="http://schemas.microsoft.com/office/drawing/2014/main" id="{F748C47B-5CE7-DDC7-5A12-EF6D54491B0E}"/>
                    </a:ext>
                  </a:extLst>
                </p:cNvPr>
                <p:cNvSpPr txBox="1"/>
                <p:nvPr/>
              </p:nvSpPr>
              <p:spPr>
                <a:xfrm>
                  <a:off x="0" y="35504"/>
                  <a:ext cx="914400" cy="326389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1100" kern="100" dirty="0">
                      <a:effectLst/>
                      <a:latin typeface="Arial" panose="020B0604020202020204" pitchFamily="34" charset="0"/>
                      <a:ea typeface="Aptos" panose="020B0004020202020204" pitchFamily="34" charset="0"/>
                      <a:cs typeface="Times New Roman" panose="02020603050405020304" pitchFamily="18" charset="0"/>
                    </a:rPr>
                    <a:t>HC D1</a:t>
                  </a:r>
                  <a:endParaRPr lang="en-GB" sz="1100" kern="100" dirty="0">
                    <a:effectLst/>
                    <a:latin typeface="Aptos" panose="020B0004020202020204" pitchFamily="34" charset="0"/>
                    <a:ea typeface="Aptos" panose="020B0004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Text Box 14">
                  <a:extLst>
                    <a:ext uri="{FF2B5EF4-FFF2-40B4-BE49-F238E27FC236}">
                      <a16:creationId xmlns:a16="http://schemas.microsoft.com/office/drawing/2014/main" id="{0107772F-0382-E940-6B7F-11933B19FFBF}"/>
                    </a:ext>
                  </a:extLst>
                </p:cNvPr>
                <p:cNvSpPr txBox="1"/>
                <p:nvPr/>
              </p:nvSpPr>
              <p:spPr>
                <a:xfrm>
                  <a:off x="1517939" y="35504"/>
                  <a:ext cx="914400" cy="326390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1100" kern="100" dirty="0">
                      <a:effectLst/>
                      <a:latin typeface="Arial" panose="020B0604020202020204" pitchFamily="34" charset="0"/>
                      <a:ea typeface="Aptos" panose="020B0004020202020204" pitchFamily="34" charset="0"/>
                      <a:cs typeface="Times New Roman" panose="02020603050405020304" pitchFamily="18" charset="0"/>
                    </a:rPr>
                    <a:t>HC D2</a:t>
                  </a:r>
                  <a:endParaRPr lang="en-GB" sz="1100" kern="100" dirty="0">
                    <a:effectLst/>
                    <a:latin typeface="Aptos" panose="020B0004020202020204" pitchFamily="34" charset="0"/>
                    <a:ea typeface="Aptos" panose="020B0004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Text Box 14">
                  <a:extLst>
                    <a:ext uri="{FF2B5EF4-FFF2-40B4-BE49-F238E27FC236}">
                      <a16:creationId xmlns:a16="http://schemas.microsoft.com/office/drawing/2014/main" id="{B2F2EC1D-AF3D-5DCA-B782-E46E4F5BFC73}"/>
                    </a:ext>
                  </a:extLst>
                </p:cNvPr>
                <p:cNvSpPr txBox="1"/>
                <p:nvPr/>
              </p:nvSpPr>
              <p:spPr>
                <a:xfrm>
                  <a:off x="3069012" y="35504"/>
                  <a:ext cx="1260140" cy="326389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1100" kern="100" dirty="0">
                      <a:effectLst/>
                      <a:latin typeface="Arial" panose="020B0604020202020204" pitchFamily="34" charset="0"/>
                      <a:ea typeface="Aptos" panose="020B0004020202020204" pitchFamily="34" charset="0"/>
                      <a:cs typeface="Times New Roman" panose="02020603050405020304" pitchFamily="18" charset="0"/>
                    </a:rPr>
                    <a:t>NPC1 P1</a:t>
                  </a:r>
                  <a:endParaRPr lang="en-GB" sz="1100" kern="100" dirty="0">
                    <a:effectLst/>
                    <a:latin typeface="Aptos" panose="020B0004020202020204" pitchFamily="34" charset="0"/>
                    <a:ea typeface="Aptos" panose="020B0004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Text Box 14">
                  <a:extLst>
                    <a:ext uri="{FF2B5EF4-FFF2-40B4-BE49-F238E27FC236}">
                      <a16:creationId xmlns:a16="http://schemas.microsoft.com/office/drawing/2014/main" id="{EDF11266-287C-5239-CE72-DE4065B11567}"/>
                    </a:ext>
                  </a:extLst>
                </p:cNvPr>
                <p:cNvSpPr txBox="1"/>
                <p:nvPr/>
              </p:nvSpPr>
              <p:spPr>
                <a:xfrm>
                  <a:off x="4811598" y="35504"/>
                  <a:ext cx="1116208" cy="326390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1100" kern="100" dirty="0">
                      <a:effectLst/>
                      <a:latin typeface="Arial" panose="020B0604020202020204" pitchFamily="34" charset="0"/>
                      <a:ea typeface="Aptos" panose="020B0004020202020204" pitchFamily="34" charset="0"/>
                      <a:cs typeface="Times New Roman" panose="02020603050405020304" pitchFamily="18" charset="0"/>
                    </a:rPr>
                    <a:t>NPC1 P2</a:t>
                  </a:r>
                  <a:endParaRPr lang="en-GB" sz="1100" kern="100" dirty="0">
                    <a:effectLst/>
                    <a:latin typeface="Aptos" panose="020B0004020202020204" pitchFamily="34" charset="0"/>
                    <a:ea typeface="Aptos" panose="020B000402020202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259A63C2-608F-D9C4-3A34-ED754095449D}"/>
                  </a:ext>
                </a:extLst>
              </p:cNvPr>
              <p:cNvGrpSpPr/>
              <p:nvPr/>
            </p:nvGrpSpPr>
            <p:grpSpPr>
              <a:xfrm>
                <a:off x="114300" y="301671"/>
                <a:ext cx="6338188" cy="1037"/>
                <a:chOff x="-228511" y="73071"/>
                <a:chExt cx="6339178" cy="1037"/>
              </a:xfrm>
            </p:grpSpPr>
            <p:cxnSp>
              <p:nvCxnSpPr>
                <p:cNvPr id="9" name="Straight Connector 8">
                  <a:extLst>
                    <a:ext uri="{FF2B5EF4-FFF2-40B4-BE49-F238E27FC236}">
                      <a16:creationId xmlns:a16="http://schemas.microsoft.com/office/drawing/2014/main" id="{D04BED18-6F4F-C6DA-F369-8D6DA4B53B3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228511" y="74107"/>
                  <a:ext cx="13716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5A0DFD31-FA52-83BF-5407-C4EEDEA3985B}"/>
                    </a:ext>
                  </a:extLst>
                </p:cNvPr>
                <p:cNvGrpSpPr/>
                <p:nvPr/>
              </p:nvGrpSpPr>
              <p:grpSpPr>
                <a:xfrm>
                  <a:off x="1411822" y="73071"/>
                  <a:ext cx="4698845" cy="1037"/>
                  <a:chOff x="-241718" y="73071"/>
                  <a:chExt cx="4698845" cy="1037"/>
                </a:xfrm>
              </p:grpSpPr>
              <p:cxnSp>
                <p:nvCxnSpPr>
                  <p:cNvPr id="12" name="Straight Connector 11">
                    <a:extLst>
                      <a:ext uri="{FF2B5EF4-FFF2-40B4-BE49-F238E27FC236}">
                        <a16:creationId xmlns:a16="http://schemas.microsoft.com/office/drawing/2014/main" id="{D4303004-0281-1FEF-46CB-9F22AD70CAF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-241718" y="74107"/>
                    <a:ext cx="1371599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" name="Straight Connector 12">
                    <a:extLst>
                      <a:ext uri="{FF2B5EF4-FFF2-40B4-BE49-F238E27FC236}">
                        <a16:creationId xmlns:a16="http://schemas.microsoft.com/office/drawing/2014/main" id="{A7F3C101-5DF5-828D-8C68-4391D070944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03066" y="74108"/>
                    <a:ext cx="1371599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" name="Straight Connector 13">
                    <a:extLst>
                      <a:ext uri="{FF2B5EF4-FFF2-40B4-BE49-F238E27FC236}">
                        <a16:creationId xmlns:a16="http://schemas.microsoft.com/office/drawing/2014/main" id="{6916D603-EBD6-8481-3EA7-8E7197ECE0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085528" y="73071"/>
                    <a:ext cx="1371599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4" name="Text Box 14">
              <a:extLst>
                <a:ext uri="{FF2B5EF4-FFF2-40B4-BE49-F238E27FC236}">
                  <a16:creationId xmlns:a16="http://schemas.microsoft.com/office/drawing/2014/main" id="{280B934C-5DE2-F94E-40BB-AE868A7E114D}"/>
                </a:ext>
              </a:extLst>
            </p:cNvPr>
            <p:cNvSpPr txBox="1"/>
            <p:nvPr/>
          </p:nvSpPr>
          <p:spPr>
            <a:xfrm rot="16200000">
              <a:off x="-327945" y="2448685"/>
              <a:ext cx="913766" cy="32639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rPr>
                <a:t>NALL</a:t>
              </a:r>
              <a:endParaRPr lang="en-GB" sz="11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 Box 14">
              <a:extLst>
                <a:ext uri="{FF2B5EF4-FFF2-40B4-BE49-F238E27FC236}">
                  <a16:creationId xmlns:a16="http://schemas.microsoft.com/office/drawing/2014/main" id="{E5AC293A-18D1-6042-C7B2-2EF397349785}"/>
                </a:ext>
              </a:extLst>
            </p:cNvPr>
            <p:cNvSpPr txBox="1"/>
            <p:nvPr/>
          </p:nvSpPr>
          <p:spPr>
            <a:xfrm rot="16200000">
              <a:off x="-339364" y="900375"/>
              <a:ext cx="913766" cy="32639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US" sz="11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rPr>
                <a:t>Vehicle</a:t>
              </a:r>
              <a:endParaRPr lang="en-GB" sz="11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57998FE0-B3A1-1E02-BAD1-B7C85C53693C}"/>
              </a:ext>
            </a:extLst>
          </p:cNvPr>
          <p:cNvSpPr txBox="1"/>
          <p:nvPr/>
        </p:nvSpPr>
        <p:spPr>
          <a:xfrm>
            <a:off x="297600" y="709758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AE482A5-EDC8-6A63-B92C-FEB2F1E22A1F}"/>
              </a:ext>
            </a:extLst>
          </p:cNvPr>
          <p:cNvSpPr txBox="1"/>
          <p:nvPr/>
        </p:nvSpPr>
        <p:spPr>
          <a:xfrm>
            <a:off x="535657" y="768514"/>
            <a:ext cx="14734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solidFill>
                  <a:srgbClr val="92D050"/>
                </a:solidFill>
              </a:rPr>
              <a:t>BODIPY</a:t>
            </a:r>
          </a:p>
        </p:txBody>
      </p:sp>
    </p:spTree>
    <p:extLst>
      <p:ext uri="{BB962C8B-B14F-4D97-AF65-F5344CB8AC3E}">
        <p14:creationId xmlns:p14="http://schemas.microsoft.com/office/powerpoint/2010/main" val="36565633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6B4F88F-58E7-19CE-D5FF-B6D495DA1E5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962" r="6472" b="3975"/>
          <a:stretch/>
        </p:blipFill>
        <p:spPr>
          <a:xfrm>
            <a:off x="4343544" y="299914"/>
            <a:ext cx="2471737" cy="3048767"/>
          </a:xfrm>
          <a:prstGeom prst="rect">
            <a:avLst/>
          </a:prstGeom>
        </p:spPr>
      </p:pic>
      <p:grpSp>
        <p:nvGrpSpPr>
          <p:cNvPr id="38" name="Group 37">
            <a:extLst>
              <a:ext uri="{FF2B5EF4-FFF2-40B4-BE49-F238E27FC236}">
                <a16:creationId xmlns:a16="http://schemas.microsoft.com/office/drawing/2014/main" id="{D7ACC79A-A242-4943-86E5-229529F93076}"/>
              </a:ext>
            </a:extLst>
          </p:cNvPr>
          <p:cNvGrpSpPr/>
          <p:nvPr/>
        </p:nvGrpSpPr>
        <p:grpSpPr>
          <a:xfrm>
            <a:off x="281652" y="235411"/>
            <a:ext cx="4118397" cy="4099980"/>
            <a:chOff x="776963" y="450118"/>
            <a:chExt cx="4118397" cy="409998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2EC911F-2B97-9DE6-7E8F-521EB75B88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22402" y="695643"/>
              <a:ext cx="1276900" cy="12769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8C27FC3-11BC-FFB0-0382-F00AA6EEBDD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618460" y="695644"/>
              <a:ext cx="1276900" cy="1276900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7696571-5512-80CC-12FD-CAD433AABEA6}"/>
                </a:ext>
              </a:extLst>
            </p:cNvPr>
            <p:cNvSpPr txBox="1"/>
            <p:nvPr/>
          </p:nvSpPr>
          <p:spPr>
            <a:xfrm>
              <a:off x="1194903" y="450118"/>
              <a:ext cx="959411" cy="266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HC D1</a:t>
              </a:r>
              <a:endPara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E40E6C1-6252-B400-2504-C82BDD1AA9E7}"/>
                </a:ext>
              </a:extLst>
            </p:cNvPr>
            <p:cNvSpPr txBox="1"/>
            <p:nvPr/>
          </p:nvSpPr>
          <p:spPr>
            <a:xfrm>
              <a:off x="2405564" y="450118"/>
              <a:ext cx="959411" cy="266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PC1 P1</a:t>
              </a:r>
              <a:endPara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683F27C-8E73-6686-F062-672E34E95E22}"/>
                </a:ext>
              </a:extLst>
            </p:cNvPr>
            <p:cNvSpPr txBox="1"/>
            <p:nvPr/>
          </p:nvSpPr>
          <p:spPr>
            <a:xfrm>
              <a:off x="3762399" y="450118"/>
              <a:ext cx="959411" cy="266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PC1 P3</a:t>
              </a:r>
              <a:endPara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26DF68D-98AE-E2FE-CB65-8DD8184DD2CA}"/>
                </a:ext>
              </a:extLst>
            </p:cNvPr>
            <p:cNvSpPr txBox="1"/>
            <p:nvPr/>
          </p:nvSpPr>
          <p:spPr>
            <a:xfrm rot="16200000">
              <a:off x="471601" y="1279432"/>
              <a:ext cx="9185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Vehicle</a:t>
              </a:r>
              <a:endPara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C5E0A3EB-55A7-ABF4-2486-B3204FCBF3C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618460" y="1984420"/>
              <a:ext cx="1276900" cy="12769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A83A64CF-01C0-9B61-52CA-F2EC45461D2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22402" y="1984420"/>
              <a:ext cx="1276900" cy="1276900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2777084-5FAF-5048-AA3B-99BE09280FE0}"/>
                </a:ext>
              </a:extLst>
            </p:cNvPr>
            <p:cNvSpPr txBox="1"/>
            <p:nvPr/>
          </p:nvSpPr>
          <p:spPr>
            <a:xfrm rot="16200000">
              <a:off x="579645" y="2479639"/>
              <a:ext cx="7024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ALL</a:t>
              </a:r>
              <a:endPara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C86457F-DC42-C70A-7814-0BCE2233F5BF}"/>
                </a:ext>
              </a:extLst>
            </p:cNvPr>
            <p:cNvSpPr txBox="1"/>
            <p:nvPr/>
          </p:nvSpPr>
          <p:spPr>
            <a:xfrm rot="16200000">
              <a:off x="582346" y="3744885"/>
              <a:ext cx="6970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LPDS</a:t>
              </a:r>
              <a:endPara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3FF5DDA6-A17E-8FD9-4DDB-10DA406A5F4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26344" y="695644"/>
              <a:ext cx="1276900" cy="1276900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6AF1C57D-F043-C95F-CDAC-2B63102CCED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26344" y="3273198"/>
              <a:ext cx="1276900" cy="1276900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F76A6B46-DF50-1AA6-ECA7-F89B35875D0F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26343" y="1984420"/>
              <a:ext cx="1276900" cy="1276900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941F1D7F-0DFE-1E63-1F95-A61C4AE2935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22402" y="3273198"/>
              <a:ext cx="1276900" cy="1276900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E87A2EDA-CA78-1702-FAFA-798B8CF896F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618460" y="3273198"/>
              <a:ext cx="1276900" cy="1276900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3AEA3C3-01C0-FD33-7F60-7C4911C61552}"/>
                </a:ext>
              </a:extLst>
            </p:cNvPr>
            <p:cNvSpPr txBox="1"/>
            <p:nvPr/>
          </p:nvSpPr>
          <p:spPr>
            <a:xfrm>
              <a:off x="1006369" y="697499"/>
              <a:ext cx="1473485" cy="3461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>
                  <a:solidFill>
                    <a:srgbClr val="92D050"/>
                  </a:solidFill>
                </a:rPr>
                <a:t>Mitochondria:LE</a:t>
              </a:r>
              <a:r>
                <a:rPr lang="en-US" sz="1000" b="1" dirty="0">
                  <a:solidFill>
                    <a:srgbClr val="92D050"/>
                  </a:solidFill>
                </a:rPr>
                <a:t>/Lys PLA</a:t>
              </a:r>
            </a:p>
            <a:p>
              <a:r>
                <a:rPr lang="en-US" sz="1000" b="1" dirty="0">
                  <a:solidFill>
                    <a:srgbClr val="B114B0"/>
                  </a:solidFill>
                </a:rPr>
                <a:t>Phalloidin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4D52ACA3-1740-69C0-20BE-A9E83FF274AC}"/>
              </a:ext>
            </a:extLst>
          </p:cNvPr>
          <p:cNvSpPr txBox="1"/>
          <p:nvPr/>
        </p:nvSpPr>
        <p:spPr>
          <a:xfrm>
            <a:off x="237555" y="4721121"/>
            <a:ext cx="514970" cy="28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C739D59-55EA-0581-4272-6C0DCDF95B08}"/>
              </a:ext>
            </a:extLst>
          </p:cNvPr>
          <p:cNvSpPr txBox="1"/>
          <p:nvPr/>
        </p:nvSpPr>
        <p:spPr>
          <a:xfrm>
            <a:off x="237555" y="337786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7BBBCF26-BD28-1DE1-2CF6-94EF9E6405ED}"/>
              </a:ext>
            </a:extLst>
          </p:cNvPr>
          <p:cNvGrpSpPr/>
          <p:nvPr/>
        </p:nvGrpSpPr>
        <p:grpSpPr>
          <a:xfrm>
            <a:off x="290366" y="4583582"/>
            <a:ext cx="2832783" cy="4403275"/>
            <a:chOff x="419521" y="1103376"/>
            <a:chExt cx="4795643" cy="6992212"/>
          </a:xfrm>
        </p:grpSpPr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0DA8DAFD-5CC0-DD44-1CEE-1A9C02D4D07E}"/>
                </a:ext>
              </a:extLst>
            </p:cNvPr>
            <p:cNvGrpSpPr/>
            <p:nvPr/>
          </p:nvGrpSpPr>
          <p:grpSpPr>
            <a:xfrm>
              <a:off x="824843" y="1524614"/>
              <a:ext cx="4390321" cy="6570974"/>
              <a:chOff x="609184" y="894886"/>
              <a:chExt cx="4390321" cy="6570974"/>
            </a:xfrm>
          </p:grpSpPr>
          <p:pic>
            <p:nvPicPr>
              <p:cNvPr id="46" name="Picture 45">
                <a:extLst>
                  <a:ext uri="{FF2B5EF4-FFF2-40B4-BE49-F238E27FC236}">
                    <a16:creationId xmlns:a16="http://schemas.microsoft.com/office/drawing/2014/main" id="{C2C4574F-758F-F1DC-66F7-91E210E445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09184" y="894886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33B047B9-EC13-BC41-0DB1-D0C3C747E2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826173" y="894886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48" name="Picture 47">
                <a:extLst>
                  <a:ext uri="{FF2B5EF4-FFF2-40B4-BE49-F238E27FC236}">
                    <a16:creationId xmlns:a16="http://schemas.microsoft.com/office/drawing/2014/main" id="{F72CF9AE-361A-DC31-F52D-CAA33A09E8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print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09184" y="3100373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A25D6969-AADD-363D-D3E5-1ADB858805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832695" y="3100373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50" name="Picture 49">
                <a:extLst>
                  <a:ext uri="{FF2B5EF4-FFF2-40B4-BE49-F238E27FC236}">
                    <a16:creationId xmlns:a16="http://schemas.microsoft.com/office/drawing/2014/main" id="{55A2C7AF-A144-29AA-DAA0-7BCB0AE362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 cstate="print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09184" y="5305860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6F2CFAA6-E7F5-5D95-AD65-7A9D6B5186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839505" y="5305860"/>
                <a:ext cx="2160000" cy="2160000"/>
              </a:xfrm>
              <a:prstGeom prst="rect">
                <a:avLst/>
              </a:prstGeom>
            </p:spPr>
          </p:pic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E37DD31-5CB0-2B88-4611-0BEE2E3E6ABC}"/>
                </a:ext>
              </a:extLst>
            </p:cNvPr>
            <p:cNvSpPr txBox="1"/>
            <p:nvPr/>
          </p:nvSpPr>
          <p:spPr>
            <a:xfrm>
              <a:off x="1164914" y="1103376"/>
              <a:ext cx="1471271" cy="4887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PC1 P1</a:t>
              </a:r>
              <a:endPara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DA1FA8D-6C63-D31D-FE22-53EFCE973CDE}"/>
                </a:ext>
              </a:extLst>
            </p:cNvPr>
            <p:cNvSpPr txBox="1"/>
            <p:nvPr/>
          </p:nvSpPr>
          <p:spPr>
            <a:xfrm>
              <a:off x="3450072" y="1103376"/>
              <a:ext cx="1471271" cy="4887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PC1 P2</a:t>
              </a:r>
              <a:endPara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589AA76-9E1C-5100-4681-EB1C33B66B6C}"/>
                </a:ext>
              </a:extLst>
            </p:cNvPr>
            <p:cNvSpPr txBox="1"/>
            <p:nvPr/>
          </p:nvSpPr>
          <p:spPr>
            <a:xfrm rot="16200000">
              <a:off x="-333006" y="2366852"/>
              <a:ext cx="2026092" cy="5210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BS</a:t>
              </a:r>
              <a:endPara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082CA44-4BFA-6404-86F1-A0DD7E996A3B}"/>
                </a:ext>
              </a:extLst>
            </p:cNvPr>
            <p:cNvSpPr txBox="1"/>
            <p:nvPr/>
          </p:nvSpPr>
          <p:spPr>
            <a:xfrm rot="16200000">
              <a:off x="-333006" y="4473329"/>
              <a:ext cx="2026092" cy="5210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4hrs LPDS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A9C2B9A-A8B8-D081-AA83-8B6184D70470}"/>
                </a:ext>
              </a:extLst>
            </p:cNvPr>
            <p:cNvSpPr txBox="1"/>
            <p:nvPr/>
          </p:nvSpPr>
          <p:spPr>
            <a:xfrm rot="16200000">
              <a:off x="-333006" y="6727368"/>
              <a:ext cx="2026092" cy="5210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8hrs LPDS</a:t>
              </a:r>
            </a:p>
          </p:txBody>
        </p:sp>
      </p:grpSp>
      <p:pic>
        <p:nvPicPr>
          <p:cNvPr id="52" name="Picture 51">
            <a:extLst>
              <a:ext uri="{FF2B5EF4-FFF2-40B4-BE49-F238E27FC236}">
                <a16:creationId xmlns:a16="http://schemas.microsoft.com/office/drawing/2014/main" id="{C1A8C5B6-7576-FACB-7BF0-A5C7E3CFC628}"/>
              </a:ext>
            </a:extLst>
          </p:cNvPr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7802"/>
          <a:stretch/>
        </p:blipFill>
        <p:spPr>
          <a:xfrm>
            <a:off x="4226500" y="4614832"/>
            <a:ext cx="2471738" cy="3160143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E651C0B0-433B-80FB-BD31-D0FB919BBC8A}"/>
              </a:ext>
            </a:extLst>
          </p:cNvPr>
          <p:cNvPicPr>
            <a:picLocks noChangeAspect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490"/>
          <a:stretch/>
        </p:blipFill>
        <p:spPr>
          <a:xfrm>
            <a:off x="3124341" y="4739591"/>
            <a:ext cx="1147611" cy="2166471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BFC2911D-FCAE-B52C-4D5B-9BD322C6C667}"/>
              </a:ext>
            </a:extLst>
          </p:cNvPr>
          <p:cNvSpPr txBox="1"/>
          <p:nvPr/>
        </p:nvSpPr>
        <p:spPr>
          <a:xfrm>
            <a:off x="4397343" y="4721121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7138BFC-3283-1DBA-872A-ACC4467F1D7C}"/>
              </a:ext>
            </a:extLst>
          </p:cNvPr>
          <p:cNvSpPr txBox="1"/>
          <p:nvPr/>
        </p:nvSpPr>
        <p:spPr>
          <a:xfrm>
            <a:off x="3164686" y="7848127"/>
            <a:ext cx="353355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kern="0" dirty="0">
                <a:effectLst/>
                <a:ea typeface="Times New Roman" panose="02020603050405020304" pitchFamily="18" charset="0"/>
              </a:rPr>
              <a:t>Supplemental Figure S4. 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NPC1 patient-derived </a:t>
            </a:r>
            <a:r>
              <a:rPr lang="en-GB" sz="1200" kern="0" dirty="0">
                <a:ea typeface="Times New Roman" panose="02020603050405020304" pitchFamily="18" charset="0"/>
              </a:rPr>
              <a:t>fibroblasts were treated with NALL for 72 hours or LPDS for 48 hours as indicated. </a:t>
            </a:r>
            <a:r>
              <a:rPr lang="en-GB" sz="1200" b="1" kern="0" dirty="0">
                <a:effectLst/>
                <a:ea typeface="Times New Roman" panose="02020603050405020304" pitchFamily="18" charset="0"/>
              </a:rPr>
              <a:t>A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)</a:t>
            </a:r>
            <a:r>
              <a:rPr lang="en-GB" sz="1200" dirty="0">
                <a:effectLst/>
              </a:rPr>
              <a:t> Representative images of </a:t>
            </a:r>
            <a:r>
              <a:rPr lang="en-GB" sz="1200" dirty="0" err="1">
                <a:effectLst/>
              </a:rPr>
              <a:t>mitochondria:LE</a:t>
            </a:r>
            <a:r>
              <a:rPr lang="en-GB" sz="1200" dirty="0">
                <a:effectLst/>
              </a:rPr>
              <a:t>/Lys PLA (green) and F-actin (magenta) and </a:t>
            </a:r>
            <a:r>
              <a:rPr lang="en-GB" sz="1200" kern="0" dirty="0">
                <a:effectLst/>
              </a:rPr>
              <a:t>q</a:t>
            </a:r>
            <a:r>
              <a:rPr lang="en-GB" sz="1200" kern="0" dirty="0">
                <a:ea typeface="Times New Roman" panose="02020603050405020304" pitchFamily="18" charset="0"/>
              </a:rPr>
              <a:t>uantitation of PLA spots per cell, normalised to controls.</a:t>
            </a:r>
            <a:r>
              <a:rPr lang="en-GB" sz="1200" dirty="0">
                <a:effectLst/>
              </a:rPr>
              <a:t> </a:t>
            </a:r>
            <a:r>
              <a:rPr lang="en-GB" sz="1200" kern="0" dirty="0">
                <a:ea typeface="Times New Roman" panose="02020603050405020304" pitchFamily="18" charset="0"/>
              </a:rPr>
              <a:t>Scale bar, 50</a:t>
            </a:r>
            <a:r>
              <a:rPr lang="en-GB" sz="1200" kern="0" dirty="0">
                <a:latin typeface="Symbol" pitchFamily="2" charset="2"/>
                <a:ea typeface="Times New Roman" panose="02020603050405020304" pitchFamily="18" charset="0"/>
              </a:rPr>
              <a:t>m</a:t>
            </a:r>
            <a:r>
              <a:rPr lang="en-GB" sz="1200" kern="0" dirty="0">
                <a:ea typeface="Times New Roman" panose="02020603050405020304" pitchFamily="18" charset="0"/>
              </a:rPr>
              <a:t>m. </a:t>
            </a:r>
            <a:endParaRPr lang="en-US" sz="12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F5FD3A0-887B-AF77-9C21-13534BBFF740}"/>
              </a:ext>
            </a:extLst>
          </p:cNvPr>
          <p:cNvSpPr txBox="1"/>
          <p:nvPr/>
        </p:nvSpPr>
        <p:spPr>
          <a:xfrm>
            <a:off x="435541" y="8951968"/>
            <a:ext cx="626269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kern="0" dirty="0">
                <a:ea typeface="Times New Roman" panose="02020603050405020304" pitchFamily="18" charset="0"/>
              </a:rPr>
              <a:t>B</a:t>
            </a:r>
            <a:r>
              <a:rPr lang="en-GB" sz="1200" kern="0" dirty="0">
                <a:ea typeface="Times New Roman" panose="02020603050405020304" pitchFamily="18" charset="0"/>
              </a:rPr>
              <a:t>) Representative images and quantitation of filipin-stained cholesterol in NPC1 patient cells cultured in LPDS for the indicated times. </a:t>
            </a:r>
            <a:r>
              <a:rPr lang="en-GB" sz="1200" b="1" kern="0" dirty="0">
                <a:ea typeface="Times New Roman" panose="02020603050405020304" pitchFamily="18" charset="0"/>
              </a:rPr>
              <a:t>C</a:t>
            </a:r>
            <a:r>
              <a:rPr lang="en-GB" sz="1200" kern="0" dirty="0">
                <a:ea typeface="Times New Roman" panose="02020603050405020304" pitchFamily="18" charset="0"/>
              </a:rPr>
              <a:t>) Effect on filipin-stained cholesterol, of culturing different cell lines in LPDS for 48h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827590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ollage of images of cells&#10;&#10;Description automatically generated">
            <a:extLst>
              <a:ext uri="{FF2B5EF4-FFF2-40B4-BE49-F238E27FC236}">
                <a16:creationId xmlns:a16="http://schemas.microsoft.com/office/drawing/2014/main" id="{19297CF5-6A32-BABE-E714-3E0D11F1D59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4640" y="3524899"/>
            <a:ext cx="4701369" cy="2362159"/>
          </a:xfrm>
          <a:prstGeom prst="rect">
            <a:avLst/>
          </a:prstGeom>
        </p:spPr>
      </p:pic>
      <p:pic>
        <p:nvPicPr>
          <p:cNvPr id="3" name="Picture 2" descr="A collage of images of a cell&#10;&#10;Description automatically generated">
            <a:extLst>
              <a:ext uri="{FF2B5EF4-FFF2-40B4-BE49-F238E27FC236}">
                <a16:creationId xmlns:a16="http://schemas.microsoft.com/office/drawing/2014/main" id="{F24FB63C-0498-2711-CC29-4330541839F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07857" y="157735"/>
            <a:ext cx="2356953" cy="1513903"/>
          </a:xfrm>
          <a:prstGeom prst="rect">
            <a:avLst/>
          </a:prstGeom>
        </p:spPr>
      </p:pic>
      <p:pic>
        <p:nvPicPr>
          <p:cNvPr id="4" name="Picture 3" descr="A graph of different colored columns&#10;&#10;Description automatically generated with medium confidence">
            <a:extLst>
              <a:ext uri="{FF2B5EF4-FFF2-40B4-BE49-F238E27FC236}">
                <a16:creationId xmlns:a16="http://schemas.microsoft.com/office/drawing/2014/main" id="{57285E4D-EFC1-4224-5C8F-C2C99EB6CC0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781" t="7048" r="9012" b="4686"/>
          <a:stretch/>
        </p:blipFill>
        <p:spPr>
          <a:xfrm>
            <a:off x="4824250" y="3524899"/>
            <a:ext cx="1800449" cy="2591728"/>
          </a:xfrm>
          <a:prstGeom prst="rect">
            <a:avLst/>
          </a:prstGeom>
        </p:spPr>
      </p:pic>
      <p:pic>
        <p:nvPicPr>
          <p:cNvPr id="6" name="Picture 5" descr="A graph of different colored bars&#10;&#10;Description automatically generated">
            <a:extLst>
              <a:ext uri="{FF2B5EF4-FFF2-40B4-BE49-F238E27FC236}">
                <a16:creationId xmlns:a16="http://schemas.microsoft.com/office/drawing/2014/main" id="{58FB0F37-FFE1-B63D-60FA-74A4F6E193A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534" t="19823" r="10095" b="4992"/>
          <a:stretch/>
        </p:blipFill>
        <p:spPr>
          <a:xfrm>
            <a:off x="4416928" y="265641"/>
            <a:ext cx="2207771" cy="2591729"/>
          </a:xfrm>
          <a:prstGeom prst="rect">
            <a:avLst/>
          </a:prstGeom>
        </p:spPr>
      </p:pic>
      <p:pic>
        <p:nvPicPr>
          <p:cNvPr id="10" name="Picture 9" descr="A collage of images of a cell&#10;&#10;Description automatically generated">
            <a:extLst>
              <a:ext uri="{FF2B5EF4-FFF2-40B4-BE49-F238E27FC236}">
                <a16:creationId xmlns:a16="http://schemas.microsoft.com/office/drawing/2014/main" id="{033FEE91-93D2-01E3-B663-EA92B1CD656B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3301" y="157736"/>
            <a:ext cx="1774556" cy="151808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DE5BFBD-D452-6E1F-F97B-05D1748893BF}"/>
              </a:ext>
            </a:extLst>
          </p:cNvPr>
          <p:cNvSpPr txBox="1"/>
          <p:nvPr/>
        </p:nvSpPr>
        <p:spPr>
          <a:xfrm>
            <a:off x="84640" y="6151197"/>
            <a:ext cx="654005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kern="0" dirty="0">
                <a:effectLst/>
                <a:ea typeface="Times New Roman" panose="02020603050405020304" pitchFamily="18" charset="0"/>
              </a:rPr>
              <a:t>Supplemental Figure S4 (continued). 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Fibroblasts from healthy controls or NPC1 patients were transfected with </a:t>
            </a:r>
            <a:r>
              <a:rPr lang="en-GB" sz="1200" kern="0" dirty="0">
                <a:ea typeface="Times New Roman" panose="02020603050405020304" pitchFamily="18" charset="0"/>
              </a:rPr>
              <a:t>△ORD-ORP1L-GFP </a:t>
            </a:r>
            <a:r>
              <a:rPr lang="en-GB" sz="1200" b="1" kern="0" dirty="0">
                <a:ea typeface="Times New Roman" panose="02020603050405020304" pitchFamily="18" charset="0"/>
              </a:rPr>
              <a:t>D</a:t>
            </a:r>
            <a:r>
              <a:rPr lang="en-GB" sz="1200" kern="0" dirty="0">
                <a:ea typeface="Times New Roman" panose="02020603050405020304" pitchFamily="18" charset="0"/>
              </a:rPr>
              <a:t>) Representative TEM images of cells expressing △ORD-ORP1L-GFP, with ER false-coloured blue and quantitation of </a:t>
            </a:r>
            <a:r>
              <a:rPr lang="en-GB" sz="1200" kern="0" dirty="0" err="1">
                <a:ea typeface="Times New Roman" panose="02020603050405020304" pitchFamily="18" charset="0"/>
              </a:rPr>
              <a:t>mitochondria:LE</a:t>
            </a:r>
            <a:r>
              <a:rPr lang="en-GB" sz="1200" kern="0" dirty="0">
                <a:ea typeface="Times New Roman" panose="02020603050405020304" pitchFamily="18" charset="0"/>
              </a:rPr>
              <a:t>/Lys PLA spots/cell normalised to control. </a:t>
            </a:r>
            <a:r>
              <a:rPr lang="en-GB" sz="1200" b="1" kern="0" dirty="0">
                <a:ea typeface="Times New Roman" panose="02020603050405020304" pitchFamily="18" charset="0"/>
              </a:rPr>
              <a:t>E</a:t>
            </a:r>
            <a:r>
              <a:rPr lang="en-GB" sz="1200" kern="0" dirty="0">
                <a:ea typeface="Times New Roman" panose="02020603050405020304" pitchFamily="18" charset="0"/>
              </a:rPr>
              <a:t>) Representative images and quantitation of filipin-stained cholesterol in cells expressing △ORD-ORP1L-GFP. Scale bar, 50</a:t>
            </a:r>
            <a:r>
              <a:rPr lang="en-GB" sz="1200" kern="0" dirty="0">
                <a:latin typeface="Symbol" pitchFamily="2" charset="2"/>
                <a:ea typeface="Times New Roman" panose="02020603050405020304" pitchFamily="18" charset="0"/>
              </a:rPr>
              <a:t>m</a:t>
            </a:r>
            <a:r>
              <a:rPr lang="en-GB" sz="1200" kern="0" dirty="0">
                <a:ea typeface="Times New Roman" panose="02020603050405020304" pitchFamily="18" charset="0"/>
              </a:rPr>
              <a:t>m. </a:t>
            </a:r>
            <a:r>
              <a:rPr lang="en-US" sz="1200" dirty="0"/>
              <a:t>Data </a:t>
            </a:r>
            <a:r>
              <a:rPr lang="en-US" sz="1200" dirty="0" err="1"/>
              <a:t>analysed</a:t>
            </a:r>
            <a:r>
              <a:rPr lang="en-US" sz="1200" dirty="0"/>
              <a:t> by one-way ANOVA followed by Tukey’s multiple comparisons test comparing all groups (* p ≤ 0.05, ** p ≤ 0.01, *** p ≤ 0.001, ns = non-significant, n = 3).</a:t>
            </a:r>
          </a:p>
          <a:p>
            <a:pPr algn="just"/>
            <a:endParaRPr lang="en-US" sz="12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F1AC432-278A-6107-F946-ACC6090F1190}"/>
              </a:ext>
            </a:extLst>
          </p:cNvPr>
          <p:cNvSpPr txBox="1"/>
          <p:nvPr/>
        </p:nvSpPr>
        <p:spPr>
          <a:xfrm>
            <a:off x="84640" y="30804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74ABB6E-3A32-A5DE-1BA2-0A1B543BB2DA}"/>
              </a:ext>
            </a:extLst>
          </p:cNvPr>
          <p:cNvSpPr txBox="1"/>
          <p:nvPr/>
        </p:nvSpPr>
        <p:spPr>
          <a:xfrm>
            <a:off x="84640" y="3254027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.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9E452048-95C7-330F-BAB6-F0042D549D25}"/>
              </a:ext>
            </a:extLst>
          </p:cNvPr>
          <p:cNvGrpSpPr/>
          <p:nvPr/>
        </p:nvGrpSpPr>
        <p:grpSpPr>
          <a:xfrm>
            <a:off x="2008158" y="1672599"/>
            <a:ext cx="2343575" cy="1264159"/>
            <a:chOff x="2004960" y="1686507"/>
            <a:chExt cx="2343575" cy="126415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52360EF2-FAAB-7DEA-872F-320091A9613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004960" y="1686507"/>
              <a:ext cx="2343575" cy="1264159"/>
            </a:xfrm>
            <a:prstGeom prst="rect">
              <a:avLst/>
            </a:prstGeom>
          </p:spPr>
        </p:pic>
        <p:sp>
          <p:nvSpPr>
            <p:cNvPr id="13" name="Freeform: Shape 12">
              <a:extLst>
                <a:ext uri="{FF2B5EF4-FFF2-40B4-BE49-F238E27FC236}">
                  <a16:creationId xmlns:a16="http://schemas.microsoft.com/office/drawing/2014/main" id="{AB7A7583-E798-8325-3228-0C54DE9B9BAA}"/>
                </a:ext>
              </a:extLst>
            </p:cNvPr>
            <p:cNvSpPr/>
            <p:nvPr/>
          </p:nvSpPr>
          <p:spPr>
            <a:xfrm>
              <a:off x="3860006" y="2057400"/>
              <a:ext cx="488157" cy="238125"/>
            </a:xfrm>
            <a:custGeom>
              <a:avLst/>
              <a:gdLst>
                <a:gd name="connsiteX0" fmla="*/ 447675 w 488157"/>
                <a:gd name="connsiteY0" fmla="*/ 45244 h 238125"/>
                <a:gd name="connsiteX1" fmla="*/ 378619 w 488157"/>
                <a:gd name="connsiteY1" fmla="*/ 33338 h 238125"/>
                <a:gd name="connsiteX2" fmla="*/ 335757 w 488157"/>
                <a:gd name="connsiteY2" fmla="*/ 16669 h 238125"/>
                <a:gd name="connsiteX3" fmla="*/ 285750 w 488157"/>
                <a:gd name="connsiteY3" fmla="*/ 0 h 238125"/>
                <a:gd name="connsiteX4" fmla="*/ 223838 w 488157"/>
                <a:gd name="connsiteY4" fmla="*/ 2381 h 238125"/>
                <a:gd name="connsiteX5" fmla="*/ 164307 w 488157"/>
                <a:gd name="connsiteY5" fmla="*/ 9525 h 238125"/>
                <a:gd name="connsiteX6" fmla="*/ 111919 w 488157"/>
                <a:gd name="connsiteY6" fmla="*/ 33338 h 238125"/>
                <a:gd name="connsiteX7" fmla="*/ 73819 w 488157"/>
                <a:gd name="connsiteY7" fmla="*/ 11906 h 238125"/>
                <a:gd name="connsiteX8" fmla="*/ 45244 w 488157"/>
                <a:gd name="connsiteY8" fmla="*/ 2381 h 238125"/>
                <a:gd name="connsiteX9" fmla="*/ 30957 w 488157"/>
                <a:gd name="connsiteY9" fmla="*/ 33338 h 238125"/>
                <a:gd name="connsiteX10" fmla="*/ 42863 w 488157"/>
                <a:gd name="connsiteY10" fmla="*/ 97631 h 238125"/>
                <a:gd name="connsiteX11" fmla="*/ 9525 w 488157"/>
                <a:gd name="connsiteY11" fmla="*/ 140494 h 238125"/>
                <a:gd name="connsiteX12" fmla="*/ 0 w 488157"/>
                <a:gd name="connsiteY12" fmla="*/ 207169 h 238125"/>
                <a:gd name="connsiteX13" fmla="*/ 57150 w 488157"/>
                <a:gd name="connsiteY13" fmla="*/ 190500 h 238125"/>
                <a:gd name="connsiteX14" fmla="*/ 78582 w 488157"/>
                <a:gd name="connsiteY14" fmla="*/ 169069 h 238125"/>
                <a:gd name="connsiteX15" fmla="*/ 88107 w 488157"/>
                <a:gd name="connsiteY15" fmla="*/ 138113 h 238125"/>
                <a:gd name="connsiteX16" fmla="*/ 107157 w 488157"/>
                <a:gd name="connsiteY16" fmla="*/ 114300 h 238125"/>
                <a:gd name="connsiteX17" fmla="*/ 142875 w 488157"/>
                <a:gd name="connsiteY17" fmla="*/ 104775 h 238125"/>
                <a:gd name="connsiteX18" fmla="*/ 197644 w 488157"/>
                <a:gd name="connsiteY18" fmla="*/ 92869 h 238125"/>
                <a:gd name="connsiteX19" fmla="*/ 238125 w 488157"/>
                <a:gd name="connsiteY19" fmla="*/ 97631 h 238125"/>
                <a:gd name="connsiteX20" fmla="*/ 254794 w 488157"/>
                <a:gd name="connsiteY20" fmla="*/ 119063 h 238125"/>
                <a:gd name="connsiteX21" fmla="*/ 269082 w 488157"/>
                <a:gd name="connsiteY21" fmla="*/ 150019 h 238125"/>
                <a:gd name="connsiteX22" fmla="*/ 254794 w 488157"/>
                <a:gd name="connsiteY22" fmla="*/ 185738 h 238125"/>
                <a:gd name="connsiteX23" fmla="*/ 247650 w 488157"/>
                <a:gd name="connsiteY23" fmla="*/ 211931 h 238125"/>
                <a:gd name="connsiteX24" fmla="*/ 269082 w 488157"/>
                <a:gd name="connsiteY24" fmla="*/ 238125 h 238125"/>
                <a:gd name="connsiteX25" fmla="*/ 292894 w 488157"/>
                <a:gd name="connsiteY25" fmla="*/ 221456 h 238125"/>
                <a:gd name="connsiteX26" fmla="*/ 321469 w 488157"/>
                <a:gd name="connsiteY26" fmla="*/ 207169 h 238125"/>
                <a:gd name="connsiteX27" fmla="*/ 328613 w 488157"/>
                <a:gd name="connsiteY27" fmla="*/ 183356 h 238125"/>
                <a:gd name="connsiteX28" fmla="*/ 338138 w 488157"/>
                <a:gd name="connsiteY28" fmla="*/ 140494 h 238125"/>
                <a:gd name="connsiteX29" fmla="*/ 350044 w 488157"/>
                <a:gd name="connsiteY29" fmla="*/ 119063 h 238125"/>
                <a:gd name="connsiteX30" fmla="*/ 376238 w 488157"/>
                <a:gd name="connsiteY30" fmla="*/ 114300 h 238125"/>
                <a:gd name="connsiteX31" fmla="*/ 376238 w 488157"/>
                <a:gd name="connsiteY31" fmla="*/ 114300 h 238125"/>
                <a:gd name="connsiteX32" fmla="*/ 423863 w 488157"/>
                <a:gd name="connsiteY32" fmla="*/ 111919 h 238125"/>
                <a:gd name="connsiteX33" fmla="*/ 461963 w 488157"/>
                <a:gd name="connsiteY33" fmla="*/ 111919 h 238125"/>
                <a:gd name="connsiteX34" fmla="*/ 488157 w 488157"/>
                <a:gd name="connsiteY34" fmla="*/ 107156 h 238125"/>
                <a:gd name="connsiteX35" fmla="*/ 447675 w 488157"/>
                <a:gd name="connsiteY35" fmla="*/ 45244 h 2381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</a:cxnLst>
              <a:rect l="l" t="t" r="r" b="b"/>
              <a:pathLst>
                <a:path w="488157" h="238125">
                  <a:moveTo>
                    <a:pt x="447675" y="45244"/>
                  </a:moveTo>
                  <a:lnTo>
                    <a:pt x="378619" y="33338"/>
                  </a:lnTo>
                  <a:lnTo>
                    <a:pt x="335757" y="16669"/>
                  </a:lnTo>
                  <a:lnTo>
                    <a:pt x="285750" y="0"/>
                  </a:lnTo>
                  <a:lnTo>
                    <a:pt x="223838" y="2381"/>
                  </a:lnTo>
                  <a:lnTo>
                    <a:pt x="164307" y="9525"/>
                  </a:lnTo>
                  <a:lnTo>
                    <a:pt x="111919" y="33338"/>
                  </a:lnTo>
                  <a:lnTo>
                    <a:pt x="73819" y="11906"/>
                  </a:lnTo>
                  <a:lnTo>
                    <a:pt x="45244" y="2381"/>
                  </a:lnTo>
                  <a:lnTo>
                    <a:pt x="30957" y="33338"/>
                  </a:lnTo>
                  <a:lnTo>
                    <a:pt x="42863" y="97631"/>
                  </a:lnTo>
                  <a:lnTo>
                    <a:pt x="9525" y="140494"/>
                  </a:lnTo>
                  <a:lnTo>
                    <a:pt x="0" y="207169"/>
                  </a:lnTo>
                  <a:lnTo>
                    <a:pt x="57150" y="190500"/>
                  </a:lnTo>
                  <a:lnTo>
                    <a:pt x="78582" y="169069"/>
                  </a:lnTo>
                  <a:lnTo>
                    <a:pt x="88107" y="138113"/>
                  </a:lnTo>
                  <a:lnTo>
                    <a:pt x="107157" y="114300"/>
                  </a:lnTo>
                  <a:lnTo>
                    <a:pt x="142875" y="104775"/>
                  </a:lnTo>
                  <a:lnTo>
                    <a:pt x="197644" y="92869"/>
                  </a:lnTo>
                  <a:lnTo>
                    <a:pt x="238125" y="97631"/>
                  </a:lnTo>
                  <a:lnTo>
                    <a:pt x="254794" y="119063"/>
                  </a:lnTo>
                  <a:lnTo>
                    <a:pt x="269082" y="150019"/>
                  </a:lnTo>
                  <a:lnTo>
                    <a:pt x="254794" y="185738"/>
                  </a:lnTo>
                  <a:lnTo>
                    <a:pt x="247650" y="211931"/>
                  </a:lnTo>
                  <a:lnTo>
                    <a:pt x="269082" y="238125"/>
                  </a:lnTo>
                  <a:lnTo>
                    <a:pt x="292894" y="221456"/>
                  </a:lnTo>
                  <a:lnTo>
                    <a:pt x="321469" y="207169"/>
                  </a:lnTo>
                  <a:lnTo>
                    <a:pt x="328613" y="183356"/>
                  </a:lnTo>
                  <a:lnTo>
                    <a:pt x="338138" y="140494"/>
                  </a:lnTo>
                  <a:lnTo>
                    <a:pt x="350044" y="119063"/>
                  </a:lnTo>
                  <a:lnTo>
                    <a:pt x="376238" y="114300"/>
                  </a:lnTo>
                  <a:lnTo>
                    <a:pt x="376238" y="114300"/>
                  </a:lnTo>
                  <a:lnTo>
                    <a:pt x="423863" y="111919"/>
                  </a:lnTo>
                  <a:lnTo>
                    <a:pt x="461963" y="111919"/>
                  </a:lnTo>
                  <a:lnTo>
                    <a:pt x="488157" y="107156"/>
                  </a:lnTo>
                  <a:lnTo>
                    <a:pt x="447675" y="45244"/>
                  </a:lnTo>
                  <a:close/>
                </a:path>
              </a:pathLst>
            </a:custGeom>
            <a:solidFill>
              <a:srgbClr val="00B0F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Freeform: Shape 13">
              <a:extLst>
                <a:ext uri="{FF2B5EF4-FFF2-40B4-BE49-F238E27FC236}">
                  <a16:creationId xmlns:a16="http://schemas.microsoft.com/office/drawing/2014/main" id="{666C8ADC-88FD-3C45-AA5A-B6DFD376AF25}"/>
                </a:ext>
              </a:extLst>
            </p:cNvPr>
            <p:cNvSpPr/>
            <p:nvPr/>
          </p:nvSpPr>
          <p:spPr>
            <a:xfrm>
              <a:off x="3157538" y="1952625"/>
              <a:ext cx="269081" cy="304800"/>
            </a:xfrm>
            <a:custGeom>
              <a:avLst/>
              <a:gdLst>
                <a:gd name="connsiteX0" fmla="*/ 252412 w 269081"/>
                <a:gd name="connsiteY0" fmla="*/ 40481 h 304800"/>
                <a:gd name="connsiteX1" fmla="*/ 219075 w 269081"/>
                <a:gd name="connsiteY1" fmla="*/ 0 h 304800"/>
                <a:gd name="connsiteX2" fmla="*/ 192881 w 269081"/>
                <a:gd name="connsiteY2" fmla="*/ 19050 h 304800"/>
                <a:gd name="connsiteX3" fmla="*/ 166687 w 269081"/>
                <a:gd name="connsiteY3" fmla="*/ 28575 h 304800"/>
                <a:gd name="connsiteX4" fmla="*/ 142875 w 269081"/>
                <a:gd name="connsiteY4" fmla="*/ 30956 h 304800"/>
                <a:gd name="connsiteX5" fmla="*/ 142875 w 269081"/>
                <a:gd name="connsiteY5" fmla="*/ 85725 h 304800"/>
                <a:gd name="connsiteX6" fmla="*/ 152400 w 269081"/>
                <a:gd name="connsiteY6" fmla="*/ 123825 h 304800"/>
                <a:gd name="connsiteX7" fmla="*/ 133350 w 269081"/>
                <a:gd name="connsiteY7" fmla="*/ 135731 h 304800"/>
                <a:gd name="connsiteX8" fmla="*/ 100012 w 269081"/>
                <a:gd name="connsiteY8" fmla="*/ 159544 h 304800"/>
                <a:gd name="connsiteX9" fmla="*/ 76200 w 269081"/>
                <a:gd name="connsiteY9" fmla="*/ 185738 h 304800"/>
                <a:gd name="connsiteX10" fmla="*/ 52387 w 269081"/>
                <a:gd name="connsiteY10" fmla="*/ 202406 h 304800"/>
                <a:gd name="connsiteX11" fmla="*/ 42862 w 269081"/>
                <a:gd name="connsiteY11" fmla="*/ 226219 h 304800"/>
                <a:gd name="connsiteX12" fmla="*/ 21431 w 269081"/>
                <a:gd name="connsiteY12" fmla="*/ 247650 h 304800"/>
                <a:gd name="connsiteX13" fmla="*/ 0 w 269081"/>
                <a:gd name="connsiteY13" fmla="*/ 278606 h 304800"/>
                <a:gd name="connsiteX14" fmla="*/ 11906 w 269081"/>
                <a:gd name="connsiteY14" fmla="*/ 304800 h 304800"/>
                <a:gd name="connsiteX15" fmla="*/ 59531 w 269081"/>
                <a:gd name="connsiteY15" fmla="*/ 276225 h 304800"/>
                <a:gd name="connsiteX16" fmla="*/ 92868 w 269081"/>
                <a:gd name="connsiteY16" fmla="*/ 247650 h 304800"/>
                <a:gd name="connsiteX17" fmla="*/ 119062 w 269081"/>
                <a:gd name="connsiteY17" fmla="*/ 211931 h 304800"/>
                <a:gd name="connsiteX18" fmla="*/ 140493 w 269081"/>
                <a:gd name="connsiteY18" fmla="*/ 185738 h 304800"/>
                <a:gd name="connsiteX19" fmla="*/ 190500 w 269081"/>
                <a:gd name="connsiteY19" fmla="*/ 164306 h 304800"/>
                <a:gd name="connsiteX20" fmla="*/ 230981 w 269081"/>
                <a:gd name="connsiteY20" fmla="*/ 171450 h 304800"/>
                <a:gd name="connsiteX21" fmla="*/ 259556 w 269081"/>
                <a:gd name="connsiteY21" fmla="*/ 159544 h 304800"/>
                <a:gd name="connsiteX22" fmla="*/ 269081 w 269081"/>
                <a:gd name="connsiteY22" fmla="*/ 128588 h 304800"/>
                <a:gd name="connsiteX23" fmla="*/ 266700 w 269081"/>
                <a:gd name="connsiteY23" fmla="*/ 100013 h 304800"/>
                <a:gd name="connsiteX24" fmla="*/ 252412 w 269081"/>
                <a:gd name="connsiteY24" fmla="*/ 40481 h 304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269081" h="304800">
                  <a:moveTo>
                    <a:pt x="252412" y="40481"/>
                  </a:moveTo>
                  <a:lnTo>
                    <a:pt x="219075" y="0"/>
                  </a:lnTo>
                  <a:lnTo>
                    <a:pt x="192881" y="19050"/>
                  </a:lnTo>
                  <a:lnTo>
                    <a:pt x="166687" y="28575"/>
                  </a:lnTo>
                  <a:lnTo>
                    <a:pt x="142875" y="30956"/>
                  </a:lnTo>
                  <a:lnTo>
                    <a:pt x="142875" y="85725"/>
                  </a:lnTo>
                  <a:lnTo>
                    <a:pt x="152400" y="123825"/>
                  </a:lnTo>
                  <a:lnTo>
                    <a:pt x="133350" y="135731"/>
                  </a:lnTo>
                  <a:lnTo>
                    <a:pt x="100012" y="159544"/>
                  </a:lnTo>
                  <a:lnTo>
                    <a:pt x="76200" y="185738"/>
                  </a:lnTo>
                  <a:lnTo>
                    <a:pt x="52387" y="202406"/>
                  </a:lnTo>
                  <a:lnTo>
                    <a:pt x="42862" y="226219"/>
                  </a:lnTo>
                  <a:lnTo>
                    <a:pt x="21431" y="247650"/>
                  </a:lnTo>
                  <a:lnTo>
                    <a:pt x="0" y="278606"/>
                  </a:lnTo>
                  <a:lnTo>
                    <a:pt x="11906" y="304800"/>
                  </a:lnTo>
                  <a:lnTo>
                    <a:pt x="59531" y="276225"/>
                  </a:lnTo>
                  <a:lnTo>
                    <a:pt x="92868" y="247650"/>
                  </a:lnTo>
                  <a:lnTo>
                    <a:pt x="119062" y="211931"/>
                  </a:lnTo>
                  <a:lnTo>
                    <a:pt x="140493" y="185738"/>
                  </a:lnTo>
                  <a:lnTo>
                    <a:pt x="190500" y="164306"/>
                  </a:lnTo>
                  <a:lnTo>
                    <a:pt x="230981" y="171450"/>
                  </a:lnTo>
                  <a:lnTo>
                    <a:pt x="259556" y="159544"/>
                  </a:lnTo>
                  <a:lnTo>
                    <a:pt x="269081" y="128588"/>
                  </a:lnTo>
                  <a:lnTo>
                    <a:pt x="266700" y="100013"/>
                  </a:lnTo>
                  <a:lnTo>
                    <a:pt x="252412" y="40481"/>
                  </a:lnTo>
                  <a:close/>
                </a:path>
              </a:pathLst>
            </a:custGeom>
            <a:solidFill>
              <a:srgbClr val="00B0F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Freeform: Shape 14">
              <a:extLst>
                <a:ext uri="{FF2B5EF4-FFF2-40B4-BE49-F238E27FC236}">
                  <a16:creationId xmlns:a16="http://schemas.microsoft.com/office/drawing/2014/main" id="{2C006D9A-599E-66C3-3399-85C772849275}"/>
                </a:ext>
              </a:extLst>
            </p:cNvPr>
            <p:cNvSpPr/>
            <p:nvPr/>
          </p:nvSpPr>
          <p:spPr>
            <a:xfrm>
              <a:off x="2800350" y="2640806"/>
              <a:ext cx="633413" cy="209550"/>
            </a:xfrm>
            <a:custGeom>
              <a:avLst/>
              <a:gdLst>
                <a:gd name="connsiteX0" fmla="*/ 633413 w 633413"/>
                <a:gd name="connsiteY0" fmla="*/ 157163 h 209550"/>
                <a:gd name="connsiteX1" fmla="*/ 602456 w 633413"/>
                <a:gd name="connsiteY1" fmla="*/ 130969 h 209550"/>
                <a:gd name="connsiteX2" fmla="*/ 526256 w 633413"/>
                <a:gd name="connsiteY2" fmla="*/ 133350 h 209550"/>
                <a:gd name="connsiteX3" fmla="*/ 488156 w 633413"/>
                <a:gd name="connsiteY3" fmla="*/ 135732 h 209550"/>
                <a:gd name="connsiteX4" fmla="*/ 438150 w 633413"/>
                <a:gd name="connsiteY4" fmla="*/ 142875 h 209550"/>
                <a:gd name="connsiteX5" fmla="*/ 404813 w 633413"/>
                <a:gd name="connsiteY5" fmla="*/ 142875 h 209550"/>
                <a:gd name="connsiteX6" fmla="*/ 364331 w 633413"/>
                <a:gd name="connsiteY6" fmla="*/ 142875 h 209550"/>
                <a:gd name="connsiteX7" fmla="*/ 330994 w 633413"/>
                <a:gd name="connsiteY7" fmla="*/ 142875 h 209550"/>
                <a:gd name="connsiteX8" fmla="*/ 276225 w 633413"/>
                <a:gd name="connsiteY8" fmla="*/ 126207 h 209550"/>
                <a:gd name="connsiteX9" fmla="*/ 245269 w 633413"/>
                <a:gd name="connsiteY9" fmla="*/ 128588 h 209550"/>
                <a:gd name="connsiteX10" fmla="*/ 209550 w 633413"/>
                <a:gd name="connsiteY10" fmla="*/ 140494 h 209550"/>
                <a:gd name="connsiteX11" fmla="*/ 166688 w 633413"/>
                <a:gd name="connsiteY11" fmla="*/ 135732 h 209550"/>
                <a:gd name="connsiteX12" fmla="*/ 135731 w 633413"/>
                <a:gd name="connsiteY12" fmla="*/ 126207 h 209550"/>
                <a:gd name="connsiteX13" fmla="*/ 157163 w 633413"/>
                <a:gd name="connsiteY13" fmla="*/ 90488 h 209550"/>
                <a:gd name="connsiteX14" fmla="*/ 169069 w 633413"/>
                <a:gd name="connsiteY14" fmla="*/ 66675 h 209550"/>
                <a:gd name="connsiteX15" fmla="*/ 150019 w 633413"/>
                <a:gd name="connsiteY15" fmla="*/ 28575 h 209550"/>
                <a:gd name="connsiteX16" fmla="*/ 109538 w 633413"/>
                <a:gd name="connsiteY16" fmla="*/ 0 h 209550"/>
                <a:gd name="connsiteX17" fmla="*/ 45244 w 633413"/>
                <a:gd name="connsiteY17" fmla="*/ 0 h 209550"/>
                <a:gd name="connsiteX18" fmla="*/ 38100 w 633413"/>
                <a:gd name="connsiteY18" fmla="*/ 33338 h 209550"/>
                <a:gd name="connsiteX19" fmla="*/ 64294 w 633413"/>
                <a:gd name="connsiteY19" fmla="*/ 78582 h 209550"/>
                <a:gd name="connsiteX20" fmla="*/ 64294 w 633413"/>
                <a:gd name="connsiteY20" fmla="*/ 107157 h 209550"/>
                <a:gd name="connsiteX21" fmla="*/ 33338 w 633413"/>
                <a:gd name="connsiteY21" fmla="*/ 133350 h 209550"/>
                <a:gd name="connsiteX22" fmla="*/ 4763 w 633413"/>
                <a:gd name="connsiteY22" fmla="*/ 169069 h 209550"/>
                <a:gd name="connsiteX23" fmla="*/ 0 w 633413"/>
                <a:gd name="connsiteY23" fmla="*/ 209550 h 209550"/>
                <a:gd name="connsiteX24" fmla="*/ 121444 w 633413"/>
                <a:gd name="connsiteY24" fmla="*/ 202407 h 209550"/>
                <a:gd name="connsiteX25" fmla="*/ 140494 w 633413"/>
                <a:gd name="connsiteY25" fmla="*/ 180975 h 209550"/>
                <a:gd name="connsiteX26" fmla="*/ 180975 w 633413"/>
                <a:gd name="connsiteY26" fmla="*/ 180975 h 209550"/>
                <a:gd name="connsiteX27" fmla="*/ 216694 w 633413"/>
                <a:gd name="connsiteY27" fmla="*/ 176213 h 209550"/>
                <a:gd name="connsiteX28" fmla="*/ 271463 w 633413"/>
                <a:gd name="connsiteY28" fmla="*/ 171450 h 209550"/>
                <a:gd name="connsiteX29" fmla="*/ 357188 w 633413"/>
                <a:gd name="connsiteY29" fmla="*/ 178594 h 209550"/>
                <a:gd name="connsiteX30" fmla="*/ 419100 w 633413"/>
                <a:gd name="connsiteY30" fmla="*/ 171450 h 209550"/>
                <a:gd name="connsiteX31" fmla="*/ 445294 w 633413"/>
                <a:gd name="connsiteY31" fmla="*/ 171450 h 209550"/>
                <a:gd name="connsiteX32" fmla="*/ 481013 w 633413"/>
                <a:gd name="connsiteY32" fmla="*/ 183357 h 209550"/>
                <a:gd name="connsiteX33" fmla="*/ 531019 w 633413"/>
                <a:gd name="connsiteY33" fmla="*/ 195263 h 209550"/>
                <a:gd name="connsiteX34" fmla="*/ 554831 w 633413"/>
                <a:gd name="connsiteY34" fmla="*/ 195263 h 209550"/>
                <a:gd name="connsiteX35" fmla="*/ 633413 w 633413"/>
                <a:gd name="connsiteY35" fmla="*/ 157163 h 2095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</a:cxnLst>
              <a:rect l="l" t="t" r="r" b="b"/>
              <a:pathLst>
                <a:path w="633413" h="209550">
                  <a:moveTo>
                    <a:pt x="633413" y="157163"/>
                  </a:moveTo>
                  <a:lnTo>
                    <a:pt x="602456" y="130969"/>
                  </a:lnTo>
                  <a:lnTo>
                    <a:pt x="526256" y="133350"/>
                  </a:lnTo>
                  <a:lnTo>
                    <a:pt x="488156" y="135732"/>
                  </a:lnTo>
                  <a:lnTo>
                    <a:pt x="438150" y="142875"/>
                  </a:lnTo>
                  <a:lnTo>
                    <a:pt x="404813" y="142875"/>
                  </a:lnTo>
                  <a:lnTo>
                    <a:pt x="364331" y="142875"/>
                  </a:lnTo>
                  <a:lnTo>
                    <a:pt x="330994" y="142875"/>
                  </a:lnTo>
                  <a:lnTo>
                    <a:pt x="276225" y="126207"/>
                  </a:lnTo>
                  <a:lnTo>
                    <a:pt x="245269" y="128588"/>
                  </a:lnTo>
                  <a:lnTo>
                    <a:pt x="209550" y="140494"/>
                  </a:lnTo>
                  <a:lnTo>
                    <a:pt x="166688" y="135732"/>
                  </a:lnTo>
                  <a:lnTo>
                    <a:pt x="135731" y="126207"/>
                  </a:lnTo>
                  <a:lnTo>
                    <a:pt x="157163" y="90488"/>
                  </a:lnTo>
                  <a:lnTo>
                    <a:pt x="169069" y="66675"/>
                  </a:lnTo>
                  <a:lnTo>
                    <a:pt x="150019" y="28575"/>
                  </a:lnTo>
                  <a:lnTo>
                    <a:pt x="109538" y="0"/>
                  </a:lnTo>
                  <a:lnTo>
                    <a:pt x="45244" y="0"/>
                  </a:lnTo>
                  <a:lnTo>
                    <a:pt x="38100" y="33338"/>
                  </a:lnTo>
                  <a:lnTo>
                    <a:pt x="64294" y="78582"/>
                  </a:lnTo>
                  <a:lnTo>
                    <a:pt x="64294" y="107157"/>
                  </a:lnTo>
                  <a:lnTo>
                    <a:pt x="33338" y="133350"/>
                  </a:lnTo>
                  <a:lnTo>
                    <a:pt x="4763" y="169069"/>
                  </a:lnTo>
                  <a:lnTo>
                    <a:pt x="0" y="209550"/>
                  </a:lnTo>
                  <a:lnTo>
                    <a:pt x="121444" y="202407"/>
                  </a:lnTo>
                  <a:lnTo>
                    <a:pt x="140494" y="180975"/>
                  </a:lnTo>
                  <a:lnTo>
                    <a:pt x="180975" y="180975"/>
                  </a:lnTo>
                  <a:lnTo>
                    <a:pt x="216694" y="176213"/>
                  </a:lnTo>
                  <a:lnTo>
                    <a:pt x="271463" y="171450"/>
                  </a:lnTo>
                  <a:lnTo>
                    <a:pt x="357188" y="178594"/>
                  </a:lnTo>
                  <a:lnTo>
                    <a:pt x="419100" y="171450"/>
                  </a:lnTo>
                  <a:lnTo>
                    <a:pt x="445294" y="171450"/>
                  </a:lnTo>
                  <a:lnTo>
                    <a:pt x="481013" y="183357"/>
                  </a:lnTo>
                  <a:lnTo>
                    <a:pt x="531019" y="195263"/>
                  </a:lnTo>
                  <a:lnTo>
                    <a:pt x="554831" y="195263"/>
                  </a:lnTo>
                  <a:lnTo>
                    <a:pt x="633413" y="157163"/>
                  </a:lnTo>
                  <a:close/>
                </a:path>
              </a:pathLst>
            </a:custGeom>
            <a:solidFill>
              <a:srgbClr val="00B0F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Freeform: Shape 16">
              <a:extLst>
                <a:ext uri="{FF2B5EF4-FFF2-40B4-BE49-F238E27FC236}">
                  <a16:creationId xmlns:a16="http://schemas.microsoft.com/office/drawing/2014/main" id="{C27BB265-9D7A-DF1A-1F01-5A181F97112D}"/>
                </a:ext>
              </a:extLst>
            </p:cNvPr>
            <p:cNvSpPr/>
            <p:nvPr/>
          </p:nvSpPr>
          <p:spPr>
            <a:xfrm>
              <a:off x="2014538" y="2197894"/>
              <a:ext cx="276225" cy="469106"/>
            </a:xfrm>
            <a:custGeom>
              <a:avLst/>
              <a:gdLst>
                <a:gd name="connsiteX0" fmla="*/ 0 w 276225"/>
                <a:gd name="connsiteY0" fmla="*/ 161925 h 469106"/>
                <a:gd name="connsiteX1" fmla="*/ 47625 w 276225"/>
                <a:gd name="connsiteY1" fmla="*/ 138112 h 469106"/>
                <a:gd name="connsiteX2" fmla="*/ 109537 w 276225"/>
                <a:gd name="connsiteY2" fmla="*/ 183356 h 469106"/>
                <a:gd name="connsiteX3" fmla="*/ 119062 w 276225"/>
                <a:gd name="connsiteY3" fmla="*/ 228600 h 469106"/>
                <a:gd name="connsiteX4" fmla="*/ 126206 w 276225"/>
                <a:gd name="connsiteY4" fmla="*/ 280987 h 469106"/>
                <a:gd name="connsiteX5" fmla="*/ 123825 w 276225"/>
                <a:gd name="connsiteY5" fmla="*/ 304800 h 469106"/>
                <a:gd name="connsiteX6" fmla="*/ 85725 w 276225"/>
                <a:gd name="connsiteY6" fmla="*/ 316706 h 469106"/>
                <a:gd name="connsiteX7" fmla="*/ 73818 w 276225"/>
                <a:gd name="connsiteY7" fmla="*/ 350044 h 469106"/>
                <a:gd name="connsiteX8" fmla="*/ 104775 w 276225"/>
                <a:gd name="connsiteY8" fmla="*/ 392906 h 469106"/>
                <a:gd name="connsiteX9" fmla="*/ 121443 w 276225"/>
                <a:gd name="connsiteY9" fmla="*/ 404812 h 469106"/>
                <a:gd name="connsiteX10" fmla="*/ 140493 w 276225"/>
                <a:gd name="connsiteY10" fmla="*/ 433387 h 469106"/>
                <a:gd name="connsiteX11" fmla="*/ 228600 w 276225"/>
                <a:gd name="connsiteY11" fmla="*/ 469106 h 469106"/>
                <a:gd name="connsiteX12" fmla="*/ 276225 w 276225"/>
                <a:gd name="connsiteY12" fmla="*/ 461962 h 469106"/>
                <a:gd name="connsiteX13" fmla="*/ 192881 w 276225"/>
                <a:gd name="connsiteY13" fmla="*/ 390525 h 469106"/>
                <a:gd name="connsiteX14" fmla="*/ 164306 w 276225"/>
                <a:gd name="connsiteY14" fmla="*/ 292894 h 469106"/>
                <a:gd name="connsiteX15" fmla="*/ 159543 w 276225"/>
                <a:gd name="connsiteY15" fmla="*/ 223837 h 469106"/>
                <a:gd name="connsiteX16" fmla="*/ 128587 w 276225"/>
                <a:gd name="connsiteY16" fmla="*/ 123825 h 469106"/>
                <a:gd name="connsiteX17" fmla="*/ 180975 w 276225"/>
                <a:gd name="connsiteY17" fmla="*/ 33337 h 469106"/>
                <a:gd name="connsiteX18" fmla="*/ 188118 w 276225"/>
                <a:gd name="connsiteY18" fmla="*/ 2381 h 469106"/>
                <a:gd name="connsiteX19" fmla="*/ 152400 w 276225"/>
                <a:gd name="connsiteY19" fmla="*/ 0 h 469106"/>
                <a:gd name="connsiteX20" fmla="*/ 140493 w 276225"/>
                <a:gd name="connsiteY20" fmla="*/ 16669 h 469106"/>
                <a:gd name="connsiteX21" fmla="*/ 102393 w 276225"/>
                <a:gd name="connsiteY21" fmla="*/ 61912 h 469106"/>
                <a:gd name="connsiteX22" fmla="*/ 88106 w 276225"/>
                <a:gd name="connsiteY22" fmla="*/ 85725 h 469106"/>
                <a:gd name="connsiteX23" fmla="*/ 45243 w 276225"/>
                <a:gd name="connsiteY23" fmla="*/ 104775 h 469106"/>
                <a:gd name="connsiteX24" fmla="*/ 0 w 276225"/>
                <a:gd name="connsiteY24" fmla="*/ 161925 h 46910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276225" h="469106">
                  <a:moveTo>
                    <a:pt x="0" y="161925"/>
                  </a:moveTo>
                  <a:lnTo>
                    <a:pt x="47625" y="138112"/>
                  </a:lnTo>
                  <a:lnTo>
                    <a:pt x="109537" y="183356"/>
                  </a:lnTo>
                  <a:lnTo>
                    <a:pt x="119062" y="228600"/>
                  </a:lnTo>
                  <a:lnTo>
                    <a:pt x="126206" y="280987"/>
                  </a:lnTo>
                  <a:lnTo>
                    <a:pt x="123825" y="304800"/>
                  </a:lnTo>
                  <a:lnTo>
                    <a:pt x="85725" y="316706"/>
                  </a:lnTo>
                  <a:lnTo>
                    <a:pt x="73818" y="350044"/>
                  </a:lnTo>
                  <a:lnTo>
                    <a:pt x="104775" y="392906"/>
                  </a:lnTo>
                  <a:lnTo>
                    <a:pt x="121443" y="404812"/>
                  </a:lnTo>
                  <a:lnTo>
                    <a:pt x="140493" y="433387"/>
                  </a:lnTo>
                  <a:lnTo>
                    <a:pt x="228600" y="469106"/>
                  </a:lnTo>
                  <a:lnTo>
                    <a:pt x="276225" y="461962"/>
                  </a:lnTo>
                  <a:lnTo>
                    <a:pt x="192881" y="390525"/>
                  </a:lnTo>
                  <a:lnTo>
                    <a:pt x="164306" y="292894"/>
                  </a:lnTo>
                  <a:lnTo>
                    <a:pt x="159543" y="223837"/>
                  </a:lnTo>
                  <a:lnTo>
                    <a:pt x="128587" y="123825"/>
                  </a:lnTo>
                  <a:lnTo>
                    <a:pt x="180975" y="33337"/>
                  </a:lnTo>
                  <a:lnTo>
                    <a:pt x="188118" y="2381"/>
                  </a:lnTo>
                  <a:lnTo>
                    <a:pt x="152400" y="0"/>
                  </a:lnTo>
                  <a:lnTo>
                    <a:pt x="140493" y="16669"/>
                  </a:lnTo>
                  <a:lnTo>
                    <a:pt x="102393" y="61912"/>
                  </a:lnTo>
                  <a:lnTo>
                    <a:pt x="88106" y="85725"/>
                  </a:lnTo>
                  <a:lnTo>
                    <a:pt x="45243" y="104775"/>
                  </a:lnTo>
                  <a:lnTo>
                    <a:pt x="0" y="161925"/>
                  </a:lnTo>
                  <a:close/>
                </a:path>
              </a:pathLst>
            </a:custGeom>
            <a:solidFill>
              <a:srgbClr val="00B0F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Freeform: Shape 18">
              <a:extLst>
                <a:ext uri="{FF2B5EF4-FFF2-40B4-BE49-F238E27FC236}">
                  <a16:creationId xmlns:a16="http://schemas.microsoft.com/office/drawing/2014/main" id="{C11C4EA3-A81A-6991-A41B-14671E7F0D4B}"/>
                </a:ext>
              </a:extLst>
            </p:cNvPr>
            <p:cNvSpPr/>
            <p:nvPr/>
          </p:nvSpPr>
          <p:spPr>
            <a:xfrm>
              <a:off x="3926681" y="2390775"/>
              <a:ext cx="219075" cy="261938"/>
            </a:xfrm>
            <a:custGeom>
              <a:avLst/>
              <a:gdLst>
                <a:gd name="connsiteX0" fmla="*/ 0 w 219075"/>
                <a:gd name="connsiteY0" fmla="*/ 0 h 261938"/>
                <a:gd name="connsiteX1" fmla="*/ 16669 w 219075"/>
                <a:gd name="connsiteY1" fmla="*/ 90488 h 261938"/>
                <a:gd name="connsiteX2" fmla="*/ 38100 w 219075"/>
                <a:gd name="connsiteY2" fmla="*/ 138113 h 261938"/>
                <a:gd name="connsiteX3" fmla="*/ 90488 w 219075"/>
                <a:gd name="connsiteY3" fmla="*/ 185738 h 261938"/>
                <a:gd name="connsiteX4" fmla="*/ 152400 w 219075"/>
                <a:gd name="connsiteY4" fmla="*/ 226219 h 261938"/>
                <a:gd name="connsiteX5" fmla="*/ 219075 w 219075"/>
                <a:gd name="connsiteY5" fmla="*/ 261938 h 261938"/>
                <a:gd name="connsiteX6" fmla="*/ 171450 w 219075"/>
                <a:gd name="connsiteY6" fmla="*/ 207169 h 261938"/>
                <a:gd name="connsiteX7" fmla="*/ 133350 w 219075"/>
                <a:gd name="connsiteY7" fmla="*/ 154781 h 261938"/>
                <a:gd name="connsiteX8" fmla="*/ 69057 w 219075"/>
                <a:gd name="connsiteY8" fmla="*/ 95250 h 261938"/>
                <a:gd name="connsiteX9" fmla="*/ 0 w 219075"/>
                <a:gd name="connsiteY9" fmla="*/ 0 h 2619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219075" h="261938">
                  <a:moveTo>
                    <a:pt x="0" y="0"/>
                  </a:moveTo>
                  <a:lnTo>
                    <a:pt x="16669" y="90488"/>
                  </a:lnTo>
                  <a:lnTo>
                    <a:pt x="38100" y="138113"/>
                  </a:lnTo>
                  <a:lnTo>
                    <a:pt x="90488" y="185738"/>
                  </a:lnTo>
                  <a:lnTo>
                    <a:pt x="152400" y="226219"/>
                  </a:lnTo>
                  <a:lnTo>
                    <a:pt x="219075" y="261938"/>
                  </a:lnTo>
                  <a:lnTo>
                    <a:pt x="171450" y="207169"/>
                  </a:lnTo>
                  <a:lnTo>
                    <a:pt x="133350" y="154781"/>
                  </a:lnTo>
                  <a:lnTo>
                    <a:pt x="69057" y="9525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B0F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Freeform: Shape 20">
              <a:extLst>
                <a:ext uri="{FF2B5EF4-FFF2-40B4-BE49-F238E27FC236}">
                  <a16:creationId xmlns:a16="http://schemas.microsoft.com/office/drawing/2014/main" id="{7649E6FE-D1B6-7F62-41E1-5481B1844DAE}"/>
                </a:ext>
              </a:extLst>
            </p:cNvPr>
            <p:cNvSpPr/>
            <p:nvPr/>
          </p:nvSpPr>
          <p:spPr>
            <a:xfrm>
              <a:off x="3064669" y="2609850"/>
              <a:ext cx="321469" cy="152400"/>
            </a:xfrm>
            <a:custGeom>
              <a:avLst/>
              <a:gdLst>
                <a:gd name="connsiteX0" fmla="*/ 321469 w 321469"/>
                <a:gd name="connsiteY0" fmla="*/ 147638 h 152400"/>
                <a:gd name="connsiteX1" fmla="*/ 264319 w 321469"/>
                <a:gd name="connsiteY1" fmla="*/ 123825 h 152400"/>
                <a:gd name="connsiteX2" fmla="*/ 204787 w 321469"/>
                <a:gd name="connsiteY2" fmla="*/ 109538 h 152400"/>
                <a:gd name="connsiteX3" fmla="*/ 169069 w 321469"/>
                <a:gd name="connsiteY3" fmla="*/ 111919 h 152400"/>
                <a:gd name="connsiteX4" fmla="*/ 102394 w 321469"/>
                <a:gd name="connsiteY4" fmla="*/ 88106 h 152400"/>
                <a:gd name="connsiteX5" fmla="*/ 69056 w 321469"/>
                <a:gd name="connsiteY5" fmla="*/ 33338 h 152400"/>
                <a:gd name="connsiteX6" fmla="*/ 26194 w 321469"/>
                <a:gd name="connsiteY6" fmla="*/ 0 h 152400"/>
                <a:gd name="connsiteX7" fmla="*/ 0 w 321469"/>
                <a:gd name="connsiteY7" fmla="*/ 9525 h 152400"/>
                <a:gd name="connsiteX8" fmla="*/ 0 w 321469"/>
                <a:gd name="connsiteY8" fmla="*/ 52388 h 152400"/>
                <a:gd name="connsiteX9" fmla="*/ 9525 w 321469"/>
                <a:gd name="connsiteY9" fmla="*/ 73819 h 152400"/>
                <a:gd name="connsiteX10" fmla="*/ 21431 w 321469"/>
                <a:gd name="connsiteY10" fmla="*/ 100013 h 152400"/>
                <a:gd name="connsiteX11" fmla="*/ 45244 w 321469"/>
                <a:gd name="connsiteY11" fmla="*/ 104775 h 152400"/>
                <a:gd name="connsiteX12" fmla="*/ 76200 w 321469"/>
                <a:gd name="connsiteY12" fmla="*/ 111919 h 152400"/>
                <a:gd name="connsiteX13" fmla="*/ 128587 w 321469"/>
                <a:gd name="connsiteY13" fmla="*/ 123825 h 152400"/>
                <a:gd name="connsiteX14" fmla="*/ 173831 w 321469"/>
                <a:gd name="connsiteY14" fmla="*/ 152400 h 152400"/>
                <a:gd name="connsiteX15" fmla="*/ 233362 w 321469"/>
                <a:gd name="connsiteY15" fmla="*/ 150019 h 152400"/>
                <a:gd name="connsiteX16" fmla="*/ 321469 w 321469"/>
                <a:gd name="connsiteY16" fmla="*/ 147638 h 1524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321469" h="152400">
                  <a:moveTo>
                    <a:pt x="321469" y="147638"/>
                  </a:moveTo>
                  <a:lnTo>
                    <a:pt x="264319" y="123825"/>
                  </a:lnTo>
                  <a:lnTo>
                    <a:pt x="204787" y="109538"/>
                  </a:lnTo>
                  <a:lnTo>
                    <a:pt x="169069" y="111919"/>
                  </a:lnTo>
                  <a:lnTo>
                    <a:pt x="102394" y="88106"/>
                  </a:lnTo>
                  <a:lnTo>
                    <a:pt x="69056" y="33338"/>
                  </a:lnTo>
                  <a:lnTo>
                    <a:pt x="26194" y="0"/>
                  </a:lnTo>
                  <a:lnTo>
                    <a:pt x="0" y="9525"/>
                  </a:lnTo>
                  <a:lnTo>
                    <a:pt x="0" y="52388"/>
                  </a:lnTo>
                  <a:cubicBezTo>
                    <a:pt x="9880" y="72148"/>
                    <a:pt x="9525" y="64338"/>
                    <a:pt x="9525" y="73819"/>
                  </a:cubicBezTo>
                  <a:lnTo>
                    <a:pt x="21431" y="100013"/>
                  </a:lnTo>
                  <a:lnTo>
                    <a:pt x="45244" y="104775"/>
                  </a:lnTo>
                  <a:lnTo>
                    <a:pt x="76200" y="111919"/>
                  </a:lnTo>
                  <a:lnTo>
                    <a:pt x="128587" y="123825"/>
                  </a:lnTo>
                  <a:lnTo>
                    <a:pt x="173831" y="152400"/>
                  </a:lnTo>
                  <a:lnTo>
                    <a:pt x="233362" y="150019"/>
                  </a:lnTo>
                  <a:lnTo>
                    <a:pt x="321469" y="147638"/>
                  </a:lnTo>
                  <a:close/>
                </a:path>
              </a:pathLst>
            </a:custGeom>
            <a:solidFill>
              <a:srgbClr val="00B0F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Freeform: Shape 21">
              <a:extLst>
                <a:ext uri="{FF2B5EF4-FFF2-40B4-BE49-F238E27FC236}">
                  <a16:creationId xmlns:a16="http://schemas.microsoft.com/office/drawing/2014/main" id="{2760D168-ACDF-BABB-C91D-BD2D015B0BFB}"/>
                </a:ext>
              </a:extLst>
            </p:cNvPr>
            <p:cNvSpPr/>
            <p:nvPr/>
          </p:nvSpPr>
          <p:spPr>
            <a:xfrm>
              <a:off x="2128838" y="1814513"/>
              <a:ext cx="445293" cy="342900"/>
            </a:xfrm>
            <a:custGeom>
              <a:avLst/>
              <a:gdLst>
                <a:gd name="connsiteX0" fmla="*/ 445293 w 445293"/>
                <a:gd name="connsiteY0" fmla="*/ 69056 h 342900"/>
                <a:gd name="connsiteX1" fmla="*/ 409575 w 445293"/>
                <a:gd name="connsiteY1" fmla="*/ 23812 h 342900"/>
                <a:gd name="connsiteX2" fmla="*/ 354806 w 445293"/>
                <a:gd name="connsiteY2" fmla="*/ 0 h 342900"/>
                <a:gd name="connsiteX3" fmla="*/ 304800 w 445293"/>
                <a:gd name="connsiteY3" fmla="*/ 14287 h 342900"/>
                <a:gd name="connsiteX4" fmla="*/ 238125 w 445293"/>
                <a:gd name="connsiteY4" fmla="*/ 26193 h 342900"/>
                <a:gd name="connsiteX5" fmla="*/ 183356 w 445293"/>
                <a:gd name="connsiteY5" fmla="*/ 33337 h 342900"/>
                <a:gd name="connsiteX6" fmla="*/ 138112 w 445293"/>
                <a:gd name="connsiteY6" fmla="*/ 59531 h 342900"/>
                <a:gd name="connsiteX7" fmla="*/ 114300 w 445293"/>
                <a:gd name="connsiteY7" fmla="*/ 66675 h 342900"/>
                <a:gd name="connsiteX8" fmla="*/ 76200 w 445293"/>
                <a:gd name="connsiteY8" fmla="*/ 111918 h 342900"/>
                <a:gd name="connsiteX9" fmla="*/ 54768 w 445293"/>
                <a:gd name="connsiteY9" fmla="*/ 154781 h 342900"/>
                <a:gd name="connsiteX10" fmla="*/ 33337 w 445293"/>
                <a:gd name="connsiteY10" fmla="*/ 188118 h 342900"/>
                <a:gd name="connsiteX11" fmla="*/ 16668 w 445293"/>
                <a:gd name="connsiteY11" fmla="*/ 216693 h 342900"/>
                <a:gd name="connsiteX12" fmla="*/ 0 w 445293"/>
                <a:gd name="connsiteY12" fmla="*/ 285750 h 342900"/>
                <a:gd name="connsiteX13" fmla="*/ 0 w 445293"/>
                <a:gd name="connsiteY13" fmla="*/ 319087 h 342900"/>
                <a:gd name="connsiteX14" fmla="*/ 0 w 445293"/>
                <a:gd name="connsiteY14" fmla="*/ 330993 h 342900"/>
                <a:gd name="connsiteX15" fmla="*/ 33337 w 445293"/>
                <a:gd name="connsiteY15" fmla="*/ 342900 h 342900"/>
                <a:gd name="connsiteX16" fmla="*/ 52387 w 445293"/>
                <a:gd name="connsiteY16" fmla="*/ 295275 h 342900"/>
                <a:gd name="connsiteX17" fmla="*/ 52387 w 445293"/>
                <a:gd name="connsiteY17" fmla="*/ 195262 h 342900"/>
                <a:gd name="connsiteX18" fmla="*/ 119062 w 445293"/>
                <a:gd name="connsiteY18" fmla="*/ 128587 h 342900"/>
                <a:gd name="connsiteX19" fmla="*/ 147637 w 445293"/>
                <a:gd name="connsiteY19" fmla="*/ 83343 h 342900"/>
                <a:gd name="connsiteX20" fmla="*/ 214312 w 445293"/>
                <a:gd name="connsiteY20" fmla="*/ 76200 h 342900"/>
                <a:gd name="connsiteX21" fmla="*/ 264318 w 445293"/>
                <a:gd name="connsiteY21" fmla="*/ 54768 h 342900"/>
                <a:gd name="connsiteX22" fmla="*/ 321468 w 445293"/>
                <a:gd name="connsiteY22" fmla="*/ 40481 h 342900"/>
                <a:gd name="connsiteX23" fmla="*/ 445293 w 445293"/>
                <a:gd name="connsiteY23" fmla="*/ 69056 h 3429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</a:cxnLst>
              <a:rect l="l" t="t" r="r" b="b"/>
              <a:pathLst>
                <a:path w="445293" h="342900">
                  <a:moveTo>
                    <a:pt x="445293" y="69056"/>
                  </a:moveTo>
                  <a:lnTo>
                    <a:pt x="409575" y="23812"/>
                  </a:lnTo>
                  <a:lnTo>
                    <a:pt x="354806" y="0"/>
                  </a:lnTo>
                  <a:lnTo>
                    <a:pt x="304800" y="14287"/>
                  </a:lnTo>
                  <a:lnTo>
                    <a:pt x="238125" y="26193"/>
                  </a:lnTo>
                  <a:lnTo>
                    <a:pt x="183356" y="33337"/>
                  </a:lnTo>
                  <a:lnTo>
                    <a:pt x="138112" y="59531"/>
                  </a:lnTo>
                  <a:lnTo>
                    <a:pt x="114300" y="66675"/>
                  </a:lnTo>
                  <a:lnTo>
                    <a:pt x="76200" y="111918"/>
                  </a:lnTo>
                  <a:lnTo>
                    <a:pt x="54768" y="154781"/>
                  </a:lnTo>
                  <a:lnTo>
                    <a:pt x="33337" y="188118"/>
                  </a:lnTo>
                  <a:lnTo>
                    <a:pt x="16668" y="216693"/>
                  </a:lnTo>
                  <a:lnTo>
                    <a:pt x="0" y="285750"/>
                  </a:lnTo>
                  <a:lnTo>
                    <a:pt x="0" y="319087"/>
                  </a:lnTo>
                  <a:lnTo>
                    <a:pt x="0" y="330993"/>
                  </a:lnTo>
                  <a:lnTo>
                    <a:pt x="33337" y="342900"/>
                  </a:lnTo>
                  <a:lnTo>
                    <a:pt x="52387" y="295275"/>
                  </a:lnTo>
                  <a:lnTo>
                    <a:pt x="52387" y="195262"/>
                  </a:lnTo>
                  <a:lnTo>
                    <a:pt x="119062" y="128587"/>
                  </a:lnTo>
                  <a:lnTo>
                    <a:pt x="147637" y="83343"/>
                  </a:lnTo>
                  <a:lnTo>
                    <a:pt x="214312" y="76200"/>
                  </a:lnTo>
                  <a:lnTo>
                    <a:pt x="264318" y="54768"/>
                  </a:lnTo>
                  <a:lnTo>
                    <a:pt x="321468" y="40481"/>
                  </a:lnTo>
                  <a:lnTo>
                    <a:pt x="445293" y="69056"/>
                  </a:lnTo>
                  <a:close/>
                </a:path>
              </a:pathLst>
            </a:custGeom>
            <a:solidFill>
              <a:srgbClr val="00B0F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pic>
        <p:nvPicPr>
          <p:cNvPr id="25" name="Picture 24">
            <a:extLst>
              <a:ext uri="{FF2B5EF4-FFF2-40B4-BE49-F238E27FC236}">
                <a16:creationId xmlns:a16="http://schemas.microsoft.com/office/drawing/2014/main" id="{02261AA1-D4B8-C044-8E33-0970EC26F9CB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3301" y="1675287"/>
            <a:ext cx="1752349" cy="1259078"/>
          </a:xfrm>
          <a:prstGeom prst="rect">
            <a:avLst/>
          </a:prstGeom>
        </p:spPr>
      </p:pic>
      <p:sp>
        <p:nvSpPr>
          <p:cNvPr id="26" name="Freeform: Shape 25">
            <a:extLst>
              <a:ext uri="{FF2B5EF4-FFF2-40B4-BE49-F238E27FC236}">
                <a16:creationId xmlns:a16="http://schemas.microsoft.com/office/drawing/2014/main" id="{66EA9CFF-0D37-F255-49BE-639204632ACC}"/>
              </a:ext>
            </a:extLst>
          </p:cNvPr>
          <p:cNvSpPr/>
          <p:nvPr/>
        </p:nvSpPr>
        <p:spPr>
          <a:xfrm>
            <a:off x="1750219" y="2383631"/>
            <a:ext cx="159544" cy="159544"/>
          </a:xfrm>
          <a:custGeom>
            <a:avLst/>
            <a:gdLst>
              <a:gd name="connsiteX0" fmla="*/ 111919 w 159544"/>
              <a:gd name="connsiteY0" fmla="*/ 16669 h 159544"/>
              <a:gd name="connsiteX1" fmla="*/ 57150 w 159544"/>
              <a:gd name="connsiteY1" fmla="*/ 23813 h 159544"/>
              <a:gd name="connsiteX2" fmla="*/ 23812 w 159544"/>
              <a:gd name="connsiteY2" fmla="*/ 7144 h 159544"/>
              <a:gd name="connsiteX3" fmla="*/ 0 w 159544"/>
              <a:gd name="connsiteY3" fmla="*/ 0 h 159544"/>
              <a:gd name="connsiteX4" fmla="*/ 9525 w 159544"/>
              <a:gd name="connsiteY4" fmla="*/ 59532 h 159544"/>
              <a:gd name="connsiteX5" fmla="*/ 9525 w 159544"/>
              <a:gd name="connsiteY5" fmla="*/ 123825 h 159544"/>
              <a:gd name="connsiteX6" fmla="*/ 2381 w 159544"/>
              <a:gd name="connsiteY6" fmla="*/ 159544 h 159544"/>
              <a:gd name="connsiteX7" fmla="*/ 45244 w 159544"/>
              <a:gd name="connsiteY7" fmla="*/ 97632 h 159544"/>
              <a:gd name="connsiteX8" fmla="*/ 88106 w 159544"/>
              <a:gd name="connsiteY8" fmla="*/ 76200 h 159544"/>
              <a:gd name="connsiteX9" fmla="*/ 159544 w 159544"/>
              <a:gd name="connsiteY9" fmla="*/ 95250 h 159544"/>
              <a:gd name="connsiteX10" fmla="*/ 111919 w 159544"/>
              <a:gd name="connsiteY10" fmla="*/ 16669 h 1595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59544" h="159544">
                <a:moveTo>
                  <a:pt x="111919" y="16669"/>
                </a:moveTo>
                <a:lnTo>
                  <a:pt x="57150" y="23813"/>
                </a:lnTo>
                <a:lnTo>
                  <a:pt x="23812" y="7144"/>
                </a:lnTo>
                <a:lnTo>
                  <a:pt x="0" y="0"/>
                </a:lnTo>
                <a:lnTo>
                  <a:pt x="9525" y="59532"/>
                </a:lnTo>
                <a:lnTo>
                  <a:pt x="9525" y="123825"/>
                </a:lnTo>
                <a:lnTo>
                  <a:pt x="2381" y="159544"/>
                </a:lnTo>
                <a:lnTo>
                  <a:pt x="45244" y="97632"/>
                </a:lnTo>
                <a:lnTo>
                  <a:pt x="88106" y="76200"/>
                </a:lnTo>
                <a:lnTo>
                  <a:pt x="159544" y="95250"/>
                </a:lnTo>
                <a:lnTo>
                  <a:pt x="111919" y="16669"/>
                </a:lnTo>
                <a:close/>
              </a:path>
            </a:pathLst>
          </a:custGeom>
          <a:solidFill>
            <a:srgbClr val="00B0F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Freeform: Shape 26">
            <a:extLst>
              <a:ext uri="{FF2B5EF4-FFF2-40B4-BE49-F238E27FC236}">
                <a16:creationId xmlns:a16="http://schemas.microsoft.com/office/drawing/2014/main" id="{5659958B-BA6F-64F9-2C71-CD32A134DDED}"/>
              </a:ext>
            </a:extLst>
          </p:cNvPr>
          <p:cNvSpPr/>
          <p:nvPr/>
        </p:nvSpPr>
        <p:spPr>
          <a:xfrm>
            <a:off x="1278731" y="2005013"/>
            <a:ext cx="238125" cy="254793"/>
          </a:xfrm>
          <a:custGeom>
            <a:avLst/>
            <a:gdLst>
              <a:gd name="connsiteX0" fmla="*/ 176213 w 238125"/>
              <a:gd name="connsiteY0" fmla="*/ 192881 h 254793"/>
              <a:gd name="connsiteX1" fmla="*/ 238125 w 238125"/>
              <a:gd name="connsiteY1" fmla="*/ 195262 h 254793"/>
              <a:gd name="connsiteX2" fmla="*/ 223838 w 238125"/>
              <a:gd name="connsiteY2" fmla="*/ 150018 h 254793"/>
              <a:gd name="connsiteX3" fmla="*/ 159544 w 238125"/>
              <a:gd name="connsiteY3" fmla="*/ 123825 h 254793"/>
              <a:gd name="connsiteX4" fmla="*/ 107157 w 238125"/>
              <a:gd name="connsiteY4" fmla="*/ 107156 h 254793"/>
              <a:gd name="connsiteX5" fmla="*/ 88107 w 238125"/>
              <a:gd name="connsiteY5" fmla="*/ 57150 h 254793"/>
              <a:gd name="connsiteX6" fmla="*/ 35719 w 238125"/>
              <a:gd name="connsiteY6" fmla="*/ 9525 h 254793"/>
              <a:gd name="connsiteX7" fmla="*/ 0 w 238125"/>
              <a:gd name="connsiteY7" fmla="*/ 0 h 254793"/>
              <a:gd name="connsiteX8" fmla="*/ 23813 w 238125"/>
              <a:gd name="connsiteY8" fmla="*/ 71437 h 254793"/>
              <a:gd name="connsiteX9" fmla="*/ 35719 w 238125"/>
              <a:gd name="connsiteY9" fmla="*/ 128587 h 254793"/>
              <a:gd name="connsiteX10" fmla="*/ 42863 w 238125"/>
              <a:gd name="connsiteY10" fmla="*/ 183356 h 254793"/>
              <a:gd name="connsiteX11" fmla="*/ 35719 w 238125"/>
              <a:gd name="connsiteY11" fmla="*/ 221456 h 254793"/>
              <a:gd name="connsiteX12" fmla="*/ 23813 w 238125"/>
              <a:gd name="connsiteY12" fmla="*/ 247650 h 254793"/>
              <a:gd name="connsiteX13" fmla="*/ 73819 w 238125"/>
              <a:gd name="connsiteY13" fmla="*/ 254793 h 254793"/>
              <a:gd name="connsiteX14" fmla="*/ 90488 w 238125"/>
              <a:gd name="connsiteY14" fmla="*/ 233362 h 254793"/>
              <a:gd name="connsiteX15" fmla="*/ 176213 w 238125"/>
              <a:gd name="connsiteY15" fmla="*/ 192881 h 2547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238125" h="254793">
                <a:moveTo>
                  <a:pt x="176213" y="192881"/>
                </a:moveTo>
                <a:lnTo>
                  <a:pt x="238125" y="195262"/>
                </a:lnTo>
                <a:lnTo>
                  <a:pt x="223838" y="150018"/>
                </a:lnTo>
                <a:lnTo>
                  <a:pt x="159544" y="123825"/>
                </a:lnTo>
                <a:lnTo>
                  <a:pt x="107157" y="107156"/>
                </a:lnTo>
                <a:lnTo>
                  <a:pt x="88107" y="57150"/>
                </a:lnTo>
                <a:lnTo>
                  <a:pt x="35719" y="9525"/>
                </a:lnTo>
                <a:lnTo>
                  <a:pt x="0" y="0"/>
                </a:lnTo>
                <a:lnTo>
                  <a:pt x="23813" y="71437"/>
                </a:lnTo>
                <a:lnTo>
                  <a:pt x="35719" y="128587"/>
                </a:lnTo>
                <a:lnTo>
                  <a:pt x="42863" y="183356"/>
                </a:lnTo>
                <a:lnTo>
                  <a:pt x="35719" y="221456"/>
                </a:lnTo>
                <a:lnTo>
                  <a:pt x="23813" y="247650"/>
                </a:lnTo>
                <a:lnTo>
                  <a:pt x="73819" y="254793"/>
                </a:lnTo>
                <a:lnTo>
                  <a:pt x="90488" y="233362"/>
                </a:lnTo>
                <a:lnTo>
                  <a:pt x="176213" y="192881"/>
                </a:lnTo>
                <a:close/>
              </a:path>
            </a:pathLst>
          </a:custGeom>
          <a:solidFill>
            <a:srgbClr val="00B0F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Freeform: Shape 27">
            <a:extLst>
              <a:ext uri="{FF2B5EF4-FFF2-40B4-BE49-F238E27FC236}">
                <a16:creationId xmlns:a16="http://schemas.microsoft.com/office/drawing/2014/main" id="{67CD1268-4833-6E18-984F-228F6C95FCC5}"/>
              </a:ext>
            </a:extLst>
          </p:cNvPr>
          <p:cNvSpPr/>
          <p:nvPr/>
        </p:nvSpPr>
        <p:spPr>
          <a:xfrm>
            <a:off x="1266825" y="2262188"/>
            <a:ext cx="85725" cy="381000"/>
          </a:xfrm>
          <a:custGeom>
            <a:avLst/>
            <a:gdLst>
              <a:gd name="connsiteX0" fmla="*/ 57150 w 85725"/>
              <a:gd name="connsiteY0" fmla="*/ 42862 h 381000"/>
              <a:gd name="connsiteX1" fmla="*/ 64294 w 85725"/>
              <a:gd name="connsiteY1" fmla="*/ 88106 h 381000"/>
              <a:gd name="connsiteX2" fmla="*/ 40481 w 85725"/>
              <a:gd name="connsiteY2" fmla="*/ 147637 h 381000"/>
              <a:gd name="connsiteX3" fmla="*/ 61913 w 85725"/>
              <a:gd name="connsiteY3" fmla="*/ 200025 h 381000"/>
              <a:gd name="connsiteX4" fmla="*/ 57150 w 85725"/>
              <a:gd name="connsiteY4" fmla="*/ 259556 h 381000"/>
              <a:gd name="connsiteX5" fmla="*/ 64294 w 85725"/>
              <a:gd name="connsiteY5" fmla="*/ 278606 h 381000"/>
              <a:gd name="connsiteX6" fmla="*/ 80963 w 85725"/>
              <a:gd name="connsiteY6" fmla="*/ 323850 h 381000"/>
              <a:gd name="connsiteX7" fmla="*/ 85725 w 85725"/>
              <a:gd name="connsiteY7" fmla="*/ 381000 h 381000"/>
              <a:gd name="connsiteX8" fmla="*/ 85725 w 85725"/>
              <a:gd name="connsiteY8" fmla="*/ 381000 h 381000"/>
              <a:gd name="connsiteX9" fmla="*/ 38100 w 85725"/>
              <a:gd name="connsiteY9" fmla="*/ 314325 h 381000"/>
              <a:gd name="connsiteX10" fmla="*/ 19050 w 85725"/>
              <a:gd name="connsiteY10" fmla="*/ 252412 h 381000"/>
              <a:gd name="connsiteX11" fmla="*/ 4763 w 85725"/>
              <a:gd name="connsiteY11" fmla="*/ 195262 h 381000"/>
              <a:gd name="connsiteX12" fmla="*/ 21431 w 85725"/>
              <a:gd name="connsiteY12" fmla="*/ 109537 h 381000"/>
              <a:gd name="connsiteX13" fmla="*/ 0 w 85725"/>
              <a:gd name="connsiteY13" fmla="*/ 61912 h 381000"/>
              <a:gd name="connsiteX14" fmla="*/ 21431 w 85725"/>
              <a:gd name="connsiteY14" fmla="*/ 0 h 381000"/>
              <a:gd name="connsiteX15" fmla="*/ 57150 w 85725"/>
              <a:gd name="connsiteY15" fmla="*/ 42862 h 381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85725" h="381000">
                <a:moveTo>
                  <a:pt x="57150" y="42862"/>
                </a:moveTo>
                <a:lnTo>
                  <a:pt x="64294" y="88106"/>
                </a:lnTo>
                <a:lnTo>
                  <a:pt x="40481" y="147637"/>
                </a:lnTo>
                <a:lnTo>
                  <a:pt x="61913" y="200025"/>
                </a:lnTo>
                <a:lnTo>
                  <a:pt x="57150" y="259556"/>
                </a:lnTo>
                <a:lnTo>
                  <a:pt x="64294" y="278606"/>
                </a:lnTo>
                <a:lnTo>
                  <a:pt x="80963" y="323850"/>
                </a:lnTo>
                <a:lnTo>
                  <a:pt x="85725" y="381000"/>
                </a:lnTo>
                <a:lnTo>
                  <a:pt x="85725" y="381000"/>
                </a:lnTo>
                <a:lnTo>
                  <a:pt x="38100" y="314325"/>
                </a:lnTo>
                <a:lnTo>
                  <a:pt x="19050" y="252412"/>
                </a:lnTo>
                <a:lnTo>
                  <a:pt x="4763" y="195262"/>
                </a:lnTo>
                <a:lnTo>
                  <a:pt x="21431" y="109537"/>
                </a:lnTo>
                <a:lnTo>
                  <a:pt x="0" y="61912"/>
                </a:lnTo>
                <a:lnTo>
                  <a:pt x="21431" y="0"/>
                </a:lnTo>
                <a:lnTo>
                  <a:pt x="57150" y="42862"/>
                </a:lnTo>
                <a:close/>
              </a:path>
            </a:pathLst>
          </a:custGeom>
          <a:solidFill>
            <a:srgbClr val="00B0F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Freeform: Shape 28">
            <a:extLst>
              <a:ext uri="{FF2B5EF4-FFF2-40B4-BE49-F238E27FC236}">
                <a16:creationId xmlns:a16="http://schemas.microsoft.com/office/drawing/2014/main" id="{341F8A08-4E50-00C1-821A-A36DEED82D70}"/>
              </a:ext>
            </a:extLst>
          </p:cNvPr>
          <p:cNvSpPr/>
          <p:nvPr/>
        </p:nvSpPr>
        <p:spPr>
          <a:xfrm>
            <a:off x="361950" y="2069306"/>
            <a:ext cx="654844" cy="602457"/>
          </a:xfrm>
          <a:custGeom>
            <a:avLst/>
            <a:gdLst>
              <a:gd name="connsiteX0" fmla="*/ 59531 w 654844"/>
              <a:gd name="connsiteY0" fmla="*/ 126207 h 602457"/>
              <a:gd name="connsiteX1" fmla="*/ 19050 w 654844"/>
              <a:gd name="connsiteY1" fmla="*/ 176213 h 602457"/>
              <a:gd name="connsiteX2" fmla="*/ 0 w 654844"/>
              <a:gd name="connsiteY2" fmla="*/ 226219 h 602457"/>
              <a:gd name="connsiteX3" fmla="*/ 9525 w 654844"/>
              <a:gd name="connsiteY3" fmla="*/ 304800 h 602457"/>
              <a:gd name="connsiteX4" fmla="*/ 14288 w 654844"/>
              <a:gd name="connsiteY4" fmla="*/ 350044 h 602457"/>
              <a:gd name="connsiteX5" fmla="*/ 30956 w 654844"/>
              <a:gd name="connsiteY5" fmla="*/ 407194 h 602457"/>
              <a:gd name="connsiteX6" fmla="*/ 71438 w 654844"/>
              <a:gd name="connsiteY6" fmla="*/ 459582 h 602457"/>
              <a:gd name="connsiteX7" fmla="*/ 135731 w 654844"/>
              <a:gd name="connsiteY7" fmla="*/ 519113 h 602457"/>
              <a:gd name="connsiteX8" fmla="*/ 176213 w 654844"/>
              <a:gd name="connsiteY8" fmla="*/ 542925 h 602457"/>
              <a:gd name="connsiteX9" fmla="*/ 214313 w 654844"/>
              <a:gd name="connsiteY9" fmla="*/ 592932 h 602457"/>
              <a:gd name="connsiteX10" fmla="*/ 230981 w 654844"/>
              <a:gd name="connsiteY10" fmla="*/ 571500 h 602457"/>
              <a:gd name="connsiteX11" fmla="*/ 264319 w 654844"/>
              <a:gd name="connsiteY11" fmla="*/ 583407 h 602457"/>
              <a:gd name="connsiteX12" fmla="*/ 269081 w 654844"/>
              <a:gd name="connsiteY12" fmla="*/ 602457 h 602457"/>
              <a:gd name="connsiteX13" fmla="*/ 307181 w 654844"/>
              <a:gd name="connsiteY13" fmla="*/ 576263 h 602457"/>
              <a:gd name="connsiteX14" fmla="*/ 352425 w 654844"/>
              <a:gd name="connsiteY14" fmla="*/ 564357 h 602457"/>
              <a:gd name="connsiteX15" fmla="*/ 411956 w 654844"/>
              <a:gd name="connsiteY15" fmla="*/ 585788 h 602457"/>
              <a:gd name="connsiteX16" fmla="*/ 426244 w 654844"/>
              <a:gd name="connsiteY16" fmla="*/ 550069 h 602457"/>
              <a:gd name="connsiteX17" fmla="*/ 452438 w 654844"/>
              <a:gd name="connsiteY17" fmla="*/ 521494 h 602457"/>
              <a:gd name="connsiteX18" fmla="*/ 485775 w 654844"/>
              <a:gd name="connsiteY18" fmla="*/ 514350 h 602457"/>
              <a:gd name="connsiteX19" fmla="*/ 519113 w 654844"/>
              <a:gd name="connsiteY19" fmla="*/ 514350 h 602457"/>
              <a:gd name="connsiteX20" fmla="*/ 526256 w 654844"/>
              <a:gd name="connsiteY20" fmla="*/ 481013 h 602457"/>
              <a:gd name="connsiteX21" fmla="*/ 533400 w 654844"/>
              <a:gd name="connsiteY21" fmla="*/ 445294 h 602457"/>
              <a:gd name="connsiteX22" fmla="*/ 535781 w 654844"/>
              <a:gd name="connsiteY22" fmla="*/ 409575 h 602457"/>
              <a:gd name="connsiteX23" fmla="*/ 545306 w 654844"/>
              <a:gd name="connsiteY23" fmla="*/ 373857 h 602457"/>
              <a:gd name="connsiteX24" fmla="*/ 614363 w 654844"/>
              <a:gd name="connsiteY24" fmla="*/ 383382 h 602457"/>
              <a:gd name="connsiteX25" fmla="*/ 621506 w 654844"/>
              <a:gd name="connsiteY25" fmla="*/ 340519 h 602457"/>
              <a:gd name="connsiteX26" fmla="*/ 611981 w 654844"/>
              <a:gd name="connsiteY26" fmla="*/ 290513 h 602457"/>
              <a:gd name="connsiteX27" fmla="*/ 650081 w 654844"/>
              <a:gd name="connsiteY27" fmla="*/ 259557 h 602457"/>
              <a:gd name="connsiteX28" fmla="*/ 654844 w 654844"/>
              <a:gd name="connsiteY28" fmla="*/ 219075 h 602457"/>
              <a:gd name="connsiteX29" fmla="*/ 645319 w 654844"/>
              <a:gd name="connsiteY29" fmla="*/ 180975 h 602457"/>
              <a:gd name="connsiteX30" fmla="*/ 569119 w 654844"/>
              <a:gd name="connsiteY30" fmla="*/ 166688 h 602457"/>
              <a:gd name="connsiteX31" fmla="*/ 509588 w 654844"/>
              <a:gd name="connsiteY31" fmla="*/ 166688 h 602457"/>
              <a:gd name="connsiteX32" fmla="*/ 488156 w 654844"/>
              <a:gd name="connsiteY32" fmla="*/ 150019 h 602457"/>
              <a:gd name="connsiteX33" fmla="*/ 459581 w 654844"/>
              <a:gd name="connsiteY33" fmla="*/ 88107 h 602457"/>
              <a:gd name="connsiteX34" fmla="*/ 426244 w 654844"/>
              <a:gd name="connsiteY34" fmla="*/ 11907 h 602457"/>
              <a:gd name="connsiteX35" fmla="*/ 392906 w 654844"/>
              <a:gd name="connsiteY35" fmla="*/ 0 h 602457"/>
              <a:gd name="connsiteX36" fmla="*/ 431006 w 654844"/>
              <a:gd name="connsiteY36" fmla="*/ 88107 h 602457"/>
              <a:gd name="connsiteX37" fmla="*/ 442913 w 654844"/>
              <a:gd name="connsiteY37" fmla="*/ 130969 h 602457"/>
              <a:gd name="connsiteX38" fmla="*/ 488156 w 654844"/>
              <a:gd name="connsiteY38" fmla="*/ 192882 h 602457"/>
              <a:gd name="connsiteX39" fmla="*/ 511969 w 654844"/>
              <a:gd name="connsiteY39" fmla="*/ 226219 h 602457"/>
              <a:gd name="connsiteX40" fmla="*/ 516731 w 654844"/>
              <a:gd name="connsiteY40" fmla="*/ 271463 h 602457"/>
              <a:gd name="connsiteX41" fmla="*/ 531019 w 654844"/>
              <a:gd name="connsiteY41" fmla="*/ 319088 h 602457"/>
              <a:gd name="connsiteX42" fmla="*/ 526256 w 654844"/>
              <a:gd name="connsiteY42" fmla="*/ 381000 h 602457"/>
              <a:gd name="connsiteX43" fmla="*/ 504825 w 654844"/>
              <a:gd name="connsiteY43" fmla="*/ 421482 h 602457"/>
              <a:gd name="connsiteX44" fmla="*/ 483394 w 654844"/>
              <a:gd name="connsiteY44" fmla="*/ 447675 h 602457"/>
              <a:gd name="connsiteX45" fmla="*/ 466725 w 654844"/>
              <a:gd name="connsiteY45" fmla="*/ 476250 h 602457"/>
              <a:gd name="connsiteX46" fmla="*/ 435769 w 654844"/>
              <a:gd name="connsiteY46" fmla="*/ 504825 h 602457"/>
              <a:gd name="connsiteX47" fmla="*/ 416719 w 654844"/>
              <a:gd name="connsiteY47" fmla="*/ 519113 h 602457"/>
              <a:gd name="connsiteX48" fmla="*/ 359569 w 654844"/>
              <a:gd name="connsiteY48" fmla="*/ 531019 h 602457"/>
              <a:gd name="connsiteX49" fmla="*/ 319088 w 654844"/>
              <a:gd name="connsiteY49" fmla="*/ 542925 h 602457"/>
              <a:gd name="connsiteX50" fmla="*/ 280988 w 654844"/>
              <a:gd name="connsiteY50" fmla="*/ 547688 h 602457"/>
              <a:gd name="connsiteX51" fmla="*/ 228600 w 654844"/>
              <a:gd name="connsiteY51" fmla="*/ 545307 h 602457"/>
              <a:gd name="connsiteX52" fmla="*/ 200025 w 654844"/>
              <a:gd name="connsiteY52" fmla="*/ 519113 h 602457"/>
              <a:gd name="connsiteX53" fmla="*/ 152400 w 654844"/>
              <a:gd name="connsiteY53" fmla="*/ 490538 h 602457"/>
              <a:gd name="connsiteX54" fmla="*/ 126206 w 654844"/>
              <a:gd name="connsiteY54" fmla="*/ 459582 h 602457"/>
              <a:gd name="connsiteX55" fmla="*/ 102394 w 654844"/>
              <a:gd name="connsiteY55" fmla="*/ 411957 h 602457"/>
              <a:gd name="connsiteX56" fmla="*/ 80963 w 654844"/>
              <a:gd name="connsiteY56" fmla="*/ 366713 h 602457"/>
              <a:gd name="connsiteX57" fmla="*/ 47625 w 654844"/>
              <a:gd name="connsiteY57" fmla="*/ 323850 h 602457"/>
              <a:gd name="connsiteX58" fmla="*/ 23813 w 654844"/>
              <a:gd name="connsiteY58" fmla="*/ 271463 h 602457"/>
              <a:gd name="connsiteX59" fmla="*/ 35719 w 654844"/>
              <a:gd name="connsiteY59" fmla="*/ 216694 h 602457"/>
              <a:gd name="connsiteX60" fmla="*/ 59531 w 654844"/>
              <a:gd name="connsiteY60" fmla="*/ 126207 h 6024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</a:cxnLst>
            <a:rect l="l" t="t" r="r" b="b"/>
            <a:pathLst>
              <a:path w="654844" h="602457">
                <a:moveTo>
                  <a:pt x="59531" y="126207"/>
                </a:moveTo>
                <a:lnTo>
                  <a:pt x="19050" y="176213"/>
                </a:lnTo>
                <a:lnTo>
                  <a:pt x="0" y="226219"/>
                </a:lnTo>
                <a:lnTo>
                  <a:pt x="9525" y="304800"/>
                </a:lnTo>
                <a:lnTo>
                  <a:pt x="14288" y="350044"/>
                </a:lnTo>
                <a:lnTo>
                  <a:pt x="30956" y="407194"/>
                </a:lnTo>
                <a:lnTo>
                  <a:pt x="71438" y="459582"/>
                </a:lnTo>
                <a:lnTo>
                  <a:pt x="135731" y="519113"/>
                </a:lnTo>
                <a:lnTo>
                  <a:pt x="176213" y="542925"/>
                </a:lnTo>
                <a:lnTo>
                  <a:pt x="214313" y="592932"/>
                </a:lnTo>
                <a:lnTo>
                  <a:pt x="230981" y="571500"/>
                </a:lnTo>
                <a:lnTo>
                  <a:pt x="264319" y="583407"/>
                </a:lnTo>
                <a:lnTo>
                  <a:pt x="269081" y="602457"/>
                </a:lnTo>
                <a:lnTo>
                  <a:pt x="307181" y="576263"/>
                </a:lnTo>
                <a:lnTo>
                  <a:pt x="352425" y="564357"/>
                </a:lnTo>
                <a:lnTo>
                  <a:pt x="411956" y="585788"/>
                </a:lnTo>
                <a:lnTo>
                  <a:pt x="426244" y="550069"/>
                </a:lnTo>
                <a:lnTo>
                  <a:pt x="452438" y="521494"/>
                </a:lnTo>
                <a:lnTo>
                  <a:pt x="485775" y="514350"/>
                </a:lnTo>
                <a:lnTo>
                  <a:pt x="519113" y="514350"/>
                </a:lnTo>
                <a:lnTo>
                  <a:pt x="526256" y="481013"/>
                </a:lnTo>
                <a:lnTo>
                  <a:pt x="533400" y="445294"/>
                </a:lnTo>
                <a:lnTo>
                  <a:pt x="535781" y="409575"/>
                </a:lnTo>
                <a:lnTo>
                  <a:pt x="545306" y="373857"/>
                </a:lnTo>
                <a:lnTo>
                  <a:pt x="614363" y="383382"/>
                </a:lnTo>
                <a:lnTo>
                  <a:pt x="621506" y="340519"/>
                </a:lnTo>
                <a:lnTo>
                  <a:pt x="611981" y="290513"/>
                </a:lnTo>
                <a:lnTo>
                  <a:pt x="650081" y="259557"/>
                </a:lnTo>
                <a:lnTo>
                  <a:pt x="654844" y="219075"/>
                </a:lnTo>
                <a:lnTo>
                  <a:pt x="645319" y="180975"/>
                </a:lnTo>
                <a:lnTo>
                  <a:pt x="569119" y="166688"/>
                </a:lnTo>
                <a:lnTo>
                  <a:pt x="509588" y="166688"/>
                </a:lnTo>
                <a:lnTo>
                  <a:pt x="488156" y="150019"/>
                </a:lnTo>
                <a:lnTo>
                  <a:pt x="459581" y="88107"/>
                </a:lnTo>
                <a:lnTo>
                  <a:pt x="426244" y="11907"/>
                </a:lnTo>
                <a:lnTo>
                  <a:pt x="392906" y="0"/>
                </a:lnTo>
                <a:lnTo>
                  <a:pt x="431006" y="88107"/>
                </a:lnTo>
                <a:lnTo>
                  <a:pt x="442913" y="130969"/>
                </a:lnTo>
                <a:lnTo>
                  <a:pt x="488156" y="192882"/>
                </a:lnTo>
                <a:lnTo>
                  <a:pt x="511969" y="226219"/>
                </a:lnTo>
                <a:lnTo>
                  <a:pt x="516731" y="271463"/>
                </a:lnTo>
                <a:lnTo>
                  <a:pt x="531019" y="319088"/>
                </a:lnTo>
                <a:lnTo>
                  <a:pt x="526256" y="381000"/>
                </a:lnTo>
                <a:lnTo>
                  <a:pt x="504825" y="421482"/>
                </a:lnTo>
                <a:lnTo>
                  <a:pt x="483394" y="447675"/>
                </a:lnTo>
                <a:lnTo>
                  <a:pt x="466725" y="476250"/>
                </a:lnTo>
                <a:lnTo>
                  <a:pt x="435769" y="504825"/>
                </a:lnTo>
                <a:lnTo>
                  <a:pt x="416719" y="519113"/>
                </a:lnTo>
                <a:lnTo>
                  <a:pt x="359569" y="531019"/>
                </a:lnTo>
                <a:lnTo>
                  <a:pt x="319088" y="542925"/>
                </a:lnTo>
                <a:lnTo>
                  <a:pt x="280988" y="547688"/>
                </a:lnTo>
                <a:lnTo>
                  <a:pt x="228600" y="545307"/>
                </a:lnTo>
                <a:lnTo>
                  <a:pt x="200025" y="519113"/>
                </a:lnTo>
                <a:lnTo>
                  <a:pt x="152400" y="490538"/>
                </a:lnTo>
                <a:lnTo>
                  <a:pt x="126206" y="459582"/>
                </a:lnTo>
                <a:lnTo>
                  <a:pt x="102394" y="411957"/>
                </a:lnTo>
                <a:lnTo>
                  <a:pt x="80963" y="366713"/>
                </a:lnTo>
                <a:lnTo>
                  <a:pt x="47625" y="323850"/>
                </a:lnTo>
                <a:lnTo>
                  <a:pt x="23813" y="271463"/>
                </a:lnTo>
                <a:lnTo>
                  <a:pt x="35719" y="216694"/>
                </a:lnTo>
                <a:lnTo>
                  <a:pt x="59531" y="126207"/>
                </a:lnTo>
                <a:close/>
              </a:path>
            </a:pathLst>
          </a:custGeom>
          <a:solidFill>
            <a:srgbClr val="00B0F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Freeform: Shape 29">
            <a:extLst>
              <a:ext uri="{FF2B5EF4-FFF2-40B4-BE49-F238E27FC236}">
                <a16:creationId xmlns:a16="http://schemas.microsoft.com/office/drawing/2014/main" id="{C8FD1026-1247-B067-D2F1-E8D429CA0E07}"/>
              </a:ext>
            </a:extLst>
          </p:cNvPr>
          <p:cNvSpPr/>
          <p:nvPr/>
        </p:nvSpPr>
        <p:spPr>
          <a:xfrm>
            <a:off x="952500" y="1693069"/>
            <a:ext cx="121444" cy="219075"/>
          </a:xfrm>
          <a:custGeom>
            <a:avLst/>
            <a:gdLst>
              <a:gd name="connsiteX0" fmla="*/ 21431 w 121444"/>
              <a:gd name="connsiteY0" fmla="*/ 0 h 219075"/>
              <a:gd name="connsiteX1" fmla="*/ 21431 w 121444"/>
              <a:gd name="connsiteY1" fmla="*/ 50006 h 219075"/>
              <a:gd name="connsiteX2" fmla="*/ 61913 w 121444"/>
              <a:gd name="connsiteY2" fmla="*/ 114300 h 219075"/>
              <a:gd name="connsiteX3" fmla="*/ 54769 w 121444"/>
              <a:gd name="connsiteY3" fmla="*/ 171450 h 219075"/>
              <a:gd name="connsiteX4" fmla="*/ 0 w 121444"/>
              <a:gd name="connsiteY4" fmla="*/ 209550 h 219075"/>
              <a:gd name="connsiteX5" fmla="*/ 57150 w 121444"/>
              <a:gd name="connsiteY5" fmla="*/ 219075 h 219075"/>
              <a:gd name="connsiteX6" fmla="*/ 102394 w 121444"/>
              <a:gd name="connsiteY6" fmla="*/ 192881 h 219075"/>
              <a:gd name="connsiteX7" fmla="*/ 114300 w 121444"/>
              <a:gd name="connsiteY7" fmla="*/ 164306 h 219075"/>
              <a:gd name="connsiteX8" fmla="*/ 121444 w 121444"/>
              <a:gd name="connsiteY8" fmla="*/ 128587 h 219075"/>
              <a:gd name="connsiteX9" fmla="*/ 116681 w 121444"/>
              <a:gd name="connsiteY9" fmla="*/ 78581 h 219075"/>
              <a:gd name="connsiteX10" fmla="*/ 102394 w 121444"/>
              <a:gd name="connsiteY10" fmla="*/ 30956 h 219075"/>
              <a:gd name="connsiteX11" fmla="*/ 21431 w 121444"/>
              <a:gd name="connsiteY11" fmla="*/ 0 h 2190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21444" h="219075">
                <a:moveTo>
                  <a:pt x="21431" y="0"/>
                </a:moveTo>
                <a:lnTo>
                  <a:pt x="21431" y="50006"/>
                </a:lnTo>
                <a:lnTo>
                  <a:pt x="61913" y="114300"/>
                </a:lnTo>
                <a:lnTo>
                  <a:pt x="54769" y="171450"/>
                </a:lnTo>
                <a:lnTo>
                  <a:pt x="0" y="209550"/>
                </a:lnTo>
                <a:lnTo>
                  <a:pt x="57150" y="219075"/>
                </a:lnTo>
                <a:lnTo>
                  <a:pt x="102394" y="192881"/>
                </a:lnTo>
                <a:cubicBezTo>
                  <a:pt x="113383" y="170904"/>
                  <a:pt x="110197" y="180719"/>
                  <a:pt x="114300" y="164306"/>
                </a:cubicBezTo>
                <a:lnTo>
                  <a:pt x="121444" y="128587"/>
                </a:lnTo>
                <a:cubicBezTo>
                  <a:pt x="118924" y="83219"/>
                  <a:pt x="123589" y="99300"/>
                  <a:pt x="116681" y="78581"/>
                </a:cubicBezTo>
                <a:lnTo>
                  <a:pt x="102394" y="30956"/>
                </a:lnTo>
                <a:lnTo>
                  <a:pt x="21431" y="0"/>
                </a:lnTo>
                <a:close/>
              </a:path>
            </a:pathLst>
          </a:custGeom>
          <a:solidFill>
            <a:srgbClr val="00B0F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80836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426BB74-75FD-1C27-489A-C9342C16170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292" t="7625" b="6002"/>
          <a:stretch/>
        </p:blipFill>
        <p:spPr>
          <a:xfrm>
            <a:off x="751265" y="154131"/>
            <a:ext cx="3437659" cy="184363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74E6050-DD39-6C6B-CC5E-136B71DB0D2B}"/>
              </a:ext>
            </a:extLst>
          </p:cNvPr>
          <p:cNvSpPr txBox="1"/>
          <p:nvPr/>
        </p:nvSpPr>
        <p:spPr>
          <a:xfrm>
            <a:off x="342330" y="156811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03E593E-1C3B-C0BA-23CB-CF67F0DA4817}"/>
              </a:ext>
            </a:extLst>
          </p:cNvPr>
          <p:cNvSpPr txBox="1"/>
          <p:nvPr/>
        </p:nvSpPr>
        <p:spPr>
          <a:xfrm>
            <a:off x="351855" y="2018136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305F8107-7D4A-6D34-BB61-880403261C66}"/>
              </a:ext>
            </a:extLst>
          </p:cNvPr>
          <p:cNvGrpSpPr/>
          <p:nvPr/>
        </p:nvGrpSpPr>
        <p:grpSpPr>
          <a:xfrm>
            <a:off x="517370" y="4121661"/>
            <a:ext cx="5338546" cy="3617375"/>
            <a:chOff x="529270" y="6138523"/>
            <a:chExt cx="4539754" cy="3076116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DCF3731B-ECC5-C3C0-898C-ACCD7F4A47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4374" y="6315073"/>
              <a:ext cx="1440000" cy="1440000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C09D5D96-3A28-2AB4-67A4-BE45AF13F3B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09328" y="7774639"/>
              <a:ext cx="1440000" cy="144000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85BC29E-E3C7-9ABA-7A03-CD0C004E73D2}"/>
                </a:ext>
              </a:extLst>
            </p:cNvPr>
            <p:cNvSpPr txBox="1"/>
            <p:nvPr/>
          </p:nvSpPr>
          <p:spPr>
            <a:xfrm rot="16200000">
              <a:off x="14641" y="6953602"/>
              <a:ext cx="1275911" cy="222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0DE2276-6D65-3060-D3AA-9F6C7E8CA6F9}"/>
                </a:ext>
              </a:extLst>
            </p:cNvPr>
            <p:cNvSpPr txBox="1"/>
            <p:nvPr/>
          </p:nvSpPr>
          <p:spPr>
            <a:xfrm rot="16200000">
              <a:off x="2547" y="8338147"/>
              <a:ext cx="1275911" cy="222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+ </a:t>
              </a:r>
              <a:r>
                <a:rPr lang="en-GB" sz="1100" b="0" i="0" dirty="0">
                  <a:solidFill>
                    <a:srgbClr val="1F1F1F"/>
                  </a:solidFill>
                  <a:effectLst/>
                  <a:latin typeface="Google Sans"/>
                </a:rPr>
                <a:t>U18666A</a:t>
              </a:r>
              <a:endParaRPr lang="en-U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B478FE1-4396-2B63-3F0E-34E3D50BEDAF}"/>
                </a:ext>
              </a:extLst>
            </p:cNvPr>
            <p:cNvSpPr txBox="1"/>
            <p:nvPr/>
          </p:nvSpPr>
          <p:spPr>
            <a:xfrm>
              <a:off x="832305" y="6138523"/>
              <a:ext cx="1275911" cy="222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WT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6CBE071-E3F2-5E6B-3385-565E97F1464A}"/>
                </a:ext>
              </a:extLst>
            </p:cNvPr>
            <p:cNvSpPr txBox="1"/>
            <p:nvPr/>
          </p:nvSpPr>
          <p:spPr>
            <a:xfrm>
              <a:off x="3739251" y="6138523"/>
              <a:ext cx="1275911" cy="222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PC1 KO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BED75BC-73DA-E422-FD63-668CB2B704E5}"/>
                </a:ext>
              </a:extLst>
            </p:cNvPr>
            <p:cNvSpPr txBox="1"/>
            <p:nvPr/>
          </p:nvSpPr>
          <p:spPr>
            <a:xfrm>
              <a:off x="2284431" y="6138523"/>
              <a:ext cx="1275911" cy="222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STARD3 KO</a:t>
              </a:r>
            </a:p>
          </p:txBody>
        </p: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0B116854-2C2F-9071-771B-06209F34197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71699" y="6315073"/>
              <a:ext cx="1440000" cy="1440000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ECEFEF7C-46FF-A538-2D4D-493501425F1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75344" y="7772400"/>
              <a:ext cx="1440000" cy="1440000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6C7AC51D-1273-045F-EC7D-1AD3FE9D2A9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629024" y="6315073"/>
              <a:ext cx="1440000" cy="1440000"/>
            </a:xfrm>
            <a:prstGeom prst="rect">
              <a:avLst/>
            </a:prstGeom>
          </p:spPr>
        </p:pic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725F56E2-14E7-F77A-4315-E4D8ED96B779}"/>
              </a:ext>
            </a:extLst>
          </p:cNvPr>
          <p:cNvSpPr txBox="1"/>
          <p:nvPr/>
        </p:nvSpPr>
        <p:spPr>
          <a:xfrm>
            <a:off x="671705" y="4308162"/>
            <a:ext cx="14734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solidFill>
                  <a:srgbClr val="FF0000"/>
                </a:solidFill>
              </a:rPr>
              <a:t>Mitochondria:LE</a:t>
            </a:r>
            <a:r>
              <a:rPr lang="en-US" sz="1000" b="1" dirty="0">
                <a:solidFill>
                  <a:srgbClr val="FF0000"/>
                </a:solidFill>
              </a:rPr>
              <a:t>/Lys PL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AEEEF39-C43C-8681-FA52-1CB1C3AEA386}"/>
              </a:ext>
            </a:extLst>
          </p:cNvPr>
          <p:cNvSpPr txBox="1"/>
          <p:nvPr/>
        </p:nvSpPr>
        <p:spPr>
          <a:xfrm>
            <a:off x="350607" y="4147221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3DC590B-E484-173F-C234-ADE598717013}"/>
              </a:ext>
            </a:extLst>
          </p:cNvPr>
          <p:cNvSpPr txBox="1"/>
          <p:nvPr/>
        </p:nvSpPr>
        <p:spPr>
          <a:xfrm>
            <a:off x="247650" y="7726474"/>
            <a:ext cx="6362700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l Figure S5.</a:t>
            </a:r>
            <a:r>
              <a:rPr lang="en-US" sz="1200" dirty="0"/>
              <a:t> To measure mitochondrial respiration, healthy control (</a:t>
            </a:r>
            <a:r>
              <a:rPr lang="en-GB" sz="1200" dirty="0"/>
              <a:t>HC) and NPC1 fibroblasts were exposed sequentially to oligomycin, FCCP and rotenone/antimycin as shown. Oxygen consumption rate (OCR) was measured over time using a Seahorse XFe96 Analyser. Cell Mito stress test was performed according to the manufacturer’s protocol and normalised to the cell number measured by </a:t>
            </a:r>
            <a:r>
              <a:rPr lang="en-GB" sz="1200" dirty="0" err="1"/>
              <a:t>Cytation</a:t>
            </a:r>
            <a:r>
              <a:rPr lang="en-GB" sz="1200" dirty="0"/>
              <a:t> C10 automated confocal imaging reader. </a:t>
            </a:r>
            <a:r>
              <a:rPr lang="en-GB" sz="1200" b="1" dirty="0"/>
              <a:t>A)</a:t>
            </a:r>
            <a:r>
              <a:rPr lang="en-GB" sz="1200" dirty="0"/>
              <a:t> Respiratory parameters were calculated from OCR data according to the mitochondrial stress test protocol. </a:t>
            </a:r>
            <a:r>
              <a:rPr lang="en-GB" sz="1200" b="1" dirty="0"/>
              <a:t>B-C) </a:t>
            </a:r>
            <a:r>
              <a:rPr lang="en-GB" sz="1200" dirty="0"/>
              <a:t>Respiratory parameters calculated from OCR data of fibroblasts HC1 D1 and NPC1 P3 treated with either </a:t>
            </a:r>
            <a:r>
              <a:rPr lang="en-GB" sz="1200" dirty="0" err="1"/>
              <a:t>Miglustat</a:t>
            </a:r>
            <a:r>
              <a:rPr lang="en-GB" sz="1200" dirty="0"/>
              <a:t> or </a:t>
            </a:r>
            <a:r>
              <a:rPr lang="en-GB" sz="1200" dirty="0" err="1"/>
              <a:t>Miglustat</a:t>
            </a:r>
            <a:r>
              <a:rPr lang="en-GB" sz="1200" dirty="0"/>
              <a:t> + NALL. Data was normalised to HC D1, and bars are the mean + SD of three independent experiments. (One-way ANOVA, Dunnett post-test) </a:t>
            </a:r>
            <a:r>
              <a:rPr lang="en-GB" sz="1200" b="1" dirty="0"/>
              <a:t>D</a:t>
            </a:r>
            <a:r>
              <a:rPr lang="en-GB" sz="1200" dirty="0"/>
              <a:t>) Representative images of </a:t>
            </a:r>
            <a:r>
              <a:rPr lang="en-GB" sz="1200" dirty="0" err="1"/>
              <a:t>mitochondria:LE</a:t>
            </a:r>
            <a:r>
              <a:rPr lang="en-GB" sz="1200" dirty="0"/>
              <a:t>/Lys PLA in HeLa cells. Scale bar, 50</a:t>
            </a:r>
            <a:r>
              <a:rPr lang="en-GB" sz="1200" dirty="0">
                <a:latin typeface="Symbol" pitchFamily="2" charset="2"/>
              </a:rPr>
              <a:t>m</a:t>
            </a:r>
            <a:r>
              <a:rPr lang="en-GB" sz="1200" dirty="0"/>
              <a:t>m.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A2F3CDF-E86F-1336-295C-8A424F0E2E72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5476"/>
          <a:stretch/>
        </p:blipFill>
        <p:spPr>
          <a:xfrm>
            <a:off x="2972587" y="1880676"/>
            <a:ext cx="2302533" cy="225789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02283C1-E585-0F5B-69FE-86E8E4B536BB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3555"/>
          <a:stretch/>
        </p:blipFill>
        <p:spPr>
          <a:xfrm>
            <a:off x="677884" y="1976268"/>
            <a:ext cx="1940942" cy="2122385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9CB17E83-5512-2962-9F93-E3514FDC8726}"/>
              </a:ext>
            </a:extLst>
          </p:cNvPr>
          <p:cNvSpPr txBox="1"/>
          <p:nvPr/>
        </p:nvSpPr>
        <p:spPr>
          <a:xfrm>
            <a:off x="2931950" y="2018136"/>
            <a:ext cx="51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25167918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8DE5BFBD-D452-6E1F-F97B-05D1748893BF}"/>
              </a:ext>
            </a:extLst>
          </p:cNvPr>
          <p:cNvSpPr txBox="1"/>
          <p:nvPr/>
        </p:nvSpPr>
        <p:spPr>
          <a:xfrm>
            <a:off x="314834" y="3472656"/>
            <a:ext cx="6231184" cy="1222997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200" b="1" kern="0" dirty="0">
                <a:effectLst/>
                <a:ea typeface="Times New Roman" panose="02020603050405020304" pitchFamily="18" charset="0"/>
              </a:rPr>
              <a:t>Supplemental Figure S6. 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Fibroblasts from healthy controls (HC) or NPC1 patients were cultured with or with DMSO or NALL for 72 hours. </a:t>
            </a:r>
            <a:r>
              <a:rPr lang="en-GB" sz="1200" b="1" kern="0" dirty="0">
                <a:effectLst/>
                <a:ea typeface="Times New Roman" panose="02020603050405020304" pitchFamily="18" charset="0"/>
              </a:rPr>
              <a:t> A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) Lysates of cells incubated ± bafilomycin (</a:t>
            </a:r>
            <a:r>
              <a:rPr lang="en-GB" sz="1200" kern="0" dirty="0" err="1">
                <a:effectLst/>
                <a:ea typeface="Times New Roman" panose="02020603050405020304" pitchFamily="18" charset="0"/>
              </a:rPr>
              <a:t>baf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) </a:t>
            </a:r>
            <a:r>
              <a:rPr lang="en-GB" sz="1200" kern="0" dirty="0">
                <a:ea typeface="Times New Roman" panose="02020603050405020304" pitchFamily="18" charset="0"/>
              </a:rPr>
              <a:t>were immunoblotted with anti LC3 and anti-vinculin antibodies. </a:t>
            </a:r>
            <a:r>
              <a:rPr lang="en-US" sz="1200" dirty="0"/>
              <a:t>LC3-II band densitometry was quantified relative to LC3-I or the vinculin loading control</a:t>
            </a:r>
            <a:r>
              <a:rPr lang="en-US" sz="1200" b="1" dirty="0"/>
              <a:t>. B</a:t>
            </a:r>
            <a:r>
              <a:rPr lang="en-US" sz="1200" dirty="0"/>
              <a:t>) </a:t>
            </a:r>
            <a:r>
              <a:rPr lang="en-GB" sz="1200" kern="0" dirty="0">
                <a:ea typeface="Times New Roman" panose="02020603050405020304" pitchFamily="18" charset="0"/>
              </a:rPr>
              <a:t>Cells were 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exposed to </a:t>
            </a:r>
            <a:r>
              <a:rPr lang="en-GB" sz="1200" kern="0" dirty="0" err="1">
                <a:effectLst/>
                <a:ea typeface="Times New Roman" panose="02020603050405020304" pitchFamily="18" charset="0"/>
              </a:rPr>
              <a:t>LLOMe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 for 1 hour ± a 4 hour washout</a:t>
            </a:r>
            <a:r>
              <a:rPr lang="en-GB" sz="1200" kern="0" dirty="0">
                <a:ea typeface="Times New Roman" panose="02020603050405020304" pitchFamily="18" charset="0"/>
              </a:rPr>
              <a:t> prior to fixation and immunofluorescence staining </a:t>
            </a:r>
            <a:r>
              <a:rPr lang="en-GB" sz="1200" kern="0" dirty="0">
                <a:effectLst/>
                <a:ea typeface="Times New Roman" panose="02020603050405020304" pitchFamily="18" charset="0"/>
              </a:rPr>
              <a:t>for galectin-3 (Gal3).  Chart shows quantitation of Gal3 spots/cell.</a:t>
            </a:r>
            <a:r>
              <a:rPr lang="en-GB" sz="1200" kern="0" dirty="0">
                <a:ea typeface="Times New Roman" panose="02020603050405020304" pitchFamily="18" charset="0"/>
              </a:rPr>
              <a:t> </a:t>
            </a:r>
            <a:endParaRPr lang="en-US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A6FFCFB-7F54-9F77-E56D-7BFE4966E89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9650" t="9736" r="12594" b="6281"/>
          <a:stretch/>
        </p:blipFill>
        <p:spPr>
          <a:xfrm>
            <a:off x="3937787" y="557958"/>
            <a:ext cx="2596896" cy="288210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7CE368B-9F31-66BA-F2F0-90DD308E6155}"/>
              </a:ext>
            </a:extLst>
          </p:cNvPr>
          <p:cNvSpPr txBox="1"/>
          <p:nvPr/>
        </p:nvSpPr>
        <p:spPr>
          <a:xfrm>
            <a:off x="266006" y="323417"/>
            <a:ext cx="841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CEB0065-8FC3-67A2-D342-F73737371EED}"/>
              </a:ext>
            </a:extLst>
          </p:cNvPr>
          <p:cNvSpPr txBox="1"/>
          <p:nvPr/>
        </p:nvSpPr>
        <p:spPr>
          <a:xfrm>
            <a:off x="3835720" y="323417"/>
            <a:ext cx="841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5E1F3EF-A4D6-8CC6-E348-1A6F1921A4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5285" y="648528"/>
            <a:ext cx="1756769" cy="219384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9CBEEE2-151F-232D-9A64-B8154C161E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0091" y="673005"/>
            <a:ext cx="1755810" cy="21902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76443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8B57F8E3BCFAD4C9AB91DC735A7495E" ma:contentTypeVersion="17" ma:contentTypeDescription="Create a new document." ma:contentTypeScope="" ma:versionID="c31a6be9f3cc7bfd91a1dbf9c1b1086e">
  <xsd:schema xmlns:xsd="http://www.w3.org/2001/XMLSchema" xmlns:xs="http://www.w3.org/2001/XMLSchema" xmlns:p="http://schemas.microsoft.com/office/2006/metadata/properties" xmlns:ns2="742903cd-b80a-47e3-8b40-5135074bb8ee" xmlns:ns3="fb80507f-4ba1-4a69-b9dd-0eeb828851e3" targetNamespace="http://schemas.microsoft.com/office/2006/metadata/properties" ma:root="true" ma:fieldsID="072433ad7d212bb7089eacebd227fc38" ns2:_="" ns3:_="">
    <xsd:import namespace="742903cd-b80a-47e3-8b40-5135074bb8ee"/>
    <xsd:import namespace="fb80507f-4ba1-4a69-b9dd-0eeb828851e3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  <xsd:element ref="ns2:lcf76f155ced4ddcb4097134ff3c332f" minOccurs="0"/>
                <xsd:element ref="ns3:TaxCatchAll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2903cd-b80a-47e3-8b40-5135074bb8e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9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579a89b1-2c2c-4f7f-9bd7-7914fb13a02b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BillingMetadata" ma:index="24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b80507f-4ba1-4a69-b9dd-0eeb828851e3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e4513516-8ca2-45bd-ad24-a21e028fe72d}" ma:internalName="TaxCatchAll" ma:showField="CatchAllData" ma:web="fb80507f-4ba1-4a69-b9dd-0eeb828851e3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742903cd-b80a-47e3-8b40-5135074bb8ee">
      <Terms xmlns="http://schemas.microsoft.com/office/infopath/2007/PartnerControls"/>
    </lcf76f155ced4ddcb4097134ff3c332f>
    <TaxCatchAll xmlns="fb80507f-4ba1-4a69-b9dd-0eeb828851e3" xsi:nil="true"/>
  </documentManagement>
</p:properties>
</file>

<file path=customXml/itemProps1.xml><?xml version="1.0" encoding="utf-8"?>
<ds:datastoreItem xmlns:ds="http://schemas.openxmlformats.org/officeDocument/2006/customXml" ds:itemID="{5E922A56-7286-43D3-88F1-5F55FFD7186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D419177-7323-4F48-B86A-B069456A39B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42903cd-b80a-47e3-8b40-5135074bb8ee"/>
    <ds:schemaRef ds:uri="fb80507f-4ba1-4a69-b9dd-0eeb828851e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88D0A930-066B-4250-A5F5-F82165541CAF}">
  <ds:schemaRefs>
    <ds:schemaRef ds:uri="http://purl.org/dc/terms/"/>
    <ds:schemaRef ds:uri="http://schemas.microsoft.com/office/2006/documentManagement/types"/>
    <ds:schemaRef ds:uri="http://schemas.microsoft.com/office/2006/metadata/properties"/>
    <ds:schemaRef ds:uri="http://www.w3.org/XML/1998/namespace"/>
    <ds:schemaRef ds:uri="http://purl.org/dc/elements/1.1/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fb80507f-4ba1-4a69-b9dd-0eeb828851e3"/>
    <ds:schemaRef ds:uri="742903cd-b80a-47e3-8b40-5135074bb8e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23</TotalTime>
  <Words>906</Words>
  <Application>Microsoft Macintosh PowerPoint</Application>
  <PresentationFormat>A4 Paper (210x297 mm)</PresentationFormat>
  <Paragraphs>68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ptos</vt:lpstr>
      <vt:lpstr>Arial</vt:lpstr>
      <vt:lpstr>Calibri</vt:lpstr>
      <vt:lpstr>Calibri Light</vt:lpstr>
      <vt:lpstr>Google Sans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Eden, Emily</dc:creator>
  <cp:keywords/>
  <dc:description/>
  <cp:lastModifiedBy>Eden, Emily</cp:lastModifiedBy>
  <cp:revision>57</cp:revision>
  <dcterms:created xsi:type="dcterms:W3CDTF">2025-04-25T10:48:26Z</dcterms:created>
  <dcterms:modified xsi:type="dcterms:W3CDTF">2025-04-27T23:29:15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8B57F8E3BCFAD4C9AB91DC735A7495E</vt:lpwstr>
  </property>
  <property fmtid="{D5CDD505-2E9C-101B-9397-08002B2CF9AE}" pid="3" name="MediaServiceImageTags">
    <vt:lpwstr/>
  </property>
</Properties>
</file>